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32" autoAdjust="0"/>
    <p:restoredTop sz="94660"/>
  </p:normalViewPr>
  <p:slideViewPr>
    <p:cSldViewPr snapToGrid="0">
      <p:cViewPr>
        <p:scale>
          <a:sx n="90" d="100"/>
          <a:sy n="90" d="100"/>
        </p:scale>
        <p:origin x="-1320" y="-13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6A0719-A97A-44FE-9BE9-953D12170BA2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F4BA5C-F713-4D1C-9EB9-D8D6B2B87D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8362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4794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493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405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3791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82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816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844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519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206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617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481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47BCF-5D3C-4E10-8266-2E7CB56B8644}" type="datetimeFigureOut">
              <a:rPr lang="en-US" smtClean="0"/>
              <a:t>11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178362-744B-4F10-96BB-304523BD27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5701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69333" y="287867"/>
            <a:ext cx="8518749" cy="4706180"/>
            <a:chOff x="169333" y="287867"/>
            <a:chExt cx="8518749" cy="4706180"/>
          </a:xfrm>
        </p:grpSpPr>
        <p:sp>
          <p:nvSpPr>
            <p:cNvPr id="334" name="TextBox 9"/>
            <p:cNvSpPr txBox="1">
              <a:spLocks noChangeArrowheads="1"/>
            </p:cNvSpPr>
            <p:nvPr/>
          </p:nvSpPr>
          <p:spPr bwMode="auto">
            <a:xfrm>
              <a:off x="1156509" y="620026"/>
              <a:ext cx="1019831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100" dirty="0"/>
                <a:t>Live-unstained</a:t>
              </a:r>
            </a:p>
          </p:txBody>
        </p:sp>
        <p:sp>
          <p:nvSpPr>
            <p:cNvPr id="500" name="TextBox 13"/>
            <p:cNvSpPr txBox="1">
              <a:spLocks noChangeArrowheads="1"/>
            </p:cNvSpPr>
            <p:nvPr/>
          </p:nvSpPr>
          <p:spPr bwMode="auto">
            <a:xfrm>
              <a:off x="2640818" y="622591"/>
              <a:ext cx="1186543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100" dirty="0"/>
                <a:t>Live- </a:t>
              </a:r>
              <a:r>
                <a:rPr lang="en-US" sz="1100" dirty="0" smtClean="0">
                  <a:latin typeface="Symbol" pitchFamily="18" charset="2"/>
                </a:rPr>
                <a:t>a</a:t>
              </a:r>
              <a:r>
                <a:rPr lang="en-US" sz="1100" dirty="0" smtClean="0"/>
                <a:t>-Caspase 3</a:t>
              </a:r>
              <a:endParaRPr lang="en-US" sz="1100" dirty="0"/>
            </a:p>
          </p:txBody>
        </p:sp>
        <p:sp>
          <p:nvSpPr>
            <p:cNvPr id="477" name="TextBox 10"/>
            <p:cNvSpPr txBox="1">
              <a:spLocks noChangeArrowheads="1"/>
            </p:cNvSpPr>
            <p:nvPr/>
          </p:nvSpPr>
          <p:spPr bwMode="auto">
            <a:xfrm>
              <a:off x="4303383" y="460274"/>
              <a:ext cx="1019831" cy="4308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100" dirty="0" smtClean="0"/>
                <a:t>0.04</a:t>
              </a:r>
              <a:r>
                <a:rPr lang="en-US" sz="1100" dirty="0" smtClean="0">
                  <a:latin typeface="Symbol" pitchFamily="18" charset="2"/>
                </a:rPr>
                <a:t>m</a:t>
              </a:r>
              <a:r>
                <a:rPr lang="en-US" sz="1100" dirty="0" smtClean="0"/>
                <a:t>M</a:t>
              </a:r>
            </a:p>
            <a:p>
              <a:pPr algn="ctr"/>
              <a:r>
                <a:rPr lang="en-US" sz="1100" dirty="0" smtClean="0"/>
                <a:t> </a:t>
              </a:r>
              <a:r>
                <a:rPr lang="en-US" sz="1100" dirty="0" err="1" smtClean="0"/>
                <a:t>Staurosporine</a:t>
              </a:r>
              <a:endParaRPr lang="en-US" sz="1100" dirty="0"/>
            </a:p>
          </p:txBody>
        </p:sp>
        <p:sp>
          <p:nvSpPr>
            <p:cNvPr id="555" name="TextBox 11"/>
            <p:cNvSpPr txBox="1">
              <a:spLocks noChangeArrowheads="1"/>
            </p:cNvSpPr>
            <p:nvPr/>
          </p:nvSpPr>
          <p:spPr bwMode="auto">
            <a:xfrm>
              <a:off x="5766647" y="426568"/>
              <a:ext cx="1058751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/>
                <a:t>0.2</a:t>
              </a:r>
              <a:r>
                <a:rPr lang="en-US" sz="1200" dirty="0">
                  <a:latin typeface="Symbol" pitchFamily="18" charset="2"/>
                </a:rPr>
                <a:t>m</a:t>
              </a:r>
              <a:r>
                <a:rPr lang="en-US" sz="1200" dirty="0"/>
                <a:t>M </a:t>
              </a:r>
              <a:endParaRPr lang="en-US" sz="1200" dirty="0" smtClean="0"/>
            </a:p>
            <a:p>
              <a:pPr algn="ctr"/>
              <a:r>
                <a:rPr lang="en-US" sz="1200" dirty="0" err="1" smtClean="0"/>
                <a:t>Staurosporine</a:t>
              </a:r>
              <a:endParaRPr lang="en-US" sz="1200" dirty="0"/>
            </a:p>
          </p:txBody>
        </p:sp>
        <p:grpSp>
          <p:nvGrpSpPr>
            <p:cNvPr id="2599" name="Group 2598"/>
            <p:cNvGrpSpPr/>
            <p:nvPr/>
          </p:nvGrpSpPr>
          <p:grpSpPr>
            <a:xfrm>
              <a:off x="866628" y="999810"/>
              <a:ext cx="7693692" cy="1428662"/>
              <a:chOff x="866628" y="971235"/>
              <a:chExt cx="7693692" cy="1428662"/>
            </a:xfrm>
          </p:grpSpPr>
          <p:grpSp>
            <p:nvGrpSpPr>
              <p:cNvPr id="2252" name="Group 243"/>
              <p:cNvGrpSpPr>
                <a:grpSpLocks noChangeAspect="1"/>
              </p:cNvGrpSpPr>
              <p:nvPr/>
            </p:nvGrpSpPr>
            <p:grpSpPr bwMode="auto">
              <a:xfrm>
                <a:off x="866628" y="986283"/>
                <a:ext cx="1408966" cy="1307592"/>
                <a:chOff x="1464" y="568"/>
                <a:chExt cx="1237" cy="1148"/>
              </a:xfrm>
            </p:grpSpPr>
            <p:grpSp>
              <p:nvGrpSpPr>
                <p:cNvPr id="2253" name="Group 241"/>
                <p:cNvGrpSpPr>
                  <a:grpSpLocks/>
                </p:cNvGrpSpPr>
                <p:nvPr/>
              </p:nvGrpSpPr>
              <p:grpSpPr bwMode="auto">
                <a:xfrm>
                  <a:off x="1464" y="568"/>
                  <a:ext cx="1237" cy="1148"/>
                  <a:chOff x="1464" y="568"/>
                  <a:chExt cx="1237" cy="1148"/>
                </a:xfrm>
              </p:grpSpPr>
              <p:sp>
                <p:nvSpPr>
                  <p:cNvPr id="2254" name="Rectangle 176"/>
                  <p:cNvSpPr>
                    <a:spLocks noChangeArrowheads="1"/>
                  </p:cNvSpPr>
                  <p:nvPr/>
                </p:nvSpPr>
                <p:spPr bwMode="auto">
                  <a:xfrm>
                    <a:off x="1634" y="574"/>
                    <a:ext cx="1032" cy="1032"/>
                  </a:xfrm>
                  <a:prstGeom prst="rect">
                    <a:avLst/>
                  </a:prstGeom>
                  <a:solidFill>
                    <a:srgbClr val="FFFFFF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2255" name="Group 208"/>
                  <p:cNvGrpSpPr>
                    <a:grpSpLocks/>
                  </p:cNvGrpSpPr>
                  <p:nvPr/>
                </p:nvGrpSpPr>
                <p:grpSpPr bwMode="auto">
                  <a:xfrm>
                    <a:off x="1616" y="1604"/>
                    <a:ext cx="1085" cy="112"/>
                    <a:chOff x="1616" y="1604"/>
                    <a:chExt cx="1085" cy="112"/>
                  </a:xfrm>
                </p:grpSpPr>
                <p:sp>
                  <p:nvSpPr>
                    <p:cNvPr id="2288" name="Line 17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32" y="1604"/>
                      <a:ext cx="1032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289" name="Group 19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32" y="1608"/>
                      <a:ext cx="1008" cy="24"/>
                      <a:chOff x="1632" y="1608"/>
                      <a:chExt cx="1008" cy="24"/>
                    </a:xfrm>
                  </p:grpSpPr>
                  <p:sp>
                    <p:nvSpPr>
                      <p:cNvPr id="2299" name="Line 17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632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00" name="Line 17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6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01" name="Line 18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3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02" name="Line 18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03" name="Line 18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32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0" name="Line 18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8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1" name="Line 18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3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2" name="Line 18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8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3" name="Line 18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036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4" name="Line 18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08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5" name="Line 18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36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6" name="Line 18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88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7" name="Line 19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36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8" name="Line 19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88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0" name="Line 19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4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1" name="Line 19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88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2" name="Line 19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40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3" name="Line 19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88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4" name="Line 19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4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5" name="Line 19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9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6" name="Line 19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40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291" name="Group 206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16" y="1648"/>
                      <a:ext cx="1085" cy="68"/>
                      <a:chOff x="1616" y="1648"/>
                      <a:chExt cx="1085" cy="68"/>
                    </a:xfrm>
                  </p:grpSpPr>
                  <p:sp>
                    <p:nvSpPr>
                      <p:cNvPr id="2293" name="Rectangle 20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16" y="1648"/>
                        <a:ext cx="31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4" name="Rectangle 20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784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5" name="Rectangle 20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988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6" name="Rectangle 20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188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7" name="Rectangle 20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392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8" name="Rectangle 20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576" y="1648"/>
                        <a:ext cx="125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2256" name="Group 240"/>
                  <p:cNvGrpSpPr>
                    <a:grpSpLocks/>
                  </p:cNvGrpSpPr>
                  <p:nvPr/>
                </p:nvGrpSpPr>
                <p:grpSpPr bwMode="auto">
                  <a:xfrm>
                    <a:off x="1464" y="568"/>
                    <a:ext cx="168" cy="1076"/>
                    <a:chOff x="1464" y="568"/>
                    <a:chExt cx="168" cy="1076"/>
                  </a:xfrm>
                </p:grpSpPr>
                <p:sp>
                  <p:nvSpPr>
                    <p:cNvPr id="2257" name="Line 209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632" y="572"/>
                      <a:ext cx="0" cy="1032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258" name="Group 23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08" y="596"/>
                      <a:ext cx="24" cy="1008"/>
                      <a:chOff x="1608" y="596"/>
                      <a:chExt cx="24" cy="1008"/>
                    </a:xfrm>
                  </p:grpSpPr>
                  <p:sp>
                    <p:nvSpPr>
                      <p:cNvPr id="2267" name="Line 21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160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68" name="Line 21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55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69" name="Line 21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50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0" name="Line 21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45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1" name="Line 21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140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2" name="Line 21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3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3" name="Line 21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30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4" name="Line 21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2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5" name="Line 21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120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6" name="Line 21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1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7" name="Line 22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10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8" name="Line 22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10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79" name="Line 22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100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0" name="Line 22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9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1" name="Line 22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89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2" name="Line 22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8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3" name="Line 22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796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4" name="Line 22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7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5" name="Line 22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69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6" name="Line 22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64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87" name="Line 23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596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259" name="Group 238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464" y="568"/>
                      <a:ext cx="127" cy="1076"/>
                      <a:chOff x="1464" y="568"/>
                      <a:chExt cx="127" cy="1076"/>
                    </a:xfrm>
                  </p:grpSpPr>
                  <p:sp>
                    <p:nvSpPr>
                      <p:cNvPr id="2261" name="Rectangle 23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560" y="1576"/>
                        <a:ext cx="31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2" name="Rectangle 2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1376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3" name="Rectangle 2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1172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4" name="Rectangle 2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972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5" name="Rectangle 2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76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6" name="Rectangle 2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64" y="568"/>
                        <a:ext cx="125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2290" name="Picture 242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40" y="580"/>
                  <a:ext cx="1020" cy="10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sp>
            <p:nvSpPr>
              <p:cNvPr id="2351" name="AutoShape 335"/>
              <p:cNvSpPr>
                <a:spLocks noChangeAspect="1" noChangeArrowheads="1" noTextEdit="1"/>
              </p:cNvSpPr>
              <p:nvPr/>
            </p:nvSpPr>
            <p:spPr bwMode="auto">
              <a:xfrm>
                <a:off x="2314164" y="971235"/>
                <a:ext cx="1291666" cy="14286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grpSp>
            <p:nvGrpSpPr>
              <p:cNvPr id="2353" name="Group 408"/>
              <p:cNvGrpSpPr>
                <a:grpSpLocks/>
              </p:cNvGrpSpPr>
              <p:nvPr/>
            </p:nvGrpSpPr>
            <p:grpSpPr bwMode="auto">
              <a:xfrm>
                <a:off x="2384620" y="982587"/>
                <a:ext cx="1451949" cy="1316736"/>
                <a:chOff x="2856" y="568"/>
                <a:chExt cx="1237" cy="1148"/>
              </a:xfrm>
            </p:grpSpPr>
            <p:grpSp>
              <p:nvGrpSpPr>
                <p:cNvPr id="2354" name="Group 406"/>
                <p:cNvGrpSpPr>
                  <a:grpSpLocks/>
                </p:cNvGrpSpPr>
                <p:nvPr/>
              </p:nvGrpSpPr>
              <p:grpSpPr bwMode="auto">
                <a:xfrm>
                  <a:off x="2856" y="568"/>
                  <a:ext cx="1237" cy="1148"/>
                  <a:chOff x="2856" y="568"/>
                  <a:chExt cx="1237" cy="1148"/>
                </a:xfrm>
              </p:grpSpPr>
              <p:sp>
                <p:nvSpPr>
                  <p:cNvPr id="2355" name="Rectangle 341"/>
                  <p:cNvSpPr>
                    <a:spLocks noChangeArrowheads="1"/>
                  </p:cNvSpPr>
                  <p:nvPr/>
                </p:nvSpPr>
                <p:spPr bwMode="auto">
                  <a:xfrm>
                    <a:off x="3026" y="574"/>
                    <a:ext cx="1032" cy="1032"/>
                  </a:xfrm>
                  <a:prstGeom prst="rect">
                    <a:avLst/>
                  </a:prstGeom>
                  <a:solidFill>
                    <a:srgbClr val="FFFFFF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2356" name="Group 373"/>
                  <p:cNvGrpSpPr>
                    <a:grpSpLocks/>
                  </p:cNvGrpSpPr>
                  <p:nvPr/>
                </p:nvGrpSpPr>
                <p:grpSpPr bwMode="auto">
                  <a:xfrm>
                    <a:off x="3008" y="1604"/>
                    <a:ext cx="1085" cy="112"/>
                    <a:chOff x="3008" y="1604"/>
                    <a:chExt cx="1085" cy="112"/>
                  </a:xfrm>
                </p:grpSpPr>
                <p:sp>
                  <p:nvSpPr>
                    <p:cNvPr id="343" name="Line 34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024" y="1604"/>
                      <a:ext cx="1032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344" name="Group 36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024" y="1608"/>
                      <a:ext cx="1008" cy="24"/>
                      <a:chOff x="3024" y="1608"/>
                      <a:chExt cx="1008" cy="24"/>
                    </a:xfrm>
                  </p:grpSpPr>
                  <p:sp>
                    <p:nvSpPr>
                      <p:cNvPr id="2433" name="Line 34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24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4" name="Line 34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7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5" name="Line 34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12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6" name="Line 34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17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7" name="Line 34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224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8" name="Line 34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276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39" name="Line 34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32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0" name="Line 35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376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1" name="Line 35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428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2" name="Line 35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476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3" name="Line 35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28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4" name="Line 35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5" name="Line 35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28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6" name="Line 35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7" name="Line 35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3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8" name="Line 35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9" name="Line 35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32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50" name="Line 36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80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51" name="Line 36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32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52" name="Line 36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84" y="160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53" name="Line 36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32" y="160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345" name="Group 37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008" y="1648"/>
                      <a:ext cx="1085" cy="68"/>
                      <a:chOff x="3008" y="1648"/>
                      <a:chExt cx="1085" cy="68"/>
                    </a:xfrm>
                  </p:grpSpPr>
                  <p:sp>
                    <p:nvSpPr>
                      <p:cNvPr id="347" name="Rectangle 36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08" y="1648"/>
                        <a:ext cx="31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48" name="Rectangle 36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176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49" name="Rectangle 36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380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50" name="Rectangle 36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580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51" name="Rectangle 36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784" y="164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432" name="Rectangle 37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68" y="1648"/>
                        <a:ext cx="125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2357" name="Group 405"/>
                  <p:cNvGrpSpPr>
                    <a:grpSpLocks/>
                  </p:cNvGrpSpPr>
                  <p:nvPr/>
                </p:nvGrpSpPr>
                <p:grpSpPr bwMode="auto">
                  <a:xfrm>
                    <a:off x="2856" y="568"/>
                    <a:ext cx="168" cy="1076"/>
                    <a:chOff x="2856" y="568"/>
                    <a:chExt cx="168" cy="1076"/>
                  </a:xfrm>
                </p:grpSpPr>
                <p:sp>
                  <p:nvSpPr>
                    <p:cNvPr id="2358" name="Line 374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3024" y="572"/>
                      <a:ext cx="0" cy="1032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359" name="Group 396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000" y="596"/>
                      <a:ext cx="24" cy="1008"/>
                      <a:chOff x="3000" y="596"/>
                      <a:chExt cx="24" cy="1008"/>
                    </a:xfrm>
                  </p:grpSpPr>
                  <p:sp>
                    <p:nvSpPr>
                      <p:cNvPr id="320" name="Line 37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160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1" name="Line 37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55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2" name="Line 37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50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3" name="Line 37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45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4" name="Line 37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140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5" name="Line 38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3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6" name="Line 38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30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7" name="Line 38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2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8" name="Line 38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120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29" name="Line 38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1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0" name="Line 38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10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1" name="Line 38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10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2" name="Line 38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100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3" name="Line 38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9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6" name="Line 38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89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7" name="Line 39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8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8" name="Line 39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796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39" name="Line 39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74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40" name="Line 39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69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41" name="Line 39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16" y="64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42" name="Line 39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000" y="596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360" name="Group 403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856" y="568"/>
                      <a:ext cx="127" cy="1076"/>
                      <a:chOff x="2856" y="568"/>
                      <a:chExt cx="127" cy="1076"/>
                    </a:xfrm>
                  </p:grpSpPr>
                  <p:sp>
                    <p:nvSpPr>
                      <p:cNvPr id="2362" name="Rectangle 39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952" y="1576"/>
                        <a:ext cx="31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63" name="Rectangle 39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8" y="1376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64" name="Rectangle 39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8" y="1172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65" name="Rectangle 40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8" y="972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66" name="Rectangle 40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8" y="768"/>
                        <a:ext cx="94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67" name="Rectangle 40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56" y="568"/>
                        <a:ext cx="125" cy="6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2455" name="Picture 407"/>
                <p:cNvPicPr>
                  <a:picLocks noChangeAspect="1" noChangeArrowheads="1"/>
                </p:cNvPicPr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032" y="580"/>
                  <a:ext cx="1020" cy="10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5" name="Group 76"/>
              <p:cNvGrpSpPr>
                <a:grpSpLocks noChangeAspect="1"/>
              </p:cNvGrpSpPr>
              <p:nvPr/>
            </p:nvGrpSpPr>
            <p:grpSpPr bwMode="auto">
              <a:xfrm>
                <a:off x="3931178" y="990886"/>
                <a:ext cx="1531585" cy="1353312"/>
                <a:chOff x="1997" y="494"/>
                <a:chExt cx="962" cy="871"/>
              </a:xfrm>
            </p:grpSpPr>
            <p:grpSp>
              <p:nvGrpSpPr>
                <p:cNvPr id="6" name="Group 74"/>
                <p:cNvGrpSpPr>
                  <a:grpSpLocks/>
                </p:cNvGrpSpPr>
                <p:nvPr/>
              </p:nvGrpSpPr>
              <p:grpSpPr bwMode="auto">
                <a:xfrm>
                  <a:off x="1997" y="494"/>
                  <a:ext cx="962" cy="871"/>
                  <a:chOff x="1997" y="494"/>
                  <a:chExt cx="962" cy="871"/>
                </a:xfrm>
              </p:grpSpPr>
              <p:sp>
                <p:nvSpPr>
                  <p:cNvPr id="7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2121" y="498"/>
                    <a:ext cx="757" cy="757"/>
                  </a:xfrm>
                  <a:prstGeom prst="rect">
                    <a:avLst/>
                  </a:prstGeom>
                  <a:solidFill>
                    <a:srgbClr val="FFFFFF"/>
                  </a:solidFill>
                  <a:ln w="4763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8" name="Group 41"/>
                  <p:cNvGrpSpPr>
                    <a:grpSpLocks/>
                  </p:cNvGrpSpPr>
                  <p:nvPr/>
                </p:nvGrpSpPr>
                <p:grpSpPr bwMode="auto">
                  <a:xfrm>
                    <a:off x="2108" y="1253"/>
                    <a:ext cx="851" cy="112"/>
                    <a:chOff x="2108" y="1253"/>
                    <a:chExt cx="851" cy="112"/>
                  </a:xfrm>
                </p:grpSpPr>
                <p:sp>
                  <p:nvSpPr>
                    <p:cNvPr id="1092" name="Line 1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120" y="1253"/>
                      <a:ext cx="756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093" name="Group 32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120" y="1256"/>
                      <a:ext cx="738" cy="18"/>
                      <a:chOff x="2120" y="1256"/>
                      <a:chExt cx="738" cy="18"/>
                    </a:xfrm>
                  </p:grpSpPr>
                  <p:sp>
                    <p:nvSpPr>
                      <p:cNvPr id="1103" name="Line 1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20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4" name="Line 1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55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5" name="Line 1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93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6" name="Line 1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28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7" name="Line 1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66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8" name="Line 1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04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09" name="Line 1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40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0" name="Line 1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78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1" name="Line 1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16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2" name="Line 2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51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3" name="Line 2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89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4" name="Line 2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27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5" name="Line 2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62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6" name="Line 2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00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7" name="Line 2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38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8" name="Line 2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74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19" name="Line 2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712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4" name="Line 2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747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88" name="Line 2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785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89" name="Line 3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823" y="1256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0" name="Line 3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858" y="1256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094" name="Group 3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108" y="1285"/>
                      <a:ext cx="851" cy="80"/>
                      <a:chOff x="2108" y="1285"/>
                      <a:chExt cx="851" cy="80"/>
                    </a:xfrm>
                  </p:grpSpPr>
                  <p:sp>
                    <p:nvSpPr>
                      <p:cNvPr id="1096" name="Rectangle 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108" y="1285"/>
                        <a:ext cx="37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097" name="Rectangle 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231" y="1285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098" name="Rectangle 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381" y="1285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00" name="Rectangle 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527" y="1285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01" name="Rectangle 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677" y="1285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02" name="Rectangle 3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11" y="1285"/>
                        <a:ext cx="148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9" name="Group 73"/>
                  <p:cNvGrpSpPr>
                    <a:grpSpLocks/>
                  </p:cNvGrpSpPr>
                  <p:nvPr/>
                </p:nvGrpSpPr>
                <p:grpSpPr bwMode="auto">
                  <a:xfrm>
                    <a:off x="1997" y="494"/>
                    <a:ext cx="148" cy="819"/>
                    <a:chOff x="1997" y="494"/>
                    <a:chExt cx="148" cy="819"/>
                  </a:xfrm>
                </p:grpSpPr>
                <p:sp>
                  <p:nvSpPr>
                    <p:cNvPr id="10" name="Line 4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120" y="497"/>
                      <a:ext cx="0" cy="756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1" name="Group 6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102" y="514"/>
                      <a:ext cx="18" cy="739"/>
                      <a:chOff x="2102" y="514"/>
                      <a:chExt cx="18" cy="739"/>
                    </a:xfrm>
                  </p:grpSpPr>
                  <p:sp>
                    <p:nvSpPr>
                      <p:cNvPr id="20" name="Line 4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1253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" name="Line 4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1218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" name="Line 4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1180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" name="Line 4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1145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" name="Line 4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1106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" name="Line 4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1068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" name="Line 4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1033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" name="Line 5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995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8" name="Line 5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957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" name="Line 5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922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0" name="Line 5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884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" name="Line 5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846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9" name="Line 5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810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7" name="Line 5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772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8" name="Line 5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734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79" name="Line 5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699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82" name="Line 5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661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88" name="Line 6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626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89" name="Line 6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588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0" name="Line 6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14" y="549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1" name="Line 6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2102" y="514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2" name="Group 7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997" y="494"/>
                      <a:ext cx="148" cy="819"/>
                      <a:chOff x="1997" y="494"/>
                      <a:chExt cx="148" cy="819"/>
                    </a:xfrm>
                  </p:grpSpPr>
                  <p:sp>
                    <p:nvSpPr>
                      <p:cNvPr id="14" name="Rectangle 6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67" y="1233"/>
                        <a:ext cx="37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5" name="Rectangle 6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20" y="1086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6" name="Rectangle 6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20" y="937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7" name="Rectangle 6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20" y="790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8" name="Rectangle 6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20" y="640"/>
                        <a:ext cx="111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9" name="Rectangle 7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997" y="494"/>
                        <a:ext cx="148" cy="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1099" name="Picture 75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126" y="534"/>
                  <a:ext cx="722" cy="6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448" name="Group 242"/>
              <p:cNvGrpSpPr>
                <a:grpSpLocks noChangeAspect="1"/>
              </p:cNvGrpSpPr>
              <p:nvPr/>
            </p:nvGrpSpPr>
            <p:grpSpPr bwMode="auto">
              <a:xfrm>
                <a:off x="5455053" y="996533"/>
                <a:ext cx="1466130" cy="1320861"/>
                <a:chOff x="3924" y="1313"/>
                <a:chExt cx="949" cy="868"/>
              </a:xfrm>
            </p:grpSpPr>
            <p:grpSp>
              <p:nvGrpSpPr>
                <p:cNvPr id="449" name="Group 240"/>
                <p:cNvGrpSpPr>
                  <a:grpSpLocks/>
                </p:cNvGrpSpPr>
                <p:nvPr/>
              </p:nvGrpSpPr>
              <p:grpSpPr bwMode="auto">
                <a:xfrm>
                  <a:off x="3924" y="1313"/>
                  <a:ext cx="949" cy="868"/>
                  <a:chOff x="3924" y="1313"/>
                  <a:chExt cx="949" cy="868"/>
                </a:xfrm>
              </p:grpSpPr>
              <p:sp>
                <p:nvSpPr>
                  <p:cNvPr id="450" name="Rectangle 175"/>
                  <p:cNvSpPr>
                    <a:spLocks noChangeArrowheads="1"/>
                  </p:cNvSpPr>
                  <p:nvPr/>
                </p:nvSpPr>
                <p:spPr bwMode="auto">
                  <a:xfrm>
                    <a:off x="4049" y="1317"/>
                    <a:ext cx="762" cy="762"/>
                  </a:xfrm>
                  <a:prstGeom prst="rect">
                    <a:avLst/>
                  </a:prstGeom>
                  <a:solidFill>
                    <a:srgbClr val="FFFFFF"/>
                  </a:solidFill>
                  <a:ln w="4763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451" name="Group 207"/>
                  <p:cNvGrpSpPr>
                    <a:grpSpLocks/>
                  </p:cNvGrpSpPr>
                  <p:nvPr/>
                </p:nvGrpSpPr>
                <p:grpSpPr bwMode="auto">
                  <a:xfrm>
                    <a:off x="4036" y="2077"/>
                    <a:ext cx="837" cy="104"/>
                    <a:chOff x="4036" y="2077"/>
                    <a:chExt cx="837" cy="104"/>
                  </a:xfrm>
                </p:grpSpPr>
                <p:sp>
                  <p:nvSpPr>
                    <p:cNvPr id="519" name="Line 17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4048" y="2077"/>
                      <a:ext cx="761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 sz="7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520" name="Group 198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048" y="2080"/>
                      <a:ext cx="743" cy="18"/>
                      <a:chOff x="4048" y="2080"/>
                      <a:chExt cx="743" cy="18"/>
                    </a:xfrm>
                  </p:grpSpPr>
                  <p:sp>
                    <p:nvSpPr>
                      <p:cNvPr id="529" name="Line 17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48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0" name="Line 17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83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1" name="Line 17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22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2" name="Line 18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57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3" name="Line 18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95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4" name="Line 18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34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5" name="Line 18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69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6" name="Line 18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07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7" name="Line 18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46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8" name="Line 18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81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39" name="Line 18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19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0" name="Line 18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58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1" name="Line 18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93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2" name="Line 19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31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3" name="Line 19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70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4" name="Line 19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05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5" name="Line 19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44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6" name="Line 19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79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7" name="Line 19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17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8" name="Line 19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56" y="2080"/>
                        <a:ext cx="0" cy="6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89" name="Line 19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91" y="2080"/>
                        <a:ext cx="0" cy="18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521" name="Group 20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036" y="2110"/>
                      <a:ext cx="837" cy="71"/>
                      <a:chOff x="4036" y="2110"/>
                      <a:chExt cx="837" cy="71"/>
                    </a:xfrm>
                  </p:grpSpPr>
                  <p:sp>
                    <p:nvSpPr>
                      <p:cNvPr id="523" name="Rectangle 19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36" y="2110"/>
                        <a:ext cx="32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24" name="Rectangle 20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160" y="2110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2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525" name="Rectangle 20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310" y="2110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4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526" name="Rectangle 20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458" y="2110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6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527" name="Rectangle 20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08" y="2110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8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528" name="Rectangle 20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744" y="2110"/>
                        <a:ext cx="129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10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</p:grpSp>
              </p:grpSp>
              <p:grpSp>
                <p:nvGrpSpPr>
                  <p:cNvPr id="452" name="Group 239"/>
                  <p:cNvGrpSpPr>
                    <a:grpSpLocks/>
                  </p:cNvGrpSpPr>
                  <p:nvPr/>
                </p:nvGrpSpPr>
                <p:grpSpPr bwMode="auto">
                  <a:xfrm>
                    <a:off x="3924" y="1313"/>
                    <a:ext cx="129" cy="815"/>
                    <a:chOff x="3924" y="1313"/>
                    <a:chExt cx="129" cy="815"/>
                  </a:xfrm>
                </p:grpSpPr>
                <p:sp>
                  <p:nvSpPr>
                    <p:cNvPr id="453" name="Line 208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048" y="1316"/>
                      <a:ext cx="0" cy="761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454" name="Group 230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030" y="1334"/>
                      <a:ext cx="18" cy="743"/>
                      <a:chOff x="4030" y="1334"/>
                      <a:chExt cx="18" cy="743"/>
                    </a:xfrm>
                  </p:grpSpPr>
                  <p:sp>
                    <p:nvSpPr>
                      <p:cNvPr id="463" name="Line 20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2077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4" name="Line 21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2042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5" name="Line 21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2003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6" name="Line 21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968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7" name="Line 21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1930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8" name="Line 21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891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69" name="Line 21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856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0" name="Line 21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817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1" name="Line 21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1779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2" name="Line 21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744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3" name="Line 21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705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4" name="Line 22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667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5" name="Line 22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1632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6" name="Line 22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593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478" name="Line 22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555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3" name="Line 22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519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4" name="Line 22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1481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5" name="Line 22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446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6" name="Line 22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407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7" name="Line 22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42" y="1369"/>
                        <a:ext cx="6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18" name="Line 22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030" y="1334"/>
                        <a:ext cx="18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55" name="Group 237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924" y="1313"/>
                      <a:ext cx="129" cy="815"/>
                      <a:chOff x="3924" y="1313"/>
                      <a:chExt cx="129" cy="815"/>
                    </a:xfrm>
                  </p:grpSpPr>
                  <p:sp>
                    <p:nvSpPr>
                      <p:cNvPr id="457" name="Rectangle 23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95" y="2057"/>
                        <a:ext cx="32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458" name="Rectangle 23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48" y="1909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2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459" name="Rectangle 2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48" y="1759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4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460" name="Rectangle 2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48" y="1611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6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461" name="Rectangle 2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48" y="1461"/>
                        <a:ext cx="96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800</a:t>
                        </a:r>
                        <a:endParaRPr kumimoji="0" lang="en-US" altLang="en-US" sz="7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  <p:sp>
                    <p:nvSpPr>
                      <p:cNvPr id="462" name="Rectangle 2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24" y="1313"/>
                        <a:ext cx="129" cy="7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</a:rPr>
                          <a:t>1000</a:t>
                        </a:r>
                        <a:endParaRPr kumimoji="0" lang="en-US" altLang="en-US" sz="7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1265" name="Picture 241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054" y="1322"/>
                  <a:ext cx="752" cy="7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13" name="Group 76"/>
              <p:cNvGrpSpPr>
                <a:grpSpLocks noChangeAspect="1"/>
              </p:cNvGrpSpPr>
              <p:nvPr/>
            </p:nvGrpSpPr>
            <p:grpSpPr bwMode="auto">
              <a:xfrm>
                <a:off x="7086484" y="991926"/>
                <a:ext cx="1473836" cy="1346525"/>
                <a:chOff x="1464" y="2392"/>
                <a:chExt cx="1285" cy="1174"/>
              </a:xfrm>
            </p:grpSpPr>
            <p:grpSp>
              <p:nvGrpSpPr>
                <p:cNvPr id="291" name="Group 74"/>
                <p:cNvGrpSpPr>
                  <a:grpSpLocks/>
                </p:cNvGrpSpPr>
                <p:nvPr/>
              </p:nvGrpSpPr>
              <p:grpSpPr bwMode="auto">
                <a:xfrm>
                  <a:off x="1464" y="2392"/>
                  <a:ext cx="1285" cy="1174"/>
                  <a:chOff x="1464" y="2392"/>
                  <a:chExt cx="1285" cy="1174"/>
                </a:xfrm>
              </p:grpSpPr>
              <p:sp>
                <p:nvSpPr>
                  <p:cNvPr id="293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1634" y="2398"/>
                    <a:ext cx="1032" cy="1032"/>
                  </a:xfrm>
                  <a:prstGeom prst="rect">
                    <a:avLst/>
                  </a:prstGeom>
                  <a:solidFill>
                    <a:srgbClr val="FFFFFF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296" name="Group 41"/>
                  <p:cNvGrpSpPr>
                    <a:grpSpLocks/>
                  </p:cNvGrpSpPr>
                  <p:nvPr/>
                </p:nvGrpSpPr>
                <p:grpSpPr bwMode="auto">
                  <a:xfrm>
                    <a:off x="1616" y="3428"/>
                    <a:ext cx="1133" cy="138"/>
                    <a:chOff x="1616" y="3428"/>
                    <a:chExt cx="1133" cy="138"/>
                  </a:xfrm>
                </p:grpSpPr>
                <p:sp>
                  <p:nvSpPr>
                    <p:cNvPr id="599" name="Line 1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32" y="3428"/>
                      <a:ext cx="1032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600" name="Group 32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32" y="3432"/>
                      <a:ext cx="1008" cy="24"/>
                      <a:chOff x="1632" y="3432"/>
                      <a:chExt cx="1008" cy="24"/>
                    </a:xfrm>
                  </p:grpSpPr>
                  <p:sp>
                    <p:nvSpPr>
                      <p:cNvPr id="2350" name="Line 1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632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61" name="Line 1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680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5" name="Line 1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32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2" name="Line 1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80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3" name="Line 1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32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4" name="Line 1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84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5" name="Line 1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32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6" name="Line 1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84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7" name="Line 1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036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1" name="Line 2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084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2" name="Line 2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36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3" name="Line 2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88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4" name="Line 2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36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5" name="Line 2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88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6" name="Line 2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40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7" name="Line 2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88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8" name="Line 2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40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9" name="Line 2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88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40" name="Line 2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40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41" name="Line 3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92" y="3432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42" name="Line 3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40" y="3432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601" name="Group 3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16" y="3472"/>
                      <a:ext cx="1133" cy="94"/>
                      <a:chOff x="1616" y="3472"/>
                      <a:chExt cx="1133" cy="94"/>
                    </a:xfrm>
                  </p:grpSpPr>
                  <p:sp>
                    <p:nvSpPr>
                      <p:cNvPr id="603" name="Rectangle 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16" y="3472"/>
                        <a:ext cx="43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04" name="Rectangle 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784" y="3472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05" name="Rectangle 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988" y="3472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06" name="Rectangle 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188" y="3472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60" name="Rectangle 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392" y="3472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92" name="Rectangle 3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576" y="3472"/>
                        <a:ext cx="173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312" name="Group 73"/>
                  <p:cNvGrpSpPr>
                    <a:grpSpLocks/>
                  </p:cNvGrpSpPr>
                  <p:nvPr/>
                </p:nvGrpSpPr>
                <p:grpSpPr bwMode="auto">
                  <a:xfrm>
                    <a:off x="1464" y="2392"/>
                    <a:ext cx="173" cy="1102"/>
                    <a:chOff x="1464" y="2392"/>
                    <a:chExt cx="173" cy="1102"/>
                  </a:xfrm>
                </p:grpSpPr>
                <p:sp>
                  <p:nvSpPr>
                    <p:cNvPr id="346" name="Line 4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632" y="2396"/>
                      <a:ext cx="0" cy="1032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410" name="Group 6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08" y="2420"/>
                      <a:ext cx="24" cy="1008"/>
                      <a:chOff x="1608" y="2420"/>
                      <a:chExt cx="24" cy="1008"/>
                    </a:xfrm>
                  </p:grpSpPr>
                  <p:sp>
                    <p:nvSpPr>
                      <p:cNvPr id="578" name="Line 4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3428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79" name="Line 4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38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0" name="Line 4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32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1" name="Line 4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28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2" name="Line 4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3228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3" name="Line 4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17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4" name="Line 4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12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5" name="Line 5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307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6" name="Line 5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302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7" name="Line 5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97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8" name="Line 5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92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89" name="Line 5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87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0" name="Line 5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282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1" name="Line 5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77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2" name="Line 5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72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3" name="Line 5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67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4" name="Line 5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262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5" name="Line 6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57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6" name="Line 6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52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7" name="Line 6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24" y="246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98" name="Line 6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1608" y="242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56" name="Group 7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464" y="2392"/>
                      <a:ext cx="173" cy="1102"/>
                      <a:chOff x="1464" y="2392"/>
                      <a:chExt cx="173" cy="1102"/>
                    </a:xfrm>
                  </p:grpSpPr>
                  <p:sp>
                    <p:nvSpPr>
                      <p:cNvPr id="512" name="Rectangle 6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560" y="3400"/>
                        <a:ext cx="43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22" name="Rectangle 6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3200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56" name="Rectangle 6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2996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7" name="Rectangle 6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2796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76" name="Rectangle 6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96" y="2592"/>
                        <a:ext cx="130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77" name="Rectangle 7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64" y="2392"/>
                        <a:ext cx="173" cy="9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292" name="Picture 75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640" y="2404"/>
                  <a:ext cx="1020" cy="102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</p:grpSp>
        <p:grpSp>
          <p:nvGrpSpPr>
            <p:cNvPr id="2598" name="Group 2597"/>
            <p:cNvGrpSpPr/>
            <p:nvPr/>
          </p:nvGrpSpPr>
          <p:grpSpPr>
            <a:xfrm>
              <a:off x="779822" y="3058573"/>
              <a:ext cx="7908260" cy="1798168"/>
              <a:chOff x="779822" y="2582323"/>
              <a:chExt cx="7908260" cy="1798168"/>
            </a:xfrm>
          </p:grpSpPr>
          <p:grpSp>
            <p:nvGrpSpPr>
              <p:cNvPr id="180" name="Group 246"/>
              <p:cNvGrpSpPr>
                <a:grpSpLocks noChangeAspect="1"/>
              </p:cNvGrpSpPr>
              <p:nvPr/>
            </p:nvGrpSpPr>
            <p:grpSpPr bwMode="auto">
              <a:xfrm>
                <a:off x="779822" y="2588267"/>
                <a:ext cx="1599513" cy="1792224"/>
                <a:chOff x="1600" y="432"/>
                <a:chExt cx="1328" cy="1488"/>
              </a:xfrm>
            </p:grpSpPr>
            <p:sp>
              <p:nvSpPr>
                <p:cNvPr id="181" name="AutoShape 245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1600" y="432"/>
                  <a:ext cx="1328" cy="14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183" name="Group 333"/>
                <p:cNvGrpSpPr>
                  <a:grpSpLocks/>
                </p:cNvGrpSpPr>
                <p:nvPr/>
              </p:nvGrpSpPr>
              <p:grpSpPr bwMode="auto">
                <a:xfrm>
                  <a:off x="1672" y="444"/>
                  <a:ext cx="1245" cy="1176"/>
                  <a:chOff x="1672" y="444"/>
                  <a:chExt cx="1245" cy="1176"/>
                </a:xfrm>
              </p:grpSpPr>
              <p:grpSp>
                <p:nvGrpSpPr>
                  <p:cNvPr id="184" name="Group 331"/>
                  <p:cNvGrpSpPr>
                    <a:grpSpLocks/>
                  </p:cNvGrpSpPr>
                  <p:nvPr/>
                </p:nvGrpSpPr>
                <p:grpSpPr bwMode="auto">
                  <a:xfrm>
                    <a:off x="1672" y="444"/>
                    <a:ext cx="1245" cy="1176"/>
                    <a:chOff x="1672" y="444"/>
                    <a:chExt cx="1245" cy="1176"/>
                  </a:xfrm>
                </p:grpSpPr>
                <p:sp>
                  <p:nvSpPr>
                    <p:cNvPr id="186" name="Rectangle 25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810" y="478"/>
                      <a:ext cx="1032" cy="1032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635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87" name="Group 298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792" y="1508"/>
                      <a:ext cx="1125" cy="112"/>
                      <a:chOff x="1792" y="1508"/>
                      <a:chExt cx="1125" cy="112"/>
                    </a:xfrm>
                  </p:grpSpPr>
                  <p:sp>
                    <p:nvSpPr>
                      <p:cNvPr id="253" name="Line 25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08" y="1508"/>
                        <a:ext cx="1032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254" name="Group 290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808" y="1512"/>
                        <a:ext cx="1032" cy="24"/>
                        <a:chOff x="1808" y="1512"/>
                        <a:chExt cx="1032" cy="24"/>
                      </a:xfrm>
                    </p:grpSpPr>
                    <p:sp>
                      <p:nvSpPr>
                        <p:cNvPr id="2310" name="Line 25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808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1" name="Line 25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88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2" name="Line 25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92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3" name="Line 25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96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4" name="Line 25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1988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5" name="Line 25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00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6" name="Line 25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02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7" name="Line 26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04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8" name="Line 26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05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9" name="Line 26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064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0" name="Line 26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14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1" name="Line 26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18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2" name="Line 26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2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3" name="Line 26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44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4" name="Line 26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6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5" name="Line 26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8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6" name="Line 26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0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7" name="Line 27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1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8" name="Line 27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24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9" name="Line 27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0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0" name="Line 27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4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1" name="Line 27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8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2" name="Line 27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04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3" name="Line 27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2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4" name="Line 27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4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5" name="Line 27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5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6" name="Line 27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7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7" name="Line 28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84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8" name="Line 28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6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9" name="Line 28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0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0" name="Line 28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4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1" name="Line 28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64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2" name="Line 28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8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3" name="Line 28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0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4" name="Line 28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1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5" name="Line 28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2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6" name="Line 28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40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  <p:grpSp>
                    <p:nvGrpSpPr>
                      <p:cNvPr id="255" name="Group 296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792" y="1552"/>
                        <a:ext cx="1125" cy="68"/>
                        <a:chOff x="1792" y="1552"/>
                        <a:chExt cx="1125" cy="68"/>
                      </a:xfrm>
                    </p:grpSpPr>
                    <p:sp>
                      <p:nvSpPr>
                        <p:cNvPr id="2305" name="Rectangle 29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792" y="1552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06" name="Rectangle 29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032" y="1552"/>
                          <a:ext cx="63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07" name="Rectangle 29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276" y="155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08" name="Rectangle 29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20" y="1552"/>
                          <a:ext cx="125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309" name="Rectangle 29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60" y="1552"/>
                          <a:ext cx="157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0</a:t>
                          </a:r>
                          <a:endParaRPr kumimoji="0" lang="en-US" altLang="en-US" sz="18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188" name="Group 330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1672" y="444"/>
                      <a:ext cx="136" cy="1104"/>
                      <a:chOff x="1672" y="444"/>
                      <a:chExt cx="136" cy="1104"/>
                    </a:xfrm>
                  </p:grpSpPr>
                  <p:sp>
                    <p:nvSpPr>
                      <p:cNvPr id="189" name="Line 299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1808" y="476"/>
                        <a:ext cx="0" cy="1032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190" name="Group 306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672" y="444"/>
                        <a:ext cx="95" cy="1104"/>
                        <a:chOff x="1672" y="444"/>
                        <a:chExt cx="95" cy="1104"/>
                      </a:xfrm>
                    </p:grpSpPr>
                    <p:sp>
                      <p:nvSpPr>
                        <p:cNvPr id="247" name="Rectangle 30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736" y="1480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8" name="Rectangle 301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72" y="1276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9" name="Rectangle 302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72" y="1068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2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50" name="Rectangle 30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72" y="860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3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51" name="Rectangle 30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72" y="65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4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52" name="Rectangle 30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1672" y="444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5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191" name="Group 328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1784" y="472"/>
                        <a:ext cx="24" cy="1036"/>
                        <a:chOff x="1784" y="472"/>
                        <a:chExt cx="24" cy="1036"/>
                      </a:xfrm>
                    </p:grpSpPr>
                    <p:sp>
                      <p:nvSpPr>
                        <p:cNvPr id="225" name="Line 30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1508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6" name="Line 30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46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7" name="Line 30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40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8" name="Line 31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35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9" name="Line 31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1304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0" name="Line 31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25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1" name="Line 31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20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2" name="Line 31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14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3" name="Line 31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1096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" name="Line 31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104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5" name="Line 31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99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6" name="Line 31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94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7" name="Line 31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888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8" name="Line 32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83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9" name="Line 32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78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0" name="Line 32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73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1" name="Line 32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680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2" name="Line 32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62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3" name="Line 32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57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5" name="Line 32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800" y="52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6" name="Line 32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1784" y="472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</p:grpSp>
              </p:grpSp>
              <p:sp>
                <p:nvSpPr>
                  <p:cNvPr id="185" name="Freeform 332"/>
                  <p:cNvSpPr>
                    <a:spLocks/>
                  </p:cNvSpPr>
                  <p:nvPr/>
                </p:nvSpPr>
                <p:spPr bwMode="auto">
                  <a:xfrm>
                    <a:off x="1816" y="620"/>
                    <a:ext cx="1016" cy="884"/>
                  </a:xfrm>
                  <a:custGeom>
                    <a:avLst/>
                    <a:gdLst>
                      <a:gd name="T0" fmla="*/ 12 w 1016"/>
                      <a:gd name="T1" fmla="*/ 884 h 884"/>
                      <a:gd name="T2" fmla="*/ 28 w 1016"/>
                      <a:gd name="T3" fmla="*/ 884 h 884"/>
                      <a:gd name="T4" fmla="*/ 44 w 1016"/>
                      <a:gd name="T5" fmla="*/ 880 h 884"/>
                      <a:gd name="T6" fmla="*/ 60 w 1016"/>
                      <a:gd name="T7" fmla="*/ 868 h 884"/>
                      <a:gd name="T8" fmla="*/ 76 w 1016"/>
                      <a:gd name="T9" fmla="*/ 832 h 884"/>
                      <a:gd name="T10" fmla="*/ 92 w 1016"/>
                      <a:gd name="T11" fmla="*/ 760 h 884"/>
                      <a:gd name="T12" fmla="*/ 108 w 1016"/>
                      <a:gd name="T13" fmla="*/ 556 h 884"/>
                      <a:gd name="T14" fmla="*/ 124 w 1016"/>
                      <a:gd name="T15" fmla="*/ 348 h 884"/>
                      <a:gd name="T16" fmla="*/ 140 w 1016"/>
                      <a:gd name="T17" fmla="*/ 80 h 884"/>
                      <a:gd name="T18" fmla="*/ 156 w 1016"/>
                      <a:gd name="T19" fmla="*/ 8 h 884"/>
                      <a:gd name="T20" fmla="*/ 172 w 1016"/>
                      <a:gd name="T21" fmla="*/ 24 h 884"/>
                      <a:gd name="T22" fmla="*/ 188 w 1016"/>
                      <a:gd name="T23" fmla="*/ 184 h 884"/>
                      <a:gd name="T24" fmla="*/ 204 w 1016"/>
                      <a:gd name="T25" fmla="*/ 400 h 884"/>
                      <a:gd name="T26" fmla="*/ 220 w 1016"/>
                      <a:gd name="T27" fmla="*/ 716 h 884"/>
                      <a:gd name="T28" fmla="*/ 236 w 1016"/>
                      <a:gd name="T29" fmla="*/ 824 h 884"/>
                      <a:gd name="T30" fmla="*/ 252 w 1016"/>
                      <a:gd name="T31" fmla="*/ 848 h 884"/>
                      <a:gd name="T32" fmla="*/ 268 w 1016"/>
                      <a:gd name="T33" fmla="*/ 868 h 884"/>
                      <a:gd name="T34" fmla="*/ 284 w 1016"/>
                      <a:gd name="T35" fmla="*/ 880 h 884"/>
                      <a:gd name="T36" fmla="*/ 300 w 1016"/>
                      <a:gd name="T37" fmla="*/ 884 h 884"/>
                      <a:gd name="T38" fmla="*/ 316 w 1016"/>
                      <a:gd name="T39" fmla="*/ 884 h 884"/>
                      <a:gd name="T40" fmla="*/ 332 w 1016"/>
                      <a:gd name="T41" fmla="*/ 884 h 884"/>
                      <a:gd name="T42" fmla="*/ 348 w 1016"/>
                      <a:gd name="T43" fmla="*/ 884 h 884"/>
                      <a:gd name="T44" fmla="*/ 364 w 1016"/>
                      <a:gd name="T45" fmla="*/ 884 h 884"/>
                      <a:gd name="T46" fmla="*/ 380 w 1016"/>
                      <a:gd name="T47" fmla="*/ 884 h 884"/>
                      <a:gd name="T48" fmla="*/ 396 w 1016"/>
                      <a:gd name="T49" fmla="*/ 884 h 884"/>
                      <a:gd name="T50" fmla="*/ 412 w 1016"/>
                      <a:gd name="T51" fmla="*/ 884 h 884"/>
                      <a:gd name="T52" fmla="*/ 428 w 1016"/>
                      <a:gd name="T53" fmla="*/ 884 h 884"/>
                      <a:gd name="T54" fmla="*/ 444 w 1016"/>
                      <a:gd name="T55" fmla="*/ 884 h 884"/>
                      <a:gd name="T56" fmla="*/ 460 w 1016"/>
                      <a:gd name="T57" fmla="*/ 884 h 884"/>
                      <a:gd name="T58" fmla="*/ 476 w 1016"/>
                      <a:gd name="T59" fmla="*/ 884 h 884"/>
                      <a:gd name="T60" fmla="*/ 492 w 1016"/>
                      <a:gd name="T61" fmla="*/ 884 h 884"/>
                      <a:gd name="T62" fmla="*/ 508 w 1016"/>
                      <a:gd name="T63" fmla="*/ 884 h 884"/>
                      <a:gd name="T64" fmla="*/ 524 w 1016"/>
                      <a:gd name="T65" fmla="*/ 884 h 884"/>
                      <a:gd name="T66" fmla="*/ 540 w 1016"/>
                      <a:gd name="T67" fmla="*/ 884 h 884"/>
                      <a:gd name="T68" fmla="*/ 556 w 1016"/>
                      <a:gd name="T69" fmla="*/ 884 h 884"/>
                      <a:gd name="T70" fmla="*/ 572 w 1016"/>
                      <a:gd name="T71" fmla="*/ 884 h 884"/>
                      <a:gd name="T72" fmla="*/ 588 w 1016"/>
                      <a:gd name="T73" fmla="*/ 884 h 884"/>
                      <a:gd name="T74" fmla="*/ 604 w 1016"/>
                      <a:gd name="T75" fmla="*/ 884 h 884"/>
                      <a:gd name="T76" fmla="*/ 620 w 1016"/>
                      <a:gd name="T77" fmla="*/ 884 h 884"/>
                      <a:gd name="T78" fmla="*/ 636 w 1016"/>
                      <a:gd name="T79" fmla="*/ 884 h 884"/>
                      <a:gd name="T80" fmla="*/ 652 w 1016"/>
                      <a:gd name="T81" fmla="*/ 884 h 884"/>
                      <a:gd name="T82" fmla="*/ 668 w 1016"/>
                      <a:gd name="T83" fmla="*/ 884 h 884"/>
                      <a:gd name="T84" fmla="*/ 684 w 1016"/>
                      <a:gd name="T85" fmla="*/ 884 h 884"/>
                      <a:gd name="T86" fmla="*/ 700 w 1016"/>
                      <a:gd name="T87" fmla="*/ 884 h 884"/>
                      <a:gd name="T88" fmla="*/ 716 w 1016"/>
                      <a:gd name="T89" fmla="*/ 884 h 884"/>
                      <a:gd name="T90" fmla="*/ 732 w 1016"/>
                      <a:gd name="T91" fmla="*/ 884 h 884"/>
                      <a:gd name="T92" fmla="*/ 748 w 1016"/>
                      <a:gd name="T93" fmla="*/ 884 h 884"/>
                      <a:gd name="T94" fmla="*/ 764 w 1016"/>
                      <a:gd name="T95" fmla="*/ 884 h 884"/>
                      <a:gd name="T96" fmla="*/ 780 w 1016"/>
                      <a:gd name="T97" fmla="*/ 884 h 884"/>
                      <a:gd name="T98" fmla="*/ 796 w 1016"/>
                      <a:gd name="T99" fmla="*/ 884 h 884"/>
                      <a:gd name="T100" fmla="*/ 812 w 1016"/>
                      <a:gd name="T101" fmla="*/ 884 h 884"/>
                      <a:gd name="T102" fmla="*/ 828 w 1016"/>
                      <a:gd name="T103" fmla="*/ 884 h 884"/>
                      <a:gd name="T104" fmla="*/ 844 w 1016"/>
                      <a:gd name="T105" fmla="*/ 884 h 884"/>
                      <a:gd name="T106" fmla="*/ 860 w 1016"/>
                      <a:gd name="T107" fmla="*/ 884 h 884"/>
                      <a:gd name="T108" fmla="*/ 876 w 1016"/>
                      <a:gd name="T109" fmla="*/ 884 h 884"/>
                      <a:gd name="T110" fmla="*/ 892 w 1016"/>
                      <a:gd name="T111" fmla="*/ 884 h 884"/>
                      <a:gd name="T112" fmla="*/ 908 w 1016"/>
                      <a:gd name="T113" fmla="*/ 884 h 884"/>
                      <a:gd name="T114" fmla="*/ 924 w 1016"/>
                      <a:gd name="T115" fmla="*/ 884 h 884"/>
                      <a:gd name="T116" fmla="*/ 940 w 1016"/>
                      <a:gd name="T117" fmla="*/ 884 h 884"/>
                      <a:gd name="T118" fmla="*/ 956 w 1016"/>
                      <a:gd name="T119" fmla="*/ 884 h 884"/>
                      <a:gd name="T120" fmla="*/ 972 w 1016"/>
                      <a:gd name="T121" fmla="*/ 884 h 884"/>
                      <a:gd name="T122" fmla="*/ 988 w 1016"/>
                      <a:gd name="T123" fmla="*/ 884 h 884"/>
                      <a:gd name="T124" fmla="*/ 1004 w 1016"/>
                      <a:gd name="T125" fmla="*/ 884 h 88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  <a:cxn ang="0">
                        <a:pos x="T110" y="T111"/>
                      </a:cxn>
                      <a:cxn ang="0">
                        <a:pos x="T112" y="T113"/>
                      </a:cxn>
                      <a:cxn ang="0">
                        <a:pos x="T114" y="T115"/>
                      </a:cxn>
                      <a:cxn ang="0">
                        <a:pos x="T116" y="T117"/>
                      </a:cxn>
                      <a:cxn ang="0">
                        <a:pos x="T118" y="T119"/>
                      </a:cxn>
                      <a:cxn ang="0">
                        <a:pos x="T120" y="T121"/>
                      </a:cxn>
                      <a:cxn ang="0">
                        <a:pos x="T122" y="T123"/>
                      </a:cxn>
                      <a:cxn ang="0">
                        <a:pos x="T124" y="T125"/>
                      </a:cxn>
                    </a:cxnLst>
                    <a:rect l="0" t="0" r="r" b="b"/>
                    <a:pathLst>
                      <a:path w="1016" h="884">
                        <a:moveTo>
                          <a:pt x="0" y="884"/>
                        </a:moveTo>
                        <a:lnTo>
                          <a:pt x="4" y="884"/>
                        </a:lnTo>
                        <a:lnTo>
                          <a:pt x="8" y="884"/>
                        </a:lnTo>
                        <a:lnTo>
                          <a:pt x="12" y="884"/>
                        </a:lnTo>
                        <a:lnTo>
                          <a:pt x="16" y="884"/>
                        </a:lnTo>
                        <a:lnTo>
                          <a:pt x="20" y="884"/>
                        </a:lnTo>
                        <a:lnTo>
                          <a:pt x="24" y="884"/>
                        </a:lnTo>
                        <a:lnTo>
                          <a:pt x="28" y="884"/>
                        </a:lnTo>
                        <a:lnTo>
                          <a:pt x="32" y="884"/>
                        </a:lnTo>
                        <a:lnTo>
                          <a:pt x="36" y="880"/>
                        </a:lnTo>
                        <a:lnTo>
                          <a:pt x="40" y="880"/>
                        </a:lnTo>
                        <a:lnTo>
                          <a:pt x="44" y="880"/>
                        </a:lnTo>
                        <a:lnTo>
                          <a:pt x="48" y="876"/>
                        </a:lnTo>
                        <a:lnTo>
                          <a:pt x="52" y="876"/>
                        </a:lnTo>
                        <a:lnTo>
                          <a:pt x="56" y="872"/>
                        </a:lnTo>
                        <a:lnTo>
                          <a:pt x="60" y="868"/>
                        </a:lnTo>
                        <a:lnTo>
                          <a:pt x="64" y="864"/>
                        </a:lnTo>
                        <a:lnTo>
                          <a:pt x="68" y="852"/>
                        </a:lnTo>
                        <a:lnTo>
                          <a:pt x="72" y="844"/>
                        </a:lnTo>
                        <a:lnTo>
                          <a:pt x="76" y="832"/>
                        </a:lnTo>
                        <a:lnTo>
                          <a:pt x="80" y="820"/>
                        </a:lnTo>
                        <a:lnTo>
                          <a:pt x="84" y="804"/>
                        </a:lnTo>
                        <a:lnTo>
                          <a:pt x="88" y="784"/>
                        </a:lnTo>
                        <a:lnTo>
                          <a:pt x="92" y="760"/>
                        </a:lnTo>
                        <a:lnTo>
                          <a:pt x="96" y="728"/>
                        </a:lnTo>
                        <a:lnTo>
                          <a:pt x="100" y="676"/>
                        </a:lnTo>
                        <a:lnTo>
                          <a:pt x="104" y="616"/>
                        </a:lnTo>
                        <a:lnTo>
                          <a:pt x="108" y="556"/>
                        </a:lnTo>
                        <a:lnTo>
                          <a:pt x="112" y="476"/>
                        </a:lnTo>
                        <a:lnTo>
                          <a:pt x="116" y="392"/>
                        </a:lnTo>
                        <a:lnTo>
                          <a:pt x="120" y="352"/>
                        </a:lnTo>
                        <a:lnTo>
                          <a:pt x="124" y="348"/>
                        </a:lnTo>
                        <a:lnTo>
                          <a:pt x="128" y="284"/>
                        </a:lnTo>
                        <a:lnTo>
                          <a:pt x="132" y="196"/>
                        </a:lnTo>
                        <a:lnTo>
                          <a:pt x="136" y="132"/>
                        </a:lnTo>
                        <a:lnTo>
                          <a:pt x="140" y="80"/>
                        </a:lnTo>
                        <a:lnTo>
                          <a:pt x="144" y="44"/>
                        </a:lnTo>
                        <a:lnTo>
                          <a:pt x="148" y="12"/>
                        </a:lnTo>
                        <a:lnTo>
                          <a:pt x="152" y="4"/>
                        </a:lnTo>
                        <a:lnTo>
                          <a:pt x="156" y="8"/>
                        </a:lnTo>
                        <a:lnTo>
                          <a:pt x="160" y="8"/>
                        </a:lnTo>
                        <a:lnTo>
                          <a:pt x="164" y="0"/>
                        </a:lnTo>
                        <a:lnTo>
                          <a:pt x="168" y="8"/>
                        </a:lnTo>
                        <a:lnTo>
                          <a:pt x="172" y="24"/>
                        </a:lnTo>
                        <a:lnTo>
                          <a:pt x="176" y="64"/>
                        </a:lnTo>
                        <a:lnTo>
                          <a:pt x="180" y="100"/>
                        </a:lnTo>
                        <a:lnTo>
                          <a:pt x="184" y="128"/>
                        </a:lnTo>
                        <a:lnTo>
                          <a:pt x="188" y="184"/>
                        </a:lnTo>
                        <a:lnTo>
                          <a:pt x="192" y="280"/>
                        </a:lnTo>
                        <a:lnTo>
                          <a:pt x="196" y="352"/>
                        </a:lnTo>
                        <a:lnTo>
                          <a:pt x="200" y="352"/>
                        </a:lnTo>
                        <a:lnTo>
                          <a:pt x="204" y="400"/>
                        </a:lnTo>
                        <a:lnTo>
                          <a:pt x="208" y="516"/>
                        </a:lnTo>
                        <a:lnTo>
                          <a:pt x="212" y="620"/>
                        </a:lnTo>
                        <a:lnTo>
                          <a:pt x="216" y="684"/>
                        </a:lnTo>
                        <a:lnTo>
                          <a:pt x="220" y="716"/>
                        </a:lnTo>
                        <a:lnTo>
                          <a:pt x="224" y="744"/>
                        </a:lnTo>
                        <a:lnTo>
                          <a:pt x="228" y="780"/>
                        </a:lnTo>
                        <a:lnTo>
                          <a:pt x="232" y="808"/>
                        </a:lnTo>
                        <a:lnTo>
                          <a:pt x="236" y="824"/>
                        </a:lnTo>
                        <a:lnTo>
                          <a:pt x="240" y="828"/>
                        </a:lnTo>
                        <a:lnTo>
                          <a:pt x="244" y="836"/>
                        </a:lnTo>
                        <a:lnTo>
                          <a:pt x="248" y="840"/>
                        </a:lnTo>
                        <a:lnTo>
                          <a:pt x="252" y="848"/>
                        </a:lnTo>
                        <a:lnTo>
                          <a:pt x="256" y="852"/>
                        </a:lnTo>
                        <a:lnTo>
                          <a:pt x="260" y="856"/>
                        </a:lnTo>
                        <a:lnTo>
                          <a:pt x="264" y="864"/>
                        </a:lnTo>
                        <a:lnTo>
                          <a:pt x="268" y="868"/>
                        </a:lnTo>
                        <a:lnTo>
                          <a:pt x="272" y="872"/>
                        </a:lnTo>
                        <a:lnTo>
                          <a:pt x="276" y="876"/>
                        </a:lnTo>
                        <a:lnTo>
                          <a:pt x="280" y="876"/>
                        </a:lnTo>
                        <a:lnTo>
                          <a:pt x="284" y="880"/>
                        </a:lnTo>
                        <a:lnTo>
                          <a:pt x="288" y="880"/>
                        </a:lnTo>
                        <a:lnTo>
                          <a:pt x="292" y="880"/>
                        </a:lnTo>
                        <a:lnTo>
                          <a:pt x="296" y="880"/>
                        </a:lnTo>
                        <a:lnTo>
                          <a:pt x="300" y="884"/>
                        </a:lnTo>
                        <a:lnTo>
                          <a:pt x="304" y="884"/>
                        </a:lnTo>
                        <a:lnTo>
                          <a:pt x="308" y="884"/>
                        </a:lnTo>
                        <a:lnTo>
                          <a:pt x="312" y="884"/>
                        </a:lnTo>
                        <a:lnTo>
                          <a:pt x="316" y="884"/>
                        </a:lnTo>
                        <a:lnTo>
                          <a:pt x="320" y="884"/>
                        </a:lnTo>
                        <a:lnTo>
                          <a:pt x="324" y="884"/>
                        </a:lnTo>
                        <a:lnTo>
                          <a:pt x="328" y="884"/>
                        </a:lnTo>
                        <a:lnTo>
                          <a:pt x="332" y="884"/>
                        </a:lnTo>
                        <a:lnTo>
                          <a:pt x="336" y="884"/>
                        </a:lnTo>
                        <a:lnTo>
                          <a:pt x="340" y="884"/>
                        </a:lnTo>
                        <a:lnTo>
                          <a:pt x="344" y="884"/>
                        </a:lnTo>
                        <a:lnTo>
                          <a:pt x="348" y="884"/>
                        </a:lnTo>
                        <a:lnTo>
                          <a:pt x="352" y="884"/>
                        </a:lnTo>
                        <a:lnTo>
                          <a:pt x="356" y="884"/>
                        </a:lnTo>
                        <a:lnTo>
                          <a:pt x="360" y="884"/>
                        </a:lnTo>
                        <a:lnTo>
                          <a:pt x="364" y="884"/>
                        </a:lnTo>
                        <a:lnTo>
                          <a:pt x="368" y="884"/>
                        </a:lnTo>
                        <a:lnTo>
                          <a:pt x="372" y="884"/>
                        </a:lnTo>
                        <a:lnTo>
                          <a:pt x="376" y="884"/>
                        </a:lnTo>
                        <a:lnTo>
                          <a:pt x="380" y="884"/>
                        </a:lnTo>
                        <a:lnTo>
                          <a:pt x="384" y="884"/>
                        </a:lnTo>
                        <a:lnTo>
                          <a:pt x="388" y="884"/>
                        </a:lnTo>
                        <a:lnTo>
                          <a:pt x="392" y="884"/>
                        </a:lnTo>
                        <a:lnTo>
                          <a:pt x="396" y="884"/>
                        </a:lnTo>
                        <a:lnTo>
                          <a:pt x="400" y="884"/>
                        </a:lnTo>
                        <a:lnTo>
                          <a:pt x="404" y="884"/>
                        </a:lnTo>
                        <a:lnTo>
                          <a:pt x="408" y="884"/>
                        </a:lnTo>
                        <a:lnTo>
                          <a:pt x="412" y="884"/>
                        </a:lnTo>
                        <a:lnTo>
                          <a:pt x="416" y="884"/>
                        </a:lnTo>
                        <a:lnTo>
                          <a:pt x="420" y="884"/>
                        </a:lnTo>
                        <a:lnTo>
                          <a:pt x="424" y="884"/>
                        </a:lnTo>
                        <a:lnTo>
                          <a:pt x="428" y="884"/>
                        </a:lnTo>
                        <a:lnTo>
                          <a:pt x="432" y="884"/>
                        </a:lnTo>
                        <a:lnTo>
                          <a:pt x="436" y="884"/>
                        </a:lnTo>
                        <a:lnTo>
                          <a:pt x="440" y="884"/>
                        </a:lnTo>
                        <a:lnTo>
                          <a:pt x="444" y="884"/>
                        </a:lnTo>
                        <a:lnTo>
                          <a:pt x="448" y="884"/>
                        </a:lnTo>
                        <a:lnTo>
                          <a:pt x="452" y="884"/>
                        </a:lnTo>
                        <a:lnTo>
                          <a:pt x="456" y="884"/>
                        </a:lnTo>
                        <a:lnTo>
                          <a:pt x="460" y="884"/>
                        </a:lnTo>
                        <a:lnTo>
                          <a:pt x="464" y="884"/>
                        </a:lnTo>
                        <a:lnTo>
                          <a:pt x="468" y="884"/>
                        </a:lnTo>
                        <a:lnTo>
                          <a:pt x="472" y="884"/>
                        </a:lnTo>
                        <a:lnTo>
                          <a:pt x="476" y="884"/>
                        </a:lnTo>
                        <a:lnTo>
                          <a:pt x="480" y="884"/>
                        </a:lnTo>
                        <a:lnTo>
                          <a:pt x="484" y="884"/>
                        </a:lnTo>
                        <a:lnTo>
                          <a:pt x="488" y="884"/>
                        </a:lnTo>
                        <a:lnTo>
                          <a:pt x="492" y="884"/>
                        </a:lnTo>
                        <a:lnTo>
                          <a:pt x="496" y="884"/>
                        </a:lnTo>
                        <a:lnTo>
                          <a:pt x="500" y="884"/>
                        </a:lnTo>
                        <a:lnTo>
                          <a:pt x="504" y="884"/>
                        </a:lnTo>
                        <a:lnTo>
                          <a:pt x="508" y="884"/>
                        </a:lnTo>
                        <a:lnTo>
                          <a:pt x="512" y="884"/>
                        </a:lnTo>
                        <a:lnTo>
                          <a:pt x="516" y="884"/>
                        </a:lnTo>
                        <a:lnTo>
                          <a:pt x="520" y="884"/>
                        </a:lnTo>
                        <a:lnTo>
                          <a:pt x="524" y="884"/>
                        </a:lnTo>
                        <a:lnTo>
                          <a:pt x="528" y="884"/>
                        </a:lnTo>
                        <a:lnTo>
                          <a:pt x="532" y="884"/>
                        </a:lnTo>
                        <a:lnTo>
                          <a:pt x="536" y="884"/>
                        </a:lnTo>
                        <a:lnTo>
                          <a:pt x="540" y="884"/>
                        </a:lnTo>
                        <a:lnTo>
                          <a:pt x="544" y="884"/>
                        </a:lnTo>
                        <a:lnTo>
                          <a:pt x="548" y="884"/>
                        </a:lnTo>
                        <a:lnTo>
                          <a:pt x="552" y="884"/>
                        </a:lnTo>
                        <a:lnTo>
                          <a:pt x="556" y="884"/>
                        </a:lnTo>
                        <a:lnTo>
                          <a:pt x="560" y="884"/>
                        </a:lnTo>
                        <a:lnTo>
                          <a:pt x="564" y="884"/>
                        </a:lnTo>
                        <a:lnTo>
                          <a:pt x="568" y="884"/>
                        </a:lnTo>
                        <a:lnTo>
                          <a:pt x="572" y="884"/>
                        </a:lnTo>
                        <a:lnTo>
                          <a:pt x="576" y="884"/>
                        </a:lnTo>
                        <a:lnTo>
                          <a:pt x="580" y="884"/>
                        </a:lnTo>
                        <a:lnTo>
                          <a:pt x="584" y="884"/>
                        </a:lnTo>
                        <a:lnTo>
                          <a:pt x="588" y="884"/>
                        </a:lnTo>
                        <a:lnTo>
                          <a:pt x="592" y="884"/>
                        </a:lnTo>
                        <a:lnTo>
                          <a:pt x="596" y="884"/>
                        </a:lnTo>
                        <a:lnTo>
                          <a:pt x="600" y="884"/>
                        </a:lnTo>
                        <a:lnTo>
                          <a:pt x="604" y="884"/>
                        </a:lnTo>
                        <a:lnTo>
                          <a:pt x="608" y="884"/>
                        </a:lnTo>
                        <a:lnTo>
                          <a:pt x="612" y="884"/>
                        </a:lnTo>
                        <a:lnTo>
                          <a:pt x="616" y="884"/>
                        </a:lnTo>
                        <a:lnTo>
                          <a:pt x="620" y="884"/>
                        </a:lnTo>
                        <a:lnTo>
                          <a:pt x="624" y="884"/>
                        </a:lnTo>
                        <a:lnTo>
                          <a:pt x="628" y="884"/>
                        </a:lnTo>
                        <a:lnTo>
                          <a:pt x="632" y="884"/>
                        </a:lnTo>
                        <a:lnTo>
                          <a:pt x="636" y="884"/>
                        </a:lnTo>
                        <a:lnTo>
                          <a:pt x="640" y="884"/>
                        </a:lnTo>
                        <a:lnTo>
                          <a:pt x="644" y="884"/>
                        </a:lnTo>
                        <a:lnTo>
                          <a:pt x="648" y="884"/>
                        </a:lnTo>
                        <a:lnTo>
                          <a:pt x="652" y="884"/>
                        </a:lnTo>
                        <a:lnTo>
                          <a:pt x="656" y="884"/>
                        </a:lnTo>
                        <a:lnTo>
                          <a:pt x="660" y="884"/>
                        </a:lnTo>
                        <a:lnTo>
                          <a:pt x="664" y="884"/>
                        </a:lnTo>
                        <a:lnTo>
                          <a:pt x="668" y="884"/>
                        </a:lnTo>
                        <a:lnTo>
                          <a:pt x="672" y="884"/>
                        </a:lnTo>
                        <a:lnTo>
                          <a:pt x="676" y="884"/>
                        </a:lnTo>
                        <a:lnTo>
                          <a:pt x="680" y="884"/>
                        </a:lnTo>
                        <a:lnTo>
                          <a:pt x="684" y="884"/>
                        </a:lnTo>
                        <a:lnTo>
                          <a:pt x="688" y="884"/>
                        </a:lnTo>
                        <a:lnTo>
                          <a:pt x="692" y="884"/>
                        </a:lnTo>
                        <a:lnTo>
                          <a:pt x="696" y="884"/>
                        </a:lnTo>
                        <a:lnTo>
                          <a:pt x="700" y="884"/>
                        </a:lnTo>
                        <a:lnTo>
                          <a:pt x="704" y="884"/>
                        </a:lnTo>
                        <a:lnTo>
                          <a:pt x="708" y="884"/>
                        </a:lnTo>
                        <a:lnTo>
                          <a:pt x="712" y="884"/>
                        </a:lnTo>
                        <a:lnTo>
                          <a:pt x="716" y="884"/>
                        </a:lnTo>
                        <a:lnTo>
                          <a:pt x="720" y="884"/>
                        </a:lnTo>
                        <a:lnTo>
                          <a:pt x="724" y="884"/>
                        </a:lnTo>
                        <a:lnTo>
                          <a:pt x="728" y="884"/>
                        </a:lnTo>
                        <a:lnTo>
                          <a:pt x="732" y="884"/>
                        </a:lnTo>
                        <a:lnTo>
                          <a:pt x="736" y="884"/>
                        </a:lnTo>
                        <a:lnTo>
                          <a:pt x="740" y="884"/>
                        </a:lnTo>
                        <a:lnTo>
                          <a:pt x="744" y="884"/>
                        </a:lnTo>
                        <a:lnTo>
                          <a:pt x="748" y="884"/>
                        </a:lnTo>
                        <a:lnTo>
                          <a:pt x="752" y="884"/>
                        </a:lnTo>
                        <a:lnTo>
                          <a:pt x="756" y="884"/>
                        </a:lnTo>
                        <a:lnTo>
                          <a:pt x="760" y="884"/>
                        </a:lnTo>
                        <a:lnTo>
                          <a:pt x="764" y="884"/>
                        </a:lnTo>
                        <a:lnTo>
                          <a:pt x="768" y="884"/>
                        </a:lnTo>
                        <a:lnTo>
                          <a:pt x="772" y="884"/>
                        </a:lnTo>
                        <a:lnTo>
                          <a:pt x="776" y="884"/>
                        </a:lnTo>
                        <a:lnTo>
                          <a:pt x="780" y="884"/>
                        </a:lnTo>
                        <a:lnTo>
                          <a:pt x="784" y="884"/>
                        </a:lnTo>
                        <a:lnTo>
                          <a:pt x="788" y="884"/>
                        </a:lnTo>
                        <a:lnTo>
                          <a:pt x="792" y="884"/>
                        </a:lnTo>
                        <a:lnTo>
                          <a:pt x="796" y="884"/>
                        </a:lnTo>
                        <a:lnTo>
                          <a:pt x="800" y="884"/>
                        </a:lnTo>
                        <a:lnTo>
                          <a:pt x="804" y="884"/>
                        </a:lnTo>
                        <a:lnTo>
                          <a:pt x="808" y="884"/>
                        </a:lnTo>
                        <a:lnTo>
                          <a:pt x="812" y="884"/>
                        </a:lnTo>
                        <a:lnTo>
                          <a:pt x="816" y="884"/>
                        </a:lnTo>
                        <a:lnTo>
                          <a:pt x="820" y="884"/>
                        </a:lnTo>
                        <a:lnTo>
                          <a:pt x="824" y="884"/>
                        </a:lnTo>
                        <a:lnTo>
                          <a:pt x="828" y="884"/>
                        </a:lnTo>
                        <a:lnTo>
                          <a:pt x="832" y="884"/>
                        </a:lnTo>
                        <a:lnTo>
                          <a:pt x="836" y="884"/>
                        </a:lnTo>
                        <a:lnTo>
                          <a:pt x="840" y="884"/>
                        </a:lnTo>
                        <a:lnTo>
                          <a:pt x="844" y="884"/>
                        </a:lnTo>
                        <a:lnTo>
                          <a:pt x="848" y="884"/>
                        </a:lnTo>
                        <a:lnTo>
                          <a:pt x="852" y="884"/>
                        </a:lnTo>
                        <a:lnTo>
                          <a:pt x="856" y="884"/>
                        </a:lnTo>
                        <a:lnTo>
                          <a:pt x="860" y="884"/>
                        </a:lnTo>
                        <a:lnTo>
                          <a:pt x="864" y="884"/>
                        </a:lnTo>
                        <a:lnTo>
                          <a:pt x="868" y="884"/>
                        </a:lnTo>
                        <a:lnTo>
                          <a:pt x="872" y="884"/>
                        </a:lnTo>
                        <a:lnTo>
                          <a:pt x="876" y="884"/>
                        </a:lnTo>
                        <a:lnTo>
                          <a:pt x="880" y="884"/>
                        </a:lnTo>
                        <a:lnTo>
                          <a:pt x="884" y="884"/>
                        </a:lnTo>
                        <a:lnTo>
                          <a:pt x="888" y="884"/>
                        </a:lnTo>
                        <a:lnTo>
                          <a:pt x="892" y="884"/>
                        </a:lnTo>
                        <a:lnTo>
                          <a:pt x="896" y="884"/>
                        </a:lnTo>
                        <a:lnTo>
                          <a:pt x="900" y="884"/>
                        </a:lnTo>
                        <a:lnTo>
                          <a:pt x="904" y="884"/>
                        </a:lnTo>
                        <a:lnTo>
                          <a:pt x="908" y="884"/>
                        </a:lnTo>
                        <a:lnTo>
                          <a:pt x="912" y="884"/>
                        </a:lnTo>
                        <a:lnTo>
                          <a:pt x="916" y="884"/>
                        </a:lnTo>
                        <a:lnTo>
                          <a:pt x="920" y="884"/>
                        </a:lnTo>
                        <a:lnTo>
                          <a:pt x="924" y="884"/>
                        </a:lnTo>
                        <a:lnTo>
                          <a:pt x="928" y="884"/>
                        </a:lnTo>
                        <a:lnTo>
                          <a:pt x="932" y="884"/>
                        </a:lnTo>
                        <a:lnTo>
                          <a:pt x="936" y="884"/>
                        </a:lnTo>
                        <a:lnTo>
                          <a:pt x="940" y="884"/>
                        </a:lnTo>
                        <a:lnTo>
                          <a:pt x="944" y="884"/>
                        </a:lnTo>
                        <a:lnTo>
                          <a:pt x="948" y="884"/>
                        </a:lnTo>
                        <a:lnTo>
                          <a:pt x="952" y="884"/>
                        </a:lnTo>
                        <a:lnTo>
                          <a:pt x="956" y="884"/>
                        </a:lnTo>
                        <a:lnTo>
                          <a:pt x="960" y="884"/>
                        </a:lnTo>
                        <a:lnTo>
                          <a:pt x="964" y="884"/>
                        </a:lnTo>
                        <a:lnTo>
                          <a:pt x="968" y="884"/>
                        </a:lnTo>
                        <a:lnTo>
                          <a:pt x="972" y="884"/>
                        </a:lnTo>
                        <a:lnTo>
                          <a:pt x="976" y="884"/>
                        </a:lnTo>
                        <a:lnTo>
                          <a:pt x="980" y="884"/>
                        </a:lnTo>
                        <a:lnTo>
                          <a:pt x="984" y="884"/>
                        </a:lnTo>
                        <a:lnTo>
                          <a:pt x="988" y="884"/>
                        </a:lnTo>
                        <a:lnTo>
                          <a:pt x="992" y="884"/>
                        </a:lnTo>
                        <a:lnTo>
                          <a:pt x="996" y="884"/>
                        </a:lnTo>
                        <a:lnTo>
                          <a:pt x="1000" y="884"/>
                        </a:lnTo>
                        <a:lnTo>
                          <a:pt x="1004" y="884"/>
                        </a:lnTo>
                        <a:lnTo>
                          <a:pt x="1008" y="884"/>
                        </a:lnTo>
                        <a:lnTo>
                          <a:pt x="1012" y="884"/>
                        </a:lnTo>
                        <a:lnTo>
                          <a:pt x="1016" y="884"/>
                        </a:lnTo>
                      </a:path>
                    </a:pathLst>
                  </a:cu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grpSp>
            <p:nvGrpSpPr>
              <p:cNvPr id="2458" name="Group 411"/>
              <p:cNvGrpSpPr>
                <a:grpSpLocks noChangeAspect="1"/>
              </p:cNvGrpSpPr>
              <p:nvPr/>
            </p:nvGrpSpPr>
            <p:grpSpPr bwMode="auto">
              <a:xfrm>
                <a:off x="2287786" y="2582323"/>
                <a:ext cx="1599511" cy="1792224"/>
                <a:chOff x="2992" y="432"/>
                <a:chExt cx="1328" cy="1488"/>
              </a:xfrm>
            </p:grpSpPr>
            <p:sp>
              <p:nvSpPr>
                <p:cNvPr id="2459" name="AutoShape 410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2992" y="432"/>
                  <a:ext cx="1328" cy="148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2461" name="Group 498"/>
                <p:cNvGrpSpPr>
                  <a:grpSpLocks/>
                </p:cNvGrpSpPr>
                <p:nvPr/>
              </p:nvGrpSpPr>
              <p:grpSpPr bwMode="auto">
                <a:xfrm>
                  <a:off x="3064" y="444"/>
                  <a:ext cx="1245" cy="1176"/>
                  <a:chOff x="3064" y="444"/>
                  <a:chExt cx="1245" cy="1176"/>
                </a:xfrm>
              </p:grpSpPr>
              <p:grpSp>
                <p:nvGrpSpPr>
                  <p:cNvPr id="2462" name="Group 496"/>
                  <p:cNvGrpSpPr>
                    <a:grpSpLocks/>
                  </p:cNvGrpSpPr>
                  <p:nvPr/>
                </p:nvGrpSpPr>
                <p:grpSpPr bwMode="auto">
                  <a:xfrm>
                    <a:off x="3064" y="444"/>
                    <a:ext cx="1245" cy="1176"/>
                    <a:chOff x="3064" y="444"/>
                    <a:chExt cx="1245" cy="1176"/>
                  </a:xfrm>
                </p:grpSpPr>
                <p:sp>
                  <p:nvSpPr>
                    <p:cNvPr id="384" name="Rectangle 41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02" y="478"/>
                      <a:ext cx="1032" cy="1032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6350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385" name="Group 463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184" y="1508"/>
                      <a:ext cx="1125" cy="112"/>
                      <a:chOff x="3184" y="1508"/>
                      <a:chExt cx="1125" cy="112"/>
                    </a:xfrm>
                  </p:grpSpPr>
                  <p:sp>
                    <p:nvSpPr>
                      <p:cNvPr id="2467" name="Line 41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200" y="1508"/>
                        <a:ext cx="1032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2468" name="Group 455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3200" y="1512"/>
                        <a:ext cx="1032" cy="24"/>
                        <a:chOff x="3200" y="1512"/>
                        <a:chExt cx="1032" cy="24"/>
                      </a:xfrm>
                    </p:grpSpPr>
                    <p:sp>
                      <p:nvSpPr>
                        <p:cNvPr id="2476" name="Line 41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00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77" name="Line 41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27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78" name="Line 42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32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79" name="Line 42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35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0" name="Line 42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380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1" name="Line 42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0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2" name="Line 42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1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3" name="Line 42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3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4" name="Line 42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4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5" name="Line 42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456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6" name="Line 42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3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7" name="Line 42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58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8" name="Line 43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1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89" name="Line 43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36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0" name="Line 43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6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1" name="Line 43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7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2" name="Line 43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69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3" name="Line 43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70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4" name="Line 43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716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5" name="Line 43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79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6" name="Line 43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4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7" name="Line 43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7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8" name="Line 44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896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99" name="Line 44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91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0" name="Line 44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93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1" name="Line 44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94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2" name="Line 44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964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3" name="Line 4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3976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4" name="Line 4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05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5" name="Line 4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10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6" name="Line 4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13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7" name="Line 4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156" y="1512"/>
                          <a:ext cx="0" cy="16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8" name="Line 45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176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09" name="Line 45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192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0" name="Line 45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208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1" name="Line 45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220" y="1512"/>
                          <a:ext cx="0" cy="8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2" name="Line 45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4232" y="1512"/>
                          <a:ext cx="0" cy="24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  <p:grpSp>
                    <p:nvGrpSpPr>
                      <p:cNvPr id="2469" name="Group 461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3184" y="1552"/>
                        <a:ext cx="1125" cy="68"/>
                        <a:chOff x="3184" y="1552"/>
                        <a:chExt cx="1125" cy="68"/>
                      </a:xfrm>
                    </p:grpSpPr>
                    <p:sp>
                      <p:nvSpPr>
                        <p:cNvPr id="2471" name="Rectangle 456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84" y="1552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72" name="Rectangle 457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424" y="1552"/>
                          <a:ext cx="63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73" name="Rectangle 458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668" y="155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74" name="Rectangle 45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912" y="1552"/>
                          <a:ext cx="125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75" name="Rectangle 46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4152" y="1552"/>
                          <a:ext cx="157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386" name="Group 49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064" y="444"/>
                      <a:ext cx="136" cy="1104"/>
                      <a:chOff x="3064" y="444"/>
                      <a:chExt cx="136" cy="1104"/>
                    </a:xfrm>
                  </p:grpSpPr>
                  <p:sp>
                    <p:nvSpPr>
                      <p:cNvPr id="387" name="Line 464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200" y="476"/>
                        <a:ext cx="0" cy="1032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388" name="Group 471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3064" y="444"/>
                        <a:ext cx="95" cy="1104"/>
                        <a:chOff x="3064" y="444"/>
                        <a:chExt cx="95" cy="1104"/>
                      </a:xfrm>
                    </p:grpSpPr>
                    <p:sp>
                      <p:nvSpPr>
                        <p:cNvPr id="413" name="Rectangle 46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128" y="1480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14" name="Rectangle 466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64" y="1276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15" name="Rectangle 467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64" y="1068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2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64" name="Rectangle 468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64" y="860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3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65" name="Rectangle 469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64" y="65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4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466" name="Rectangle 470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3064" y="444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500</a:t>
                          </a:r>
                          <a:endParaRPr kumimoji="0" lang="en-US" altLang="en-US" sz="18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389" name="Group 493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3176" y="472"/>
                        <a:ext cx="24" cy="1036"/>
                        <a:chOff x="3176" y="472"/>
                        <a:chExt cx="24" cy="1036"/>
                      </a:xfrm>
                    </p:grpSpPr>
                    <p:sp>
                      <p:nvSpPr>
                        <p:cNvPr id="391" name="Line 47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1508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2" name="Line 47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46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3" name="Line 47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40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4" name="Line 47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35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5" name="Line 47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1304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6" name="Line 47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25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7" name="Line 47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20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8" name="Line 47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14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99" name="Line 48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1096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0" name="Line 48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104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1" name="Line 48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99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2" name="Line 48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940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3" name="Line 48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888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4" name="Line 48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83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5" name="Line 48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78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6" name="Line 48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732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7" name="Line 48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680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8" name="Line 48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628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09" name="Line 49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576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11" name="Line 49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92" y="524"/>
                          <a:ext cx="8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12" name="Line 49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3176" y="472"/>
                          <a:ext cx="24" cy="0"/>
                        </a:xfrm>
                        <a:prstGeom prst="line">
                          <a:avLst/>
                        </a:prstGeom>
                        <a:noFill/>
                        <a:ln w="6350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</p:grpSp>
              </p:grpSp>
              <p:sp>
                <p:nvSpPr>
                  <p:cNvPr id="2463" name="Freeform 497"/>
                  <p:cNvSpPr>
                    <a:spLocks/>
                  </p:cNvSpPr>
                  <p:nvPr/>
                </p:nvSpPr>
                <p:spPr bwMode="auto">
                  <a:xfrm>
                    <a:off x="3208" y="620"/>
                    <a:ext cx="1016" cy="884"/>
                  </a:xfrm>
                  <a:custGeom>
                    <a:avLst/>
                    <a:gdLst>
                      <a:gd name="T0" fmla="*/ 12 w 1016"/>
                      <a:gd name="T1" fmla="*/ 884 h 884"/>
                      <a:gd name="T2" fmla="*/ 28 w 1016"/>
                      <a:gd name="T3" fmla="*/ 884 h 884"/>
                      <a:gd name="T4" fmla="*/ 44 w 1016"/>
                      <a:gd name="T5" fmla="*/ 880 h 884"/>
                      <a:gd name="T6" fmla="*/ 60 w 1016"/>
                      <a:gd name="T7" fmla="*/ 868 h 884"/>
                      <a:gd name="T8" fmla="*/ 76 w 1016"/>
                      <a:gd name="T9" fmla="*/ 832 h 884"/>
                      <a:gd name="T10" fmla="*/ 92 w 1016"/>
                      <a:gd name="T11" fmla="*/ 760 h 884"/>
                      <a:gd name="T12" fmla="*/ 108 w 1016"/>
                      <a:gd name="T13" fmla="*/ 556 h 884"/>
                      <a:gd name="T14" fmla="*/ 124 w 1016"/>
                      <a:gd name="T15" fmla="*/ 348 h 884"/>
                      <a:gd name="T16" fmla="*/ 140 w 1016"/>
                      <a:gd name="T17" fmla="*/ 80 h 884"/>
                      <a:gd name="T18" fmla="*/ 156 w 1016"/>
                      <a:gd name="T19" fmla="*/ 8 h 884"/>
                      <a:gd name="T20" fmla="*/ 172 w 1016"/>
                      <a:gd name="T21" fmla="*/ 24 h 884"/>
                      <a:gd name="T22" fmla="*/ 188 w 1016"/>
                      <a:gd name="T23" fmla="*/ 184 h 884"/>
                      <a:gd name="T24" fmla="*/ 204 w 1016"/>
                      <a:gd name="T25" fmla="*/ 400 h 884"/>
                      <a:gd name="T26" fmla="*/ 220 w 1016"/>
                      <a:gd name="T27" fmla="*/ 716 h 884"/>
                      <a:gd name="T28" fmla="*/ 236 w 1016"/>
                      <a:gd name="T29" fmla="*/ 824 h 884"/>
                      <a:gd name="T30" fmla="*/ 252 w 1016"/>
                      <a:gd name="T31" fmla="*/ 848 h 884"/>
                      <a:gd name="T32" fmla="*/ 268 w 1016"/>
                      <a:gd name="T33" fmla="*/ 868 h 884"/>
                      <a:gd name="T34" fmla="*/ 284 w 1016"/>
                      <a:gd name="T35" fmla="*/ 880 h 884"/>
                      <a:gd name="T36" fmla="*/ 300 w 1016"/>
                      <a:gd name="T37" fmla="*/ 884 h 884"/>
                      <a:gd name="T38" fmla="*/ 316 w 1016"/>
                      <a:gd name="T39" fmla="*/ 884 h 884"/>
                      <a:gd name="T40" fmla="*/ 332 w 1016"/>
                      <a:gd name="T41" fmla="*/ 884 h 884"/>
                      <a:gd name="T42" fmla="*/ 348 w 1016"/>
                      <a:gd name="T43" fmla="*/ 884 h 884"/>
                      <a:gd name="T44" fmla="*/ 364 w 1016"/>
                      <a:gd name="T45" fmla="*/ 884 h 884"/>
                      <a:gd name="T46" fmla="*/ 380 w 1016"/>
                      <a:gd name="T47" fmla="*/ 884 h 884"/>
                      <a:gd name="T48" fmla="*/ 396 w 1016"/>
                      <a:gd name="T49" fmla="*/ 884 h 884"/>
                      <a:gd name="T50" fmla="*/ 412 w 1016"/>
                      <a:gd name="T51" fmla="*/ 884 h 884"/>
                      <a:gd name="T52" fmla="*/ 428 w 1016"/>
                      <a:gd name="T53" fmla="*/ 884 h 884"/>
                      <a:gd name="T54" fmla="*/ 444 w 1016"/>
                      <a:gd name="T55" fmla="*/ 884 h 884"/>
                      <a:gd name="T56" fmla="*/ 460 w 1016"/>
                      <a:gd name="T57" fmla="*/ 884 h 884"/>
                      <a:gd name="T58" fmla="*/ 476 w 1016"/>
                      <a:gd name="T59" fmla="*/ 884 h 884"/>
                      <a:gd name="T60" fmla="*/ 492 w 1016"/>
                      <a:gd name="T61" fmla="*/ 884 h 884"/>
                      <a:gd name="T62" fmla="*/ 508 w 1016"/>
                      <a:gd name="T63" fmla="*/ 884 h 884"/>
                      <a:gd name="T64" fmla="*/ 524 w 1016"/>
                      <a:gd name="T65" fmla="*/ 884 h 884"/>
                      <a:gd name="T66" fmla="*/ 540 w 1016"/>
                      <a:gd name="T67" fmla="*/ 884 h 884"/>
                      <a:gd name="T68" fmla="*/ 556 w 1016"/>
                      <a:gd name="T69" fmla="*/ 884 h 884"/>
                      <a:gd name="T70" fmla="*/ 572 w 1016"/>
                      <a:gd name="T71" fmla="*/ 884 h 884"/>
                      <a:gd name="T72" fmla="*/ 588 w 1016"/>
                      <a:gd name="T73" fmla="*/ 884 h 884"/>
                      <a:gd name="T74" fmla="*/ 604 w 1016"/>
                      <a:gd name="T75" fmla="*/ 884 h 884"/>
                      <a:gd name="T76" fmla="*/ 620 w 1016"/>
                      <a:gd name="T77" fmla="*/ 884 h 884"/>
                      <a:gd name="T78" fmla="*/ 636 w 1016"/>
                      <a:gd name="T79" fmla="*/ 884 h 884"/>
                      <a:gd name="T80" fmla="*/ 652 w 1016"/>
                      <a:gd name="T81" fmla="*/ 884 h 884"/>
                      <a:gd name="T82" fmla="*/ 668 w 1016"/>
                      <a:gd name="T83" fmla="*/ 884 h 884"/>
                      <a:gd name="T84" fmla="*/ 684 w 1016"/>
                      <a:gd name="T85" fmla="*/ 884 h 884"/>
                      <a:gd name="T86" fmla="*/ 700 w 1016"/>
                      <a:gd name="T87" fmla="*/ 884 h 884"/>
                      <a:gd name="T88" fmla="*/ 716 w 1016"/>
                      <a:gd name="T89" fmla="*/ 884 h 884"/>
                      <a:gd name="T90" fmla="*/ 732 w 1016"/>
                      <a:gd name="T91" fmla="*/ 884 h 884"/>
                      <a:gd name="T92" fmla="*/ 748 w 1016"/>
                      <a:gd name="T93" fmla="*/ 884 h 884"/>
                      <a:gd name="T94" fmla="*/ 764 w 1016"/>
                      <a:gd name="T95" fmla="*/ 884 h 884"/>
                      <a:gd name="T96" fmla="*/ 780 w 1016"/>
                      <a:gd name="T97" fmla="*/ 884 h 884"/>
                      <a:gd name="T98" fmla="*/ 796 w 1016"/>
                      <a:gd name="T99" fmla="*/ 884 h 884"/>
                      <a:gd name="T100" fmla="*/ 812 w 1016"/>
                      <a:gd name="T101" fmla="*/ 884 h 884"/>
                      <a:gd name="T102" fmla="*/ 828 w 1016"/>
                      <a:gd name="T103" fmla="*/ 884 h 884"/>
                      <a:gd name="T104" fmla="*/ 844 w 1016"/>
                      <a:gd name="T105" fmla="*/ 884 h 884"/>
                      <a:gd name="T106" fmla="*/ 860 w 1016"/>
                      <a:gd name="T107" fmla="*/ 884 h 884"/>
                      <a:gd name="T108" fmla="*/ 876 w 1016"/>
                      <a:gd name="T109" fmla="*/ 884 h 884"/>
                      <a:gd name="T110" fmla="*/ 892 w 1016"/>
                      <a:gd name="T111" fmla="*/ 884 h 884"/>
                      <a:gd name="T112" fmla="*/ 908 w 1016"/>
                      <a:gd name="T113" fmla="*/ 884 h 884"/>
                      <a:gd name="T114" fmla="*/ 924 w 1016"/>
                      <a:gd name="T115" fmla="*/ 884 h 884"/>
                      <a:gd name="T116" fmla="*/ 940 w 1016"/>
                      <a:gd name="T117" fmla="*/ 884 h 884"/>
                      <a:gd name="T118" fmla="*/ 956 w 1016"/>
                      <a:gd name="T119" fmla="*/ 884 h 884"/>
                      <a:gd name="T120" fmla="*/ 972 w 1016"/>
                      <a:gd name="T121" fmla="*/ 884 h 884"/>
                      <a:gd name="T122" fmla="*/ 988 w 1016"/>
                      <a:gd name="T123" fmla="*/ 884 h 884"/>
                      <a:gd name="T124" fmla="*/ 1004 w 1016"/>
                      <a:gd name="T125" fmla="*/ 884 h 884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  <a:cxn ang="0">
                        <a:pos x="T110" y="T111"/>
                      </a:cxn>
                      <a:cxn ang="0">
                        <a:pos x="T112" y="T113"/>
                      </a:cxn>
                      <a:cxn ang="0">
                        <a:pos x="T114" y="T115"/>
                      </a:cxn>
                      <a:cxn ang="0">
                        <a:pos x="T116" y="T117"/>
                      </a:cxn>
                      <a:cxn ang="0">
                        <a:pos x="T118" y="T119"/>
                      </a:cxn>
                      <a:cxn ang="0">
                        <a:pos x="T120" y="T121"/>
                      </a:cxn>
                      <a:cxn ang="0">
                        <a:pos x="T122" y="T123"/>
                      </a:cxn>
                      <a:cxn ang="0">
                        <a:pos x="T124" y="T125"/>
                      </a:cxn>
                    </a:cxnLst>
                    <a:rect l="0" t="0" r="r" b="b"/>
                    <a:pathLst>
                      <a:path w="1016" h="884">
                        <a:moveTo>
                          <a:pt x="0" y="884"/>
                        </a:moveTo>
                        <a:lnTo>
                          <a:pt x="4" y="884"/>
                        </a:lnTo>
                        <a:lnTo>
                          <a:pt x="8" y="884"/>
                        </a:lnTo>
                        <a:lnTo>
                          <a:pt x="12" y="884"/>
                        </a:lnTo>
                        <a:lnTo>
                          <a:pt x="16" y="884"/>
                        </a:lnTo>
                        <a:lnTo>
                          <a:pt x="20" y="884"/>
                        </a:lnTo>
                        <a:lnTo>
                          <a:pt x="24" y="884"/>
                        </a:lnTo>
                        <a:lnTo>
                          <a:pt x="28" y="884"/>
                        </a:lnTo>
                        <a:lnTo>
                          <a:pt x="32" y="884"/>
                        </a:lnTo>
                        <a:lnTo>
                          <a:pt x="36" y="880"/>
                        </a:lnTo>
                        <a:lnTo>
                          <a:pt x="40" y="880"/>
                        </a:lnTo>
                        <a:lnTo>
                          <a:pt x="44" y="880"/>
                        </a:lnTo>
                        <a:lnTo>
                          <a:pt x="48" y="876"/>
                        </a:lnTo>
                        <a:lnTo>
                          <a:pt x="52" y="876"/>
                        </a:lnTo>
                        <a:lnTo>
                          <a:pt x="56" y="872"/>
                        </a:lnTo>
                        <a:lnTo>
                          <a:pt x="60" y="868"/>
                        </a:lnTo>
                        <a:lnTo>
                          <a:pt x="64" y="864"/>
                        </a:lnTo>
                        <a:lnTo>
                          <a:pt x="68" y="852"/>
                        </a:lnTo>
                        <a:lnTo>
                          <a:pt x="72" y="844"/>
                        </a:lnTo>
                        <a:lnTo>
                          <a:pt x="76" y="832"/>
                        </a:lnTo>
                        <a:lnTo>
                          <a:pt x="80" y="820"/>
                        </a:lnTo>
                        <a:lnTo>
                          <a:pt x="84" y="804"/>
                        </a:lnTo>
                        <a:lnTo>
                          <a:pt x="88" y="784"/>
                        </a:lnTo>
                        <a:lnTo>
                          <a:pt x="92" y="760"/>
                        </a:lnTo>
                        <a:lnTo>
                          <a:pt x="96" y="728"/>
                        </a:lnTo>
                        <a:lnTo>
                          <a:pt x="100" y="676"/>
                        </a:lnTo>
                        <a:lnTo>
                          <a:pt x="104" y="616"/>
                        </a:lnTo>
                        <a:lnTo>
                          <a:pt x="108" y="556"/>
                        </a:lnTo>
                        <a:lnTo>
                          <a:pt x="112" y="476"/>
                        </a:lnTo>
                        <a:lnTo>
                          <a:pt x="116" y="392"/>
                        </a:lnTo>
                        <a:lnTo>
                          <a:pt x="120" y="352"/>
                        </a:lnTo>
                        <a:lnTo>
                          <a:pt x="124" y="348"/>
                        </a:lnTo>
                        <a:lnTo>
                          <a:pt x="128" y="284"/>
                        </a:lnTo>
                        <a:lnTo>
                          <a:pt x="132" y="196"/>
                        </a:lnTo>
                        <a:lnTo>
                          <a:pt x="136" y="132"/>
                        </a:lnTo>
                        <a:lnTo>
                          <a:pt x="140" y="80"/>
                        </a:lnTo>
                        <a:lnTo>
                          <a:pt x="144" y="44"/>
                        </a:lnTo>
                        <a:lnTo>
                          <a:pt x="148" y="12"/>
                        </a:lnTo>
                        <a:lnTo>
                          <a:pt x="152" y="4"/>
                        </a:lnTo>
                        <a:lnTo>
                          <a:pt x="156" y="8"/>
                        </a:lnTo>
                        <a:lnTo>
                          <a:pt x="160" y="8"/>
                        </a:lnTo>
                        <a:lnTo>
                          <a:pt x="164" y="0"/>
                        </a:lnTo>
                        <a:lnTo>
                          <a:pt x="168" y="8"/>
                        </a:lnTo>
                        <a:lnTo>
                          <a:pt x="172" y="24"/>
                        </a:lnTo>
                        <a:lnTo>
                          <a:pt x="176" y="64"/>
                        </a:lnTo>
                        <a:lnTo>
                          <a:pt x="180" y="100"/>
                        </a:lnTo>
                        <a:lnTo>
                          <a:pt x="184" y="128"/>
                        </a:lnTo>
                        <a:lnTo>
                          <a:pt x="188" y="184"/>
                        </a:lnTo>
                        <a:lnTo>
                          <a:pt x="192" y="280"/>
                        </a:lnTo>
                        <a:lnTo>
                          <a:pt x="196" y="352"/>
                        </a:lnTo>
                        <a:lnTo>
                          <a:pt x="200" y="352"/>
                        </a:lnTo>
                        <a:lnTo>
                          <a:pt x="204" y="400"/>
                        </a:lnTo>
                        <a:lnTo>
                          <a:pt x="208" y="516"/>
                        </a:lnTo>
                        <a:lnTo>
                          <a:pt x="212" y="620"/>
                        </a:lnTo>
                        <a:lnTo>
                          <a:pt x="216" y="684"/>
                        </a:lnTo>
                        <a:lnTo>
                          <a:pt x="220" y="716"/>
                        </a:lnTo>
                        <a:lnTo>
                          <a:pt x="224" y="744"/>
                        </a:lnTo>
                        <a:lnTo>
                          <a:pt x="228" y="780"/>
                        </a:lnTo>
                        <a:lnTo>
                          <a:pt x="232" y="808"/>
                        </a:lnTo>
                        <a:lnTo>
                          <a:pt x="236" y="824"/>
                        </a:lnTo>
                        <a:lnTo>
                          <a:pt x="240" y="828"/>
                        </a:lnTo>
                        <a:lnTo>
                          <a:pt x="244" y="836"/>
                        </a:lnTo>
                        <a:lnTo>
                          <a:pt x="248" y="840"/>
                        </a:lnTo>
                        <a:lnTo>
                          <a:pt x="252" y="848"/>
                        </a:lnTo>
                        <a:lnTo>
                          <a:pt x="256" y="852"/>
                        </a:lnTo>
                        <a:lnTo>
                          <a:pt x="260" y="856"/>
                        </a:lnTo>
                        <a:lnTo>
                          <a:pt x="264" y="864"/>
                        </a:lnTo>
                        <a:lnTo>
                          <a:pt x="268" y="868"/>
                        </a:lnTo>
                        <a:lnTo>
                          <a:pt x="272" y="872"/>
                        </a:lnTo>
                        <a:lnTo>
                          <a:pt x="276" y="876"/>
                        </a:lnTo>
                        <a:lnTo>
                          <a:pt x="280" y="876"/>
                        </a:lnTo>
                        <a:lnTo>
                          <a:pt x="284" y="880"/>
                        </a:lnTo>
                        <a:lnTo>
                          <a:pt x="288" y="880"/>
                        </a:lnTo>
                        <a:lnTo>
                          <a:pt x="292" y="880"/>
                        </a:lnTo>
                        <a:lnTo>
                          <a:pt x="296" y="880"/>
                        </a:lnTo>
                        <a:lnTo>
                          <a:pt x="300" y="884"/>
                        </a:lnTo>
                        <a:lnTo>
                          <a:pt x="304" y="884"/>
                        </a:lnTo>
                        <a:lnTo>
                          <a:pt x="308" y="884"/>
                        </a:lnTo>
                        <a:lnTo>
                          <a:pt x="312" y="884"/>
                        </a:lnTo>
                        <a:lnTo>
                          <a:pt x="316" y="884"/>
                        </a:lnTo>
                        <a:lnTo>
                          <a:pt x="320" y="884"/>
                        </a:lnTo>
                        <a:lnTo>
                          <a:pt x="324" y="884"/>
                        </a:lnTo>
                        <a:lnTo>
                          <a:pt x="328" y="884"/>
                        </a:lnTo>
                        <a:lnTo>
                          <a:pt x="332" y="884"/>
                        </a:lnTo>
                        <a:lnTo>
                          <a:pt x="336" y="884"/>
                        </a:lnTo>
                        <a:lnTo>
                          <a:pt x="340" y="884"/>
                        </a:lnTo>
                        <a:lnTo>
                          <a:pt x="344" y="884"/>
                        </a:lnTo>
                        <a:lnTo>
                          <a:pt x="348" y="884"/>
                        </a:lnTo>
                        <a:lnTo>
                          <a:pt x="352" y="884"/>
                        </a:lnTo>
                        <a:lnTo>
                          <a:pt x="356" y="884"/>
                        </a:lnTo>
                        <a:lnTo>
                          <a:pt x="360" y="884"/>
                        </a:lnTo>
                        <a:lnTo>
                          <a:pt x="364" y="884"/>
                        </a:lnTo>
                        <a:lnTo>
                          <a:pt x="368" y="884"/>
                        </a:lnTo>
                        <a:lnTo>
                          <a:pt x="372" y="884"/>
                        </a:lnTo>
                        <a:lnTo>
                          <a:pt x="376" y="884"/>
                        </a:lnTo>
                        <a:lnTo>
                          <a:pt x="380" y="884"/>
                        </a:lnTo>
                        <a:lnTo>
                          <a:pt x="384" y="884"/>
                        </a:lnTo>
                        <a:lnTo>
                          <a:pt x="388" y="884"/>
                        </a:lnTo>
                        <a:lnTo>
                          <a:pt x="392" y="884"/>
                        </a:lnTo>
                        <a:lnTo>
                          <a:pt x="396" y="884"/>
                        </a:lnTo>
                        <a:lnTo>
                          <a:pt x="400" y="884"/>
                        </a:lnTo>
                        <a:lnTo>
                          <a:pt x="404" y="884"/>
                        </a:lnTo>
                        <a:lnTo>
                          <a:pt x="408" y="884"/>
                        </a:lnTo>
                        <a:lnTo>
                          <a:pt x="412" y="884"/>
                        </a:lnTo>
                        <a:lnTo>
                          <a:pt x="416" y="884"/>
                        </a:lnTo>
                        <a:lnTo>
                          <a:pt x="420" y="884"/>
                        </a:lnTo>
                        <a:lnTo>
                          <a:pt x="424" y="884"/>
                        </a:lnTo>
                        <a:lnTo>
                          <a:pt x="428" y="884"/>
                        </a:lnTo>
                        <a:lnTo>
                          <a:pt x="432" y="884"/>
                        </a:lnTo>
                        <a:lnTo>
                          <a:pt x="436" y="884"/>
                        </a:lnTo>
                        <a:lnTo>
                          <a:pt x="440" y="884"/>
                        </a:lnTo>
                        <a:lnTo>
                          <a:pt x="444" y="884"/>
                        </a:lnTo>
                        <a:lnTo>
                          <a:pt x="448" y="884"/>
                        </a:lnTo>
                        <a:lnTo>
                          <a:pt x="452" y="884"/>
                        </a:lnTo>
                        <a:lnTo>
                          <a:pt x="456" y="884"/>
                        </a:lnTo>
                        <a:lnTo>
                          <a:pt x="460" y="884"/>
                        </a:lnTo>
                        <a:lnTo>
                          <a:pt x="464" y="884"/>
                        </a:lnTo>
                        <a:lnTo>
                          <a:pt x="468" y="884"/>
                        </a:lnTo>
                        <a:lnTo>
                          <a:pt x="472" y="884"/>
                        </a:lnTo>
                        <a:lnTo>
                          <a:pt x="476" y="884"/>
                        </a:lnTo>
                        <a:lnTo>
                          <a:pt x="480" y="884"/>
                        </a:lnTo>
                        <a:lnTo>
                          <a:pt x="484" y="884"/>
                        </a:lnTo>
                        <a:lnTo>
                          <a:pt x="488" y="884"/>
                        </a:lnTo>
                        <a:lnTo>
                          <a:pt x="492" y="884"/>
                        </a:lnTo>
                        <a:lnTo>
                          <a:pt x="496" y="884"/>
                        </a:lnTo>
                        <a:lnTo>
                          <a:pt x="500" y="884"/>
                        </a:lnTo>
                        <a:lnTo>
                          <a:pt x="504" y="884"/>
                        </a:lnTo>
                        <a:lnTo>
                          <a:pt x="508" y="884"/>
                        </a:lnTo>
                        <a:lnTo>
                          <a:pt x="512" y="884"/>
                        </a:lnTo>
                        <a:lnTo>
                          <a:pt x="516" y="884"/>
                        </a:lnTo>
                        <a:lnTo>
                          <a:pt x="520" y="884"/>
                        </a:lnTo>
                        <a:lnTo>
                          <a:pt x="524" y="884"/>
                        </a:lnTo>
                        <a:lnTo>
                          <a:pt x="528" y="884"/>
                        </a:lnTo>
                        <a:lnTo>
                          <a:pt x="532" y="884"/>
                        </a:lnTo>
                        <a:lnTo>
                          <a:pt x="536" y="884"/>
                        </a:lnTo>
                        <a:lnTo>
                          <a:pt x="540" y="884"/>
                        </a:lnTo>
                        <a:lnTo>
                          <a:pt x="544" y="884"/>
                        </a:lnTo>
                        <a:lnTo>
                          <a:pt x="548" y="884"/>
                        </a:lnTo>
                        <a:lnTo>
                          <a:pt x="552" y="884"/>
                        </a:lnTo>
                        <a:lnTo>
                          <a:pt x="556" y="884"/>
                        </a:lnTo>
                        <a:lnTo>
                          <a:pt x="560" y="884"/>
                        </a:lnTo>
                        <a:lnTo>
                          <a:pt x="564" y="884"/>
                        </a:lnTo>
                        <a:lnTo>
                          <a:pt x="568" y="884"/>
                        </a:lnTo>
                        <a:lnTo>
                          <a:pt x="572" y="884"/>
                        </a:lnTo>
                        <a:lnTo>
                          <a:pt x="576" y="884"/>
                        </a:lnTo>
                        <a:lnTo>
                          <a:pt x="580" y="884"/>
                        </a:lnTo>
                        <a:lnTo>
                          <a:pt x="584" y="884"/>
                        </a:lnTo>
                        <a:lnTo>
                          <a:pt x="588" y="884"/>
                        </a:lnTo>
                        <a:lnTo>
                          <a:pt x="592" y="884"/>
                        </a:lnTo>
                        <a:lnTo>
                          <a:pt x="596" y="884"/>
                        </a:lnTo>
                        <a:lnTo>
                          <a:pt x="600" y="884"/>
                        </a:lnTo>
                        <a:lnTo>
                          <a:pt x="604" y="884"/>
                        </a:lnTo>
                        <a:lnTo>
                          <a:pt x="608" y="884"/>
                        </a:lnTo>
                        <a:lnTo>
                          <a:pt x="612" y="884"/>
                        </a:lnTo>
                        <a:lnTo>
                          <a:pt x="616" y="884"/>
                        </a:lnTo>
                        <a:lnTo>
                          <a:pt x="620" y="884"/>
                        </a:lnTo>
                        <a:lnTo>
                          <a:pt x="624" y="884"/>
                        </a:lnTo>
                        <a:lnTo>
                          <a:pt x="628" y="884"/>
                        </a:lnTo>
                        <a:lnTo>
                          <a:pt x="632" y="884"/>
                        </a:lnTo>
                        <a:lnTo>
                          <a:pt x="636" y="884"/>
                        </a:lnTo>
                        <a:lnTo>
                          <a:pt x="640" y="884"/>
                        </a:lnTo>
                        <a:lnTo>
                          <a:pt x="644" y="884"/>
                        </a:lnTo>
                        <a:lnTo>
                          <a:pt x="648" y="884"/>
                        </a:lnTo>
                        <a:lnTo>
                          <a:pt x="652" y="884"/>
                        </a:lnTo>
                        <a:lnTo>
                          <a:pt x="656" y="884"/>
                        </a:lnTo>
                        <a:lnTo>
                          <a:pt x="660" y="884"/>
                        </a:lnTo>
                        <a:lnTo>
                          <a:pt x="664" y="884"/>
                        </a:lnTo>
                        <a:lnTo>
                          <a:pt x="668" y="884"/>
                        </a:lnTo>
                        <a:lnTo>
                          <a:pt x="672" y="884"/>
                        </a:lnTo>
                        <a:lnTo>
                          <a:pt x="676" y="884"/>
                        </a:lnTo>
                        <a:lnTo>
                          <a:pt x="680" y="884"/>
                        </a:lnTo>
                        <a:lnTo>
                          <a:pt x="684" y="884"/>
                        </a:lnTo>
                        <a:lnTo>
                          <a:pt x="688" y="884"/>
                        </a:lnTo>
                        <a:lnTo>
                          <a:pt x="692" y="884"/>
                        </a:lnTo>
                        <a:lnTo>
                          <a:pt x="696" y="884"/>
                        </a:lnTo>
                        <a:lnTo>
                          <a:pt x="700" y="884"/>
                        </a:lnTo>
                        <a:lnTo>
                          <a:pt x="704" y="884"/>
                        </a:lnTo>
                        <a:lnTo>
                          <a:pt x="708" y="884"/>
                        </a:lnTo>
                        <a:lnTo>
                          <a:pt x="712" y="884"/>
                        </a:lnTo>
                        <a:lnTo>
                          <a:pt x="716" y="884"/>
                        </a:lnTo>
                        <a:lnTo>
                          <a:pt x="720" y="884"/>
                        </a:lnTo>
                        <a:lnTo>
                          <a:pt x="724" y="884"/>
                        </a:lnTo>
                        <a:lnTo>
                          <a:pt x="728" y="884"/>
                        </a:lnTo>
                        <a:lnTo>
                          <a:pt x="732" y="884"/>
                        </a:lnTo>
                        <a:lnTo>
                          <a:pt x="736" y="884"/>
                        </a:lnTo>
                        <a:lnTo>
                          <a:pt x="740" y="884"/>
                        </a:lnTo>
                        <a:lnTo>
                          <a:pt x="744" y="884"/>
                        </a:lnTo>
                        <a:lnTo>
                          <a:pt x="748" y="884"/>
                        </a:lnTo>
                        <a:lnTo>
                          <a:pt x="752" y="884"/>
                        </a:lnTo>
                        <a:lnTo>
                          <a:pt x="756" y="884"/>
                        </a:lnTo>
                        <a:lnTo>
                          <a:pt x="760" y="884"/>
                        </a:lnTo>
                        <a:lnTo>
                          <a:pt x="764" y="884"/>
                        </a:lnTo>
                        <a:lnTo>
                          <a:pt x="768" y="884"/>
                        </a:lnTo>
                        <a:lnTo>
                          <a:pt x="772" y="884"/>
                        </a:lnTo>
                        <a:lnTo>
                          <a:pt x="776" y="884"/>
                        </a:lnTo>
                        <a:lnTo>
                          <a:pt x="780" y="884"/>
                        </a:lnTo>
                        <a:lnTo>
                          <a:pt x="784" y="884"/>
                        </a:lnTo>
                        <a:lnTo>
                          <a:pt x="788" y="884"/>
                        </a:lnTo>
                        <a:lnTo>
                          <a:pt x="792" y="884"/>
                        </a:lnTo>
                        <a:lnTo>
                          <a:pt x="796" y="884"/>
                        </a:lnTo>
                        <a:lnTo>
                          <a:pt x="800" y="884"/>
                        </a:lnTo>
                        <a:lnTo>
                          <a:pt x="804" y="884"/>
                        </a:lnTo>
                        <a:lnTo>
                          <a:pt x="808" y="884"/>
                        </a:lnTo>
                        <a:lnTo>
                          <a:pt x="812" y="884"/>
                        </a:lnTo>
                        <a:lnTo>
                          <a:pt x="816" y="884"/>
                        </a:lnTo>
                        <a:lnTo>
                          <a:pt x="820" y="884"/>
                        </a:lnTo>
                        <a:lnTo>
                          <a:pt x="824" y="884"/>
                        </a:lnTo>
                        <a:lnTo>
                          <a:pt x="828" y="884"/>
                        </a:lnTo>
                        <a:lnTo>
                          <a:pt x="832" y="884"/>
                        </a:lnTo>
                        <a:lnTo>
                          <a:pt x="836" y="884"/>
                        </a:lnTo>
                        <a:lnTo>
                          <a:pt x="840" y="884"/>
                        </a:lnTo>
                        <a:lnTo>
                          <a:pt x="844" y="884"/>
                        </a:lnTo>
                        <a:lnTo>
                          <a:pt x="848" y="884"/>
                        </a:lnTo>
                        <a:lnTo>
                          <a:pt x="852" y="884"/>
                        </a:lnTo>
                        <a:lnTo>
                          <a:pt x="856" y="884"/>
                        </a:lnTo>
                        <a:lnTo>
                          <a:pt x="860" y="884"/>
                        </a:lnTo>
                        <a:lnTo>
                          <a:pt x="864" y="884"/>
                        </a:lnTo>
                        <a:lnTo>
                          <a:pt x="868" y="884"/>
                        </a:lnTo>
                        <a:lnTo>
                          <a:pt x="872" y="884"/>
                        </a:lnTo>
                        <a:lnTo>
                          <a:pt x="876" y="884"/>
                        </a:lnTo>
                        <a:lnTo>
                          <a:pt x="880" y="884"/>
                        </a:lnTo>
                        <a:lnTo>
                          <a:pt x="884" y="884"/>
                        </a:lnTo>
                        <a:lnTo>
                          <a:pt x="888" y="884"/>
                        </a:lnTo>
                        <a:lnTo>
                          <a:pt x="892" y="884"/>
                        </a:lnTo>
                        <a:lnTo>
                          <a:pt x="896" y="884"/>
                        </a:lnTo>
                        <a:lnTo>
                          <a:pt x="900" y="884"/>
                        </a:lnTo>
                        <a:lnTo>
                          <a:pt x="904" y="884"/>
                        </a:lnTo>
                        <a:lnTo>
                          <a:pt x="908" y="884"/>
                        </a:lnTo>
                        <a:lnTo>
                          <a:pt x="912" y="884"/>
                        </a:lnTo>
                        <a:lnTo>
                          <a:pt x="916" y="884"/>
                        </a:lnTo>
                        <a:lnTo>
                          <a:pt x="920" y="884"/>
                        </a:lnTo>
                        <a:lnTo>
                          <a:pt x="924" y="884"/>
                        </a:lnTo>
                        <a:lnTo>
                          <a:pt x="928" y="884"/>
                        </a:lnTo>
                        <a:lnTo>
                          <a:pt x="932" y="884"/>
                        </a:lnTo>
                        <a:lnTo>
                          <a:pt x="936" y="884"/>
                        </a:lnTo>
                        <a:lnTo>
                          <a:pt x="940" y="884"/>
                        </a:lnTo>
                        <a:lnTo>
                          <a:pt x="944" y="884"/>
                        </a:lnTo>
                        <a:lnTo>
                          <a:pt x="948" y="884"/>
                        </a:lnTo>
                        <a:lnTo>
                          <a:pt x="952" y="884"/>
                        </a:lnTo>
                        <a:lnTo>
                          <a:pt x="956" y="884"/>
                        </a:lnTo>
                        <a:lnTo>
                          <a:pt x="960" y="884"/>
                        </a:lnTo>
                        <a:lnTo>
                          <a:pt x="964" y="884"/>
                        </a:lnTo>
                        <a:lnTo>
                          <a:pt x="968" y="884"/>
                        </a:lnTo>
                        <a:lnTo>
                          <a:pt x="972" y="884"/>
                        </a:lnTo>
                        <a:lnTo>
                          <a:pt x="976" y="884"/>
                        </a:lnTo>
                        <a:lnTo>
                          <a:pt x="980" y="884"/>
                        </a:lnTo>
                        <a:lnTo>
                          <a:pt x="984" y="884"/>
                        </a:lnTo>
                        <a:lnTo>
                          <a:pt x="988" y="884"/>
                        </a:lnTo>
                        <a:lnTo>
                          <a:pt x="992" y="884"/>
                        </a:lnTo>
                        <a:lnTo>
                          <a:pt x="996" y="884"/>
                        </a:lnTo>
                        <a:lnTo>
                          <a:pt x="1000" y="884"/>
                        </a:lnTo>
                        <a:lnTo>
                          <a:pt x="1004" y="884"/>
                        </a:lnTo>
                        <a:lnTo>
                          <a:pt x="1008" y="884"/>
                        </a:lnTo>
                        <a:lnTo>
                          <a:pt x="1012" y="884"/>
                        </a:lnTo>
                        <a:lnTo>
                          <a:pt x="1016" y="884"/>
                        </a:lnTo>
                      </a:path>
                    </a:pathLst>
                  </a:cu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grpSp>
            <p:nvGrpSpPr>
              <p:cNvPr id="294" name="Group 79"/>
              <p:cNvGrpSpPr>
                <a:grpSpLocks noChangeAspect="1"/>
              </p:cNvGrpSpPr>
              <p:nvPr/>
            </p:nvGrpSpPr>
            <p:grpSpPr bwMode="auto">
              <a:xfrm>
                <a:off x="3863973" y="2582635"/>
                <a:ext cx="1653861" cy="1792224"/>
                <a:chOff x="2064" y="1443"/>
                <a:chExt cx="1016" cy="1101"/>
              </a:xfrm>
            </p:grpSpPr>
            <p:sp>
              <p:nvSpPr>
                <p:cNvPr id="295" name="AutoShape 78"/>
                <p:cNvSpPr>
                  <a:spLocks noChangeAspect="1" noChangeArrowheads="1" noTextEdit="1"/>
                </p:cNvSpPr>
                <p:nvPr/>
              </p:nvSpPr>
              <p:spPr bwMode="auto">
                <a:xfrm>
                  <a:off x="2064" y="1443"/>
                  <a:ext cx="983" cy="110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grpSp>
              <p:nvGrpSpPr>
                <p:cNvPr id="297" name="Group 166"/>
                <p:cNvGrpSpPr>
                  <a:grpSpLocks/>
                </p:cNvGrpSpPr>
                <p:nvPr/>
              </p:nvGrpSpPr>
              <p:grpSpPr bwMode="auto">
                <a:xfrm>
                  <a:off x="2117" y="1452"/>
                  <a:ext cx="963" cy="888"/>
                  <a:chOff x="2117" y="1452"/>
                  <a:chExt cx="963" cy="888"/>
                </a:xfrm>
              </p:grpSpPr>
              <p:grpSp>
                <p:nvGrpSpPr>
                  <p:cNvPr id="298" name="Group 164"/>
                  <p:cNvGrpSpPr>
                    <a:grpSpLocks/>
                  </p:cNvGrpSpPr>
                  <p:nvPr/>
                </p:nvGrpSpPr>
                <p:grpSpPr bwMode="auto">
                  <a:xfrm>
                    <a:off x="2117" y="1452"/>
                    <a:ext cx="963" cy="888"/>
                    <a:chOff x="2117" y="1452"/>
                    <a:chExt cx="963" cy="888"/>
                  </a:xfrm>
                </p:grpSpPr>
                <p:sp>
                  <p:nvSpPr>
                    <p:cNvPr id="300" name="Rectangle 8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219" y="1477"/>
                      <a:ext cx="765" cy="764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4763">
                      <a:solidFill>
                        <a:srgbClr val="000000"/>
                      </a:solidFill>
                      <a:prstDash val="solid"/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301" name="Group 13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206" y="2239"/>
                      <a:ext cx="874" cy="101"/>
                      <a:chOff x="2206" y="2239"/>
                      <a:chExt cx="874" cy="101"/>
                    </a:xfrm>
                  </p:grpSpPr>
                  <p:sp>
                    <p:nvSpPr>
                      <p:cNvPr id="482" name="Line 8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18" y="2239"/>
                        <a:ext cx="764" cy="0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483" name="Group 123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2218" y="2242"/>
                        <a:ext cx="764" cy="18"/>
                        <a:chOff x="2218" y="2242"/>
                        <a:chExt cx="764" cy="18"/>
                      </a:xfrm>
                    </p:grpSpPr>
                    <p:sp>
                      <p:nvSpPr>
                        <p:cNvPr id="491" name="Line 8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18" y="224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2" name="Line 8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274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3" name="Line 8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07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4" name="Line 8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30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5" name="Line 9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51" y="2242"/>
                          <a:ext cx="0" cy="12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6" name="Line 9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66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7" name="Line 9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78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8" name="Line 9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90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499" name="Line 9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399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1" name="Line 9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07" y="224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2" name="Line 9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67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3" name="Line 9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499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4" name="Line 9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23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5" name="Line 9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41" y="2242"/>
                          <a:ext cx="0" cy="12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6" name="Line 10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58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7" name="Line 10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70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8" name="Line 10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82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09" name="Line 10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591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10" name="Line 10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00" y="224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511" name="Line 10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56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7" name="Line 10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692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8" name="Line 10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15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49" name="Line 10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33" y="2242"/>
                          <a:ext cx="0" cy="12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352" name="Line 10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48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54" name="Line 11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63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56" name="Line 11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72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57" name="Line 11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83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460" name="Line 11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792" y="224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3" name="Line 11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49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4" name="Line 11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884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5" name="Line 11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08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6" name="Line 11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26" y="2242"/>
                          <a:ext cx="0" cy="12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7" name="Line 11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40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8" name="Line 11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52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19" name="Line 12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64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20" name="Line 12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73" y="2242"/>
                          <a:ext cx="0" cy="6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521" name="Line 12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>
                          <a:off x="2982" y="2242"/>
                          <a:ext cx="0" cy="18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  <p:grpSp>
                    <p:nvGrpSpPr>
                      <p:cNvPr id="484" name="Group 129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2206" y="2272"/>
                        <a:ext cx="874" cy="68"/>
                        <a:chOff x="2206" y="2272"/>
                        <a:chExt cx="874" cy="68"/>
                      </a:xfrm>
                    </p:grpSpPr>
                    <p:sp>
                      <p:nvSpPr>
                        <p:cNvPr id="486" name="Rectangle 12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206" y="2272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87" name="Rectangle 12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384" y="2272"/>
                          <a:ext cx="63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88" name="Rectangle 126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564" y="227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89" name="Rectangle 127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745" y="2272"/>
                          <a:ext cx="125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90" name="Rectangle 128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923" y="2272"/>
                          <a:ext cx="157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</p:grpSp>
                <p:grpSp>
                  <p:nvGrpSpPr>
                    <p:cNvPr id="302" name="Group 163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117" y="1452"/>
                      <a:ext cx="101" cy="835"/>
                      <a:chOff x="2117" y="1452"/>
                      <a:chExt cx="101" cy="835"/>
                    </a:xfrm>
                  </p:grpSpPr>
                  <p:sp>
                    <p:nvSpPr>
                      <p:cNvPr id="303" name="Line 132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218" y="1476"/>
                        <a:ext cx="0" cy="763"/>
                      </a:xfrm>
                      <a:prstGeom prst="line">
                        <a:avLst/>
                      </a:prstGeom>
                      <a:noFill/>
                      <a:ln w="4763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grpSp>
                    <p:nvGrpSpPr>
                      <p:cNvPr id="304" name="Group 139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2117" y="1452"/>
                        <a:ext cx="94" cy="835"/>
                        <a:chOff x="2117" y="1452"/>
                        <a:chExt cx="94" cy="835"/>
                      </a:xfrm>
                    </p:grpSpPr>
                    <p:sp>
                      <p:nvSpPr>
                        <p:cNvPr id="2248" name="Rectangle 133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65" y="2219"/>
                          <a:ext cx="31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249" name="Rectangle 134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17" y="2068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250" name="Rectangle 135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17" y="1914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2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2251" name="Rectangle 136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17" y="1760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3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80" name="Rectangle 137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17" y="1606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400</a:t>
                          </a:r>
                          <a:endPara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481" name="Rectangle 138"/>
                        <p:cNvSpPr>
                          <a:spLocks noChangeArrowheads="1"/>
                        </p:cNvSpPr>
                        <p:nvPr/>
                      </p:nvSpPr>
                      <p:spPr bwMode="auto">
                        <a:xfrm>
                          <a:off x="2117" y="1452"/>
                          <a:ext cx="94" cy="68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  <p:txBody>
                        <a:bodyPr vert="horz" wrap="none" lIns="0" tIns="0" rIns="0" bIns="0" numCol="1" anchor="t" anchorCtr="0" compatLnSpc="1">
                          <a:prstTxWarp prst="textNoShape">
                            <a:avLst/>
                          </a:prstTxWarp>
                          <a:spAutoFit/>
                        </a:bodyPr>
                        <a:lstStyle>
                          <a:lvl1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1pPr>
                          <a:lvl2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2pPr>
                          <a:lvl3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3pPr>
                          <a:lvl4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4pPr>
                          <a:lvl5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5pPr>
                          <a:lvl6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6pPr>
                          <a:lvl7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7pPr>
                          <a:lvl8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8pPr>
                          <a:lvl9pPr fontAlgn="base"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defRPr>
                              <a:solidFill>
                                <a:schemeClr val="tx1"/>
                              </a:solidFill>
                              <a:latin typeface="Arial" pitchFamily="34" charset="0"/>
                              <a:cs typeface="Arial" pitchFamily="34" charset="0"/>
                            </a:defRPr>
                          </a:lvl9pPr>
                        </a:lstStyle>
                        <a:p>
                          <a:pPr marL="0" marR="0" lvl="0" indent="0" algn="l" defTabSz="914400" rtl="0" eaLnBrk="1" fontAlgn="base" latinLnBrk="0" hangingPunct="1">
                            <a:lnSpc>
                              <a:spcPct val="100000"/>
                            </a:lnSpc>
                            <a:spcBef>
                              <a:spcPct val="0"/>
                            </a:spcBef>
                            <a:spcAft>
                              <a:spcPct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</a:pPr>
                          <a:r>
                            <a:rPr kumimoji="0" lang="en-US" altLang="en-US" sz="700" b="1" i="0" u="none" strike="noStrike" cap="none" normalizeH="0" baseline="0" dirty="0" smtClean="0">
                              <a:ln>
                                <a:noFill/>
                              </a:ln>
                              <a:solidFill>
                                <a:srgbClr val="000000"/>
                              </a:solidFill>
                              <a:effectLst/>
                              <a:latin typeface="Arial" pitchFamily="34" charset="0"/>
                              <a:cs typeface="Arial" pitchFamily="34" charset="0"/>
                            </a:rPr>
                            <a:t>500</a:t>
                          </a:r>
                          <a:endPara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chemeClr val="tx1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grpSp>
                    <p:nvGrpSpPr>
                      <p:cNvPr id="305" name="Group 161"/>
                      <p:cNvGrpSpPr>
                        <a:grpSpLocks/>
                      </p:cNvGrpSpPr>
                      <p:nvPr/>
                    </p:nvGrpSpPr>
                    <p:grpSpPr bwMode="auto">
                      <a:xfrm>
                        <a:off x="2200" y="1473"/>
                        <a:ext cx="18" cy="766"/>
                        <a:chOff x="2200" y="1473"/>
                        <a:chExt cx="18" cy="766"/>
                      </a:xfrm>
                    </p:grpSpPr>
                    <p:sp>
                      <p:nvSpPr>
                        <p:cNvPr id="307" name="Line 14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2239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08" name="Line 14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2204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09" name="Line 14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2165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0" name="Line 14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2127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1" name="Line 14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2088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3" name="Line 14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2050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4" name="Line 14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2011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5" name="Line 14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973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6" name="Line 14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1934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7" name="Line 14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896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8" name="Line 15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857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19" name="Line 151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819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335" name="Line 152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1780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0" name="Line 153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742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1" name="Line 154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703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2" name="Line 155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665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3" name="Line 156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1627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4" name="Line 157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588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5" name="Line 158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550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6" name="Line 159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12" y="1511"/>
                          <a:ext cx="6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  <p:sp>
                      <p:nvSpPr>
                        <p:cNvPr id="2247" name="Line 160"/>
                        <p:cNvSpPr>
                          <a:spLocks noChangeShapeType="1"/>
                        </p:cNvSpPr>
                        <p:nvPr/>
                      </p:nvSpPr>
                      <p:spPr bwMode="auto">
                        <a:xfrm flipH="1">
                          <a:off x="2200" y="1473"/>
                          <a:ext cx="18" cy="0"/>
                        </a:xfrm>
                        <a:prstGeom prst="line">
                          <a:avLst/>
                        </a:prstGeom>
                        <a:noFill/>
                        <a:ln w="4763">
                          <a:solidFill>
                            <a:srgbClr val="000000"/>
                          </a:solidFill>
                          <a:prstDash val="solid"/>
                          <a:round/>
                          <a:headEnd/>
                          <a:tailEnd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noFill/>
                            </a14:hiddenFill>
                          </a:ext>
                        </a:extLst>
                      </p:spPr>
                      <p:txBody>
                        <a:bodyPr vert="horz" wrap="square" lIns="91440" tIns="45720" rIns="91440" bIns="45720" numCol="1" anchor="t" anchorCtr="0" compatLnSpc="1">
                          <a:prstTxWarp prst="textNoShape">
                            <a:avLst/>
                          </a:prstTxWarp>
                        </a:bodyPr>
                        <a:lstStyle/>
                        <a:p>
                          <a:endParaRPr lang="en-US"/>
                        </a:p>
                      </p:txBody>
                    </p:sp>
                  </p:grpSp>
                </p:grpSp>
              </p:grpSp>
              <p:sp>
                <p:nvSpPr>
                  <p:cNvPr id="299" name="Freeform 165"/>
                  <p:cNvSpPr>
                    <a:spLocks/>
                  </p:cNvSpPr>
                  <p:nvPr/>
                </p:nvSpPr>
                <p:spPr bwMode="auto">
                  <a:xfrm>
                    <a:off x="2224" y="1535"/>
                    <a:ext cx="752" cy="701"/>
                  </a:xfrm>
                  <a:custGeom>
                    <a:avLst/>
                    <a:gdLst>
                      <a:gd name="T0" fmla="*/ 9 w 752"/>
                      <a:gd name="T1" fmla="*/ 701 h 701"/>
                      <a:gd name="T2" fmla="*/ 21 w 752"/>
                      <a:gd name="T3" fmla="*/ 701 h 701"/>
                      <a:gd name="T4" fmla="*/ 32 w 752"/>
                      <a:gd name="T5" fmla="*/ 701 h 701"/>
                      <a:gd name="T6" fmla="*/ 44 w 752"/>
                      <a:gd name="T7" fmla="*/ 701 h 701"/>
                      <a:gd name="T8" fmla="*/ 56 w 752"/>
                      <a:gd name="T9" fmla="*/ 701 h 701"/>
                      <a:gd name="T10" fmla="*/ 68 w 752"/>
                      <a:gd name="T11" fmla="*/ 701 h 701"/>
                      <a:gd name="T12" fmla="*/ 80 w 752"/>
                      <a:gd name="T13" fmla="*/ 698 h 701"/>
                      <a:gd name="T14" fmla="*/ 92 w 752"/>
                      <a:gd name="T15" fmla="*/ 692 h 701"/>
                      <a:gd name="T16" fmla="*/ 104 w 752"/>
                      <a:gd name="T17" fmla="*/ 678 h 701"/>
                      <a:gd name="T18" fmla="*/ 115 w 752"/>
                      <a:gd name="T19" fmla="*/ 624 h 701"/>
                      <a:gd name="T20" fmla="*/ 127 w 752"/>
                      <a:gd name="T21" fmla="*/ 494 h 701"/>
                      <a:gd name="T22" fmla="*/ 139 w 752"/>
                      <a:gd name="T23" fmla="*/ 299 h 701"/>
                      <a:gd name="T24" fmla="*/ 151 w 752"/>
                      <a:gd name="T25" fmla="*/ 139 h 701"/>
                      <a:gd name="T26" fmla="*/ 163 w 752"/>
                      <a:gd name="T27" fmla="*/ 32 h 701"/>
                      <a:gd name="T28" fmla="*/ 175 w 752"/>
                      <a:gd name="T29" fmla="*/ 41 h 701"/>
                      <a:gd name="T30" fmla="*/ 186 w 752"/>
                      <a:gd name="T31" fmla="*/ 115 h 701"/>
                      <a:gd name="T32" fmla="*/ 198 w 752"/>
                      <a:gd name="T33" fmla="*/ 382 h 701"/>
                      <a:gd name="T34" fmla="*/ 210 w 752"/>
                      <a:gd name="T35" fmla="*/ 604 h 701"/>
                      <a:gd name="T36" fmla="*/ 222 w 752"/>
                      <a:gd name="T37" fmla="*/ 660 h 701"/>
                      <a:gd name="T38" fmla="*/ 234 w 752"/>
                      <a:gd name="T39" fmla="*/ 680 h 701"/>
                      <a:gd name="T40" fmla="*/ 246 w 752"/>
                      <a:gd name="T41" fmla="*/ 692 h 701"/>
                      <a:gd name="T42" fmla="*/ 257 w 752"/>
                      <a:gd name="T43" fmla="*/ 698 h 701"/>
                      <a:gd name="T44" fmla="*/ 269 w 752"/>
                      <a:gd name="T45" fmla="*/ 698 h 701"/>
                      <a:gd name="T46" fmla="*/ 281 w 752"/>
                      <a:gd name="T47" fmla="*/ 698 h 701"/>
                      <a:gd name="T48" fmla="*/ 293 w 752"/>
                      <a:gd name="T49" fmla="*/ 698 h 701"/>
                      <a:gd name="T50" fmla="*/ 305 w 752"/>
                      <a:gd name="T51" fmla="*/ 698 h 701"/>
                      <a:gd name="T52" fmla="*/ 317 w 752"/>
                      <a:gd name="T53" fmla="*/ 695 h 701"/>
                      <a:gd name="T54" fmla="*/ 329 w 752"/>
                      <a:gd name="T55" fmla="*/ 695 h 701"/>
                      <a:gd name="T56" fmla="*/ 340 w 752"/>
                      <a:gd name="T57" fmla="*/ 698 h 701"/>
                      <a:gd name="T58" fmla="*/ 352 w 752"/>
                      <a:gd name="T59" fmla="*/ 698 h 701"/>
                      <a:gd name="T60" fmla="*/ 364 w 752"/>
                      <a:gd name="T61" fmla="*/ 698 h 701"/>
                      <a:gd name="T62" fmla="*/ 376 w 752"/>
                      <a:gd name="T63" fmla="*/ 701 h 701"/>
                      <a:gd name="T64" fmla="*/ 388 w 752"/>
                      <a:gd name="T65" fmla="*/ 701 h 701"/>
                      <a:gd name="T66" fmla="*/ 400 w 752"/>
                      <a:gd name="T67" fmla="*/ 701 h 701"/>
                      <a:gd name="T68" fmla="*/ 411 w 752"/>
                      <a:gd name="T69" fmla="*/ 701 h 701"/>
                      <a:gd name="T70" fmla="*/ 423 w 752"/>
                      <a:gd name="T71" fmla="*/ 701 h 701"/>
                      <a:gd name="T72" fmla="*/ 435 w 752"/>
                      <a:gd name="T73" fmla="*/ 701 h 701"/>
                      <a:gd name="T74" fmla="*/ 447 w 752"/>
                      <a:gd name="T75" fmla="*/ 701 h 701"/>
                      <a:gd name="T76" fmla="*/ 459 w 752"/>
                      <a:gd name="T77" fmla="*/ 701 h 701"/>
                      <a:gd name="T78" fmla="*/ 471 w 752"/>
                      <a:gd name="T79" fmla="*/ 701 h 701"/>
                      <a:gd name="T80" fmla="*/ 483 w 752"/>
                      <a:gd name="T81" fmla="*/ 701 h 701"/>
                      <a:gd name="T82" fmla="*/ 494 w 752"/>
                      <a:gd name="T83" fmla="*/ 701 h 701"/>
                      <a:gd name="T84" fmla="*/ 506 w 752"/>
                      <a:gd name="T85" fmla="*/ 701 h 701"/>
                      <a:gd name="T86" fmla="*/ 518 w 752"/>
                      <a:gd name="T87" fmla="*/ 701 h 701"/>
                      <a:gd name="T88" fmla="*/ 530 w 752"/>
                      <a:gd name="T89" fmla="*/ 701 h 701"/>
                      <a:gd name="T90" fmla="*/ 542 w 752"/>
                      <a:gd name="T91" fmla="*/ 701 h 701"/>
                      <a:gd name="T92" fmla="*/ 554 w 752"/>
                      <a:gd name="T93" fmla="*/ 701 h 701"/>
                      <a:gd name="T94" fmla="*/ 565 w 752"/>
                      <a:gd name="T95" fmla="*/ 701 h 701"/>
                      <a:gd name="T96" fmla="*/ 577 w 752"/>
                      <a:gd name="T97" fmla="*/ 701 h 701"/>
                      <a:gd name="T98" fmla="*/ 589 w 752"/>
                      <a:gd name="T99" fmla="*/ 701 h 701"/>
                      <a:gd name="T100" fmla="*/ 601 w 752"/>
                      <a:gd name="T101" fmla="*/ 701 h 701"/>
                      <a:gd name="T102" fmla="*/ 613 w 752"/>
                      <a:gd name="T103" fmla="*/ 701 h 701"/>
                      <a:gd name="T104" fmla="*/ 625 w 752"/>
                      <a:gd name="T105" fmla="*/ 701 h 701"/>
                      <a:gd name="T106" fmla="*/ 636 w 752"/>
                      <a:gd name="T107" fmla="*/ 701 h 701"/>
                      <a:gd name="T108" fmla="*/ 648 w 752"/>
                      <a:gd name="T109" fmla="*/ 701 h 701"/>
                      <a:gd name="T110" fmla="*/ 660 w 752"/>
                      <a:gd name="T111" fmla="*/ 701 h 701"/>
                      <a:gd name="T112" fmla="*/ 672 w 752"/>
                      <a:gd name="T113" fmla="*/ 701 h 701"/>
                      <a:gd name="T114" fmla="*/ 684 w 752"/>
                      <a:gd name="T115" fmla="*/ 701 h 701"/>
                      <a:gd name="T116" fmla="*/ 696 w 752"/>
                      <a:gd name="T117" fmla="*/ 701 h 701"/>
                      <a:gd name="T118" fmla="*/ 708 w 752"/>
                      <a:gd name="T119" fmla="*/ 701 h 701"/>
                      <a:gd name="T120" fmla="*/ 719 w 752"/>
                      <a:gd name="T121" fmla="*/ 701 h 701"/>
                      <a:gd name="T122" fmla="*/ 731 w 752"/>
                      <a:gd name="T123" fmla="*/ 701 h 701"/>
                      <a:gd name="T124" fmla="*/ 743 w 752"/>
                      <a:gd name="T125" fmla="*/ 701 h 701"/>
                    </a:gdLst>
                    <a:ahLst/>
                    <a:cxnLst>
                      <a:cxn ang="0">
                        <a:pos x="T0" y="T1"/>
                      </a:cxn>
                      <a:cxn ang="0">
                        <a:pos x="T2" y="T3"/>
                      </a:cxn>
                      <a:cxn ang="0">
                        <a:pos x="T4" y="T5"/>
                      </a:cxn>
                      <a:cxn ang="0">
                        <a:pos x="T6" y="T7"/>
                      </a:cxn>
                      <a:cxn ang="0">
                        <a:pos x="T8" y="T9"/>
                      </a:cxn>
                      <a:cxn ang="0">
                        <a:pos x="T10" y="T11"/>
                      </a:cxn>
                      <a:cxn ang="0">
                        <a:pos x="T12" y="T13"/>
                      </a:cxn>
                      <a:cxn ang="0">
                        <a:pos x="T14" y="T15"/>
                      </a:cxn>
                      <a:cxn ang="0">
                        <a:pos x="T16" y="T17"/>
                      </a:cxn>
                      <a:cxn ang="0">
                        <a:pos x="T18" y="T19"/>
                      </a:cxn>
                      <a:cxn ang="0">
                        <a:pos x="T20" y="T21"/>
                      </a:cxn>
                      <a:cxn ang="0">
                        <a:pos x="T22" y="T23"/>
                      </a:cxn>
                      <a:cxn ang="0">
                        <a:pos x="T24" y="T25"/>
                      </a:cxn>
                      <a:cxn ang="0">
                        <a:pos x="T26" y="T27"/>
                      </a:cxn>
                      <a:cxn ang="0">
                        <a:pos x="T28" y="T29"/>
                      </a:cxn>
                      <a:cxn ang="0">
                        <a:pos x="T30" y="T31"/>
                      </a:cxn>
                      <a:cxn ang="0">
                        <a:pos x="T32" y="T33"/>
                      </a:cxn>
                      <a:cxn ang="0">
                        <a:pos x="T34" y="T35"/>
                      </a:cxn>
                      <a:cxn ang="0">
                        <a:pos x="T36" y="T37"/>
                      </a:cxn>
                      <a:cxn ang="0">
                        <a:pos x="T38" y="T39"/>
                      </a:cxn>
                      <a:cxn ang="0">
                        <a:pos x="T40" y="T41"/>
                      </a:cxn>
                      <a:cxn ang="0">
                        <a:pos x="T42" y="T43"/>
                      </a:cxn>
                      <a:cxn ang="0">
                        <a:pos x="T44" y="T45"/>
                      </a:cxn>
                      <a:cxn ang="0">
                        <a:pos x="T46" y="T47"/>
                      </a:cxn>
                      <a:cxn ang="0">
                        <a:pos x="T48" y="T49"/>
                      </a:cxn>
                      <a:cxn ang="0">
                        <a:pos x="T50" y="T51"/>
                      </a:cxn>
                      <a:cxn ang="0">
                        <a:pos x="T52" y="T53"/>
                      </a:cxn>
                      <a:cxn ang="0">
                        <a:pos x="T54" y="T55"/>
                      </a:cxn>
                      <a:cxn ang="0">
                        <a:pos x="T56" y="T57"/>
                      </a:cxn>
                      <a:cxn ang="0">
                        <a:pos x="T58" y="T59"/>
                      </a:cxn>
                      <a:cxn ang="0">
                        <a:pos x="T60" y="T61"/>
                      </a:cxn>
                      <a:cxn ang="0">
                        <a:pos x="T62" y="T63"/>
                      </a:cxn>
                      <a:cxn ang="0">
                        <a:pos x="T64" y="T65"/>
                      </a:cxn>
                      <a:cxn ang="0">
                        <a:pos x="T66" y="T67"/>
                      </a:cxn>
                      <a:cxn ang="0">
                        <a:pos x="T68" y="T69"/>
                      </a:cxn>
                      <a:cxn ang="0">
                        <a:pos x="T70" y="T71"/>
                      </a:cxn>
                      <a:cxn ang="0">
                        <a:pos x="T72" y="T73"/>
                      </a:cxn>
                      <a:cxn ang="0">
                        <a:pos x="T74" y="T75"/>
                      </a:cxn>
                      <a:cxn ang="0">
                        <a:pos x="T76" y="T77"/>
                      </a:cxn>
                      <a:cxn ang="0">
                        <a:pos x="T78" y="T79"/>
                      </a:cxn>
                      <a:cxn ang="0">
                        <a:pos x="T80" y="T81"/>
                      </a:cxn>
                      <a:cxn ang="0">
                        <a:pos x="T82" y="T83"/>
                      </a:cxn>
                      <a:cxn ang="0">
                        <a:pos x="T84" y="T85"/>
                      </a:cxn>
                      <a:cxn ang="0">
                        <a:pos x="T86" y="T87"/>
                      </a:cxn>
                      <a:cxn ang="0">
                        <a:pos x="T88" y="T89"/>
                      </a:cxn>
                      <a:cxn ang="0">
                        <a:pos x="T90" y="T91"/>
                      </a:cxn>
                      <a:cxn ang="0">
                        <a:pos x="T92" y="T93"/>
                      </a:cxn>
                      <a:cxn ang="0">
                        <a:pos x="T94" y="T95"/>
                      </a:cxn>
                      <a:cxn ang="0">
                        <a:pos x="T96" y="T97"/>
                      </a:cxn>
                      <a:cxn ang="0">
                        <a:pos x="T98" y="T99"/>
                      </a:cxn>
                      <a:cxn ang="0">
                        <a:pos x="T100" y="T101"/>
                      </a:cxn>
                      <a:cxn ang="0">
                        <a:pos x="T102" y="T103"/>
                      </a:cxn>
                      <a:cxn ang="0">
                        <a:pos x="T104" y="T105"/>
                      </a:cxn>
                      <a:cxn ang="0">
                        <a:pos x="T106" y="T107"/>
                      </a:cxn>
                      <a:cxn ang="0">
                        <a:pos x="T108" y="T109"/>
                      </a:cxn>
                      <a:cxn ang="0">
                        <a:pos x="T110" y="T111"/>
                      </a:cxn>
                      <a:cxn ang="0">
                        <a:pos x="T112" y="T113"/>
                      </a:cxn>
                      <a:cxn ang="0">
                        <a:pos x="T114" y="T115"/>
                      </a:cxn>
                      <a:cxn ang="0">
                        <a:pos x="T116" y="T117"/>
                      </a:cxn>
                      <a:cxn ang="0">
                        <a:pos x="T118" y="T119"/>
                      </a:cxn>
                      <a:cxn ang="0">
                        <a:pos x="T120" y="T121"/>
                      </a:cxn>
                      <a:cxn ang="0">
                        <a:pos x="T122" y="T123"/>
                      </a:cxn>
                      <a:cxn ang="0">
                        <a:pos x="T124" y="T125"/>
                      </a:cxn>
                    </a:cxnLst>
                    <a:rect l="0" t="0" r="r" b="b"/>
                    <a:pathLst>
                      <a:path w="752" h="701">
                        <a:moveTo>
                          <a:pt x="0" y="701"/>
                        </a:moveTo>
                        <a:lnTo>
                          <a:pt x="3" y="701"/>
                        </a:lnTo>
                        <a:lnTo>
                          <a:pt x="6" y="701"/>
                        </a:lnTo>
                        <a:lnTo>
                          <a:pt x="9" y="701"/>
                        </a:lnTo>
                        <a:lnTo>
                          <a:pt x="12" y="701"/>
                        </a:lnTo>
                        <a:lnTo>
                          <a:pt x="15" y="701"/>
                        </a:lnTo>
                        <a:lnTo>
                          <a:pt x="18" y="701"/>
                        </a:lnTo>
                        <a:lnTo>
                          <a:pt x="21" y="701"/>
                        </a:lnTo>
                        <a:lnTo>
                          <a:pt x="24" y="701"/>
                        </a:lnTo>
                        <a:lnTo>
                          <a:pt x="27" y="701"/>
                        </a:lnTo>
                        <a:lnTo>
                          <a:pt x="29" y="701"/>
                        </a:lnTo>
                        <a:lnTo>
                          <a:pt x="32" y="701"/>
                        </a:lnTo>
                        <a:lnTo>
                          <a:pt x="35" y="701"/>
                        </a:lnTo>
                        <a:lnTo>
                          <a:pt x="38" y="701"/>
                        </a:lnTo>
                        <a:lnTo>
                          <a:pt x="41" y="701"/>
                        </a:lnTo>
                        <a:lnTo>
                          <a:pt x="44" y="701"/>
                        </a:lnTo>
                        <a:lnTo>
                          <a:pt x="47" y="701"/>
                        </a:lnTo>
                        <a:lnTo>
                          <a:pt x="50" y="701"/>
                        </a:lnTo>
                        <a:lnTo>
                          <a:pt x="53" y="701"/>
                        </a:lnTo>
                        <a:lnTo>
                          <a:pt x="56" y="701"/>
                        </a:lnTo>
                        <a:lnTo>
                          <a:pt x="59" y="701"/>
                        </a:lnTo>
                        <a:lnTo>
                          <a:pt x="62" y="701"/>
                        </a:lnTo>
                        <a:lnTo>
                          <a:pt x="65" y="701"/>
                        </a:lnTo>
                        <a:lnTo>
                          <a:pt x="68" y="701"/>
                        </a:lnTo>
                        <a:lnTo>
                          <a:pt x="71" y="701"/>
                        </a:lnTo>
                        <a:lnTo>
                          <a:pt x="74" y="698"/>
                        </a:lnTo>
                        <a:lnTo>
                          <a:pt x="77" y="698"/>
                        </a:lnTo>
                        <a:lnTo>
                          <a:pt x="80" y="698"/>
                        </a:lnTo>
                        <a:lnTo>
                          <a:pt x="83" y="695"/>
                        </a:lnTo>
                        <a:lnTo>
                          <a:pt x="86" y="695"/>
                        </a:lnTo>
                        <a:lnTo>
                          <a:pt x="89" y="695"/>
                        </a:lnTo>
                        <a:lnTo>
                          <a:pt x="92" y="692"/>
                        </a:lnTo>
                        <a:lnTo>
                          <a:pt x="95" y="689"/>
                        </a:lnTo>
                        <a:lnTo>
                          <a:pt x="98" y="686"/>
                        </a:lnTo>
                        <a:lnTo>
                          <a:pt x="101" y="683"/>
                        </a:lnTo>
                        <a:lnTo>
                          <a:pt x="104" y="678"/>
                        </a:lnTo>
                        <a:lnTo>
                          <a:pt x="106" y="666"/>
                        </a:lnTo>
                        <a:lnTo>
                          <a:pt x="109" y="651"/>
                        </a:lnTo>
                        <a:lnTo>
                          <a:pt x="112" y="636"/>
                        </a:lnTo>
                        <a:lnTo>
                          <a:pt x="115" y="624"/>
                        </a:lnTo>
                        <a:lnTo>
                          <a:pt x="118" y="604"/>
                        </a:lnTo>
                        <a:lnTo>
                          <a:pt x="121" y="565"/>
                        </a:lnTo>
                        <a:lnTo>
                          <a:pt x="124" y="521"/>
                        </a:lnTo>
                        <a:lnTo>
                          <a:pt x="127" y="494"/>
                        </a:lnTo>
                        <a:lnTo>
                          <a:pt x="130" y="461"/>
                        </a:lnTo>
                        <a:lnTo>
                          <a:pt x="133" y="408"/>
                        </a:lnTo>
                        <a:lnTo>
                          <a:pt x="136" y="346"/>
                        </a:lnTo>
                        <a:lnTo>
                          <a:pt x="139" y="299"/>
                        </a:lnTo>
                        <a:lnTo>
                          <a:pt x="142" y="287"/>
                        </a:lnTo>
                        <a:lnTo>
                          <a:pt x="145" y="254"/>
                        </a:lnTo>
                        <a:lnTo>
                          <a:pt x="148" y="198"/>
                        </a:lnTo>
                        <a:lnTo>
                          <a:pt x="151" y="139"/>
                        </a:lnTo>
                        <a:lnTo>
                          <a:pt x="154" y="86"/>
                        </a:lnTo>
                        <a:lnTo>
                          <a:pt x="157" y="50"/>
                        </a:lnTo>
                        <a:lnTo>
                          <a:pt x="160" y="41"/>
                        </a:lnTo>
                        <a:lnTo>
                          <a:pt x="163" y="32"/>
                        </a:lnTo>
                        <a:lnTo>
                          <a:pt x="166" y="9"/>
                        </a:lnTo>
                        <a:lnTo>
                          <a:pt x="169" y="0"/>
                        </a:lnTo>
                        <a:lnTo>
                          <a:pt x="172" y="23"/>
                        </a:lnTo>
                        <a:lnTo>
                          <a:pt x="175" y="41"/>
                        </a:lnTo>
                        <a:lnTo>
                          <a:pt x="178" y="35"/>
                        </a:lnTo>
                        <a:lnTo>
                          <a:pt x="180" y="44"/>
                        </a:lnTo>
                        <a:lnTo>
                          <a:pt x="183" y="71"/>
                        </a:lnTo>
                        <a:lnTo>
                          <a:pt x="186" y="115"/>
                        </a:lnTo>
                        <a:lnTo>
                          <a:pt x="189" y="183"/>
                        </a:lnTo>
                        <a:lnTo>
                          <a:pt x="192" y="266"/>
                        </a:lnTo>
                        <a:lnTo>
                          <a:pt x="195" y="337"/>
                        </a:lnTo>
                        <a:lnTo>
                          <a:pt x="198" y="382"/>
                        </a:lnTo>
                        <a:lnTo>
                          <a:pt x="201" y="450"/>
                        </a:lnTo>
                        <a:lnTo>
                          <a:pt x="204" y="527"/>
                        </a:lnTo>
                        <a:lnTo>
                          <a:pt x="207" y="574"/>
                        </a:lnTo>
                        <a:lnTo>
                          <a:pt x="210" y="604"/>
                        </a:lnTo>
                        <a:lnTo>
                          <a:pt x="213" y="624"/>
                        </a:lnTo>
                        <a:lnTo>
                          <a:pt x="216" y="642"/>
                        </a:lnTo>
                        <a:lnTo>
                          <a:pt x="219" y="654"/>
                        </a:lnTo>
                        <a:lnTo>
                          <a:pt x="222" y="660"/>
                        </a:lnTo>
                        <a:lnTo>
                          <a:pt x="225" y="666"/>
                        </a:lnTo>
                        <a:lnTo>
                          <a:pt x="228" y="672"/>
                        </a:lnTo>
                        <a:lnTo>
                          <a:pt x="231" y="678"/>
                        </a:lnTo>
                        <a:lnTo>
                          <a:pt x="234" y="680"/>
                        </a:lnTo>
                        <a:lnTo>
                          <a:pt x="237" y="683"/>
                        </a:lnTo>
                        <a:lnTo>
                          <a:pt x="240" y="686"/>
                        </a:lnTo>
                        <a:lnTo>
                          <a:pt x="243" y="689"/>
                        </a:lnTo>
                        <a:lnTo>
                          <a:pt x="246" y="692"/>
                        </a:lnTo>
                        <a:lnTo>
                          <a:pt x="249" y="695"/>
                        </a:lnTo>
                        <a:lnTo>
                          <a:pt x="252" y="695"/>
                        </a:lnTo>
                        <a:lnTo>
                          <a:pt x="255" y="695"/>
                        </a:lnTo>
                        <a:lnTo>
                          <a:pt x="257" y="698"/>
                        </a:lnTo>
                        <a:lnTo>
                          <a:pt x="260" y="698"/>
                        </a:lnTo>
                        <a:lnTo>
                          <a:pt x="263" y="698"/>
                        </a:lnTo>
                        <a:lnTo>
                          <a:pt x="266" y="698"/>
                        </a:lnTo>
                        <a:lnTo>
                          <a:pt x="269" y="698"/>
                        </a:lnTo>
                        <a:lnTo>
                          <a:pt x="272" y="698"/>
                        </a:lnTo>
                        <a:lnTo>
                          <a:pt x="275" y="698"/>
                        </a:lnTo>
                        <a:lnTo>
                          <a:pt x="278" y="698"/>
                        </a:lnTo>
                        <a:lnTo>
                          <a:pt x="281" y="698"/>
                        </a:lnTo>
                        <a:lnTo>
                          <a:pt x="284" y="698"/>
                        </a:lnTo>
                        <a:lnTo>
                          <a:pt x="287" y="698"/>
                        </a:lnTo>
                        <a:lnTo>
                          <a:pt x="290" y="698"/>
                        </a:lnTo>
                        <a:lnTo>
                          <a:pt x="293" y="698"/>
                        </a:lnTo>
                        <a:lnTo>
                          <a:pt x="296" y="698"/>
                        </a:lnTo>
                        <a:lnTo>
                          <a:pt x="299" y="698"/>
                        </a:lnTo>
                        <a:lnTo>
                          <a:pt x="302" y="698"/>
                        </a:lnTo>
                        <a:lnTo>
                          <a:pt x="305" y="698"/>
                        </a:lnTo>
                        <a:lnTo>
                          <a:pt x="308" y="698"/>
                        </a:lnTo>
                        <a:lnTo>
                          <a:pt x="311" y="698"/>
                        </a:lnTo>
                        <a:lnTo>
                          <a:pt x="314" y="698"/>
                        </a:lnTo>
                        <a:lnTo>
                          <a:pt x="317" y="695"/>
                        </a:lnTo>
                        <a:lnTo>
                          <a:pt x="320" y="695"/>
                        </a:lnTo>
                        <a:lnTo>
                          <a:pt x="323" y="695"/>
                        </a:lnTo>
                        <a:lnTo>
                          <a:pt x="326" y="695"/>
                        </a:lnTo>
                        <a:lnTo>
                          <a:pt x="329" y="695"/>
                        </a:lnTo>
                        <a:lnTo>
                          <a:pt x="332" y="695"/>
                        </a:lnTo>
                        <a:lnTo>
                          <a:pt x="334" y="698"/>
                        </a:lnTo>
                        <a:lnTo>
                          <a:pt x="337" y="698"/>
                        </a:lnTo>
                        <a:lnTo>
                          <a:pt x="340" y="698"/>
                        </a:lnTo>
                        <a:lnTo>
                          <a:pt x="343" y="698"/>
                        </a:lnTo>
                        <a:lnTo>
                          <a:pt x="346" y="698"/>
                        </a:lnTo>
                        <a:lnTo>
                          <a:pt x="349" y="698"/>
                        </a:lnTo>
                        <a:lnTo>
                          <a:pt x="352" y="698"/>
                        </a:lnTo>
                        <a:lnTo>
                          <a:pt x="355" y="698"/>
                        </a:lnTo>
                        <a:lnTo>
                          <a:pt x="358" y="698"/>
                        </a:lnTo>
                        <a:lnTo>
                          <a:pt x="361" y="698"/>
                        </a:lnTo>
                        <a:lnTo>
                          <a:pt x="364" y="698"/>
                        </a:lnTo>
                        <a:lnTo>
                          <a:pt x="367" y="701"/>
                        </a:lnTo>
                        <a:lnTo>
                          <a:pt x="370" y="701"/>
                        </a:lnTo>
                        <a:lnTo>
                          <a:pt x="373" y="701"/>
                        </a:lnTo>
                        <a:lnTo>
                          <a:pt x="376" y="701"/>
                        </a:lnTo>
                        <a:lnTo>
                          <a:pt x="379" y="701"/>
                        </a:lnTo>
                        <a:lnTo>
                          <a:pt x="382" y="701"/>
                        </a:lnTo>
                        <a:lnTo>
                          <a:pt x="385" y="701"/>
                        </a:lnTo>
                        <a:lnTo>
                          <a:pt x="388" y="701"/>
                        </a:lnTo>
                        <a:lnTo>
                          <a:pt x="391" y="701"/>
                        </a:lnTo>
                        <a:lnTo>
                          <a:pt x="394" y="701"/>
                        </a:lnTo>
                        <a:lnTo>
                          <a:pt x="397" y="701"/>
                        </a:lnTo>
                        <a:lnTo>
                          <a:pt x="400" y="701"/>
                        </a:lnTo>
                        <a:lnTo>
                          <a:pt x="403" y="701"/>
                        </a:lnTo>
                        <a:lnTo>
                          <a:pt x="406" y="701"/>
                        </a:lnTo>
                        <a:lnTo>
                          <a:pt x="408" y="701"/>
                        </a:lnTo>
                        <a:lnTo>
                          <a:pt x="411" y="701"/>
                        </a:lnTo>
                        <a:lnTo>
                          <a:pt x="414" y="701"/>
                        </a:lnTo>
                        <a:lnTo>
                          <a:pt x="417" y="701"/>
                        </a:lnTo>
                        <a:lnTo>
                          <a:pt x="420" y="701"/>
                        </a:lnTo>
                        <a:lnTo>
                          <a:pt x="423" y="701"/>
                        </a:lnTo>
                        <a:lnTo>
                          <a:pt x="426" y="701"/>
                        </a:lnTo>
                        <a:lnTo>
                          <a:pt x="429" y="701"/>
                        </a:lnTo>
                        <a:lnTo>
                          <a:pt x="432" y="701"/>
                        </a:lnTo>
                        <a:lnTo>
                          <a:pt x="435" y="701"/>
                        </a:lnTo>
                        <a:lnTo>
                          <a:pt x="438" y="701"/>
                        </a:lnTo>
                        <a:lnTo>
                          <a:pt x="441" y="701"/>
                        </a:lnTo>
                        <a:lnTo>
                          <a:pt x="444" y="701"/>
                        </a:lnTo>
                        <a:lnTo>
                          <a:pt x="447" y="701"/>
                        </a:lnTo>
                        <a:lnTo>
                          <a:pt x="450" y="701"/>
                        </a:lnTo>
                        <a:lnTo>
                          <a:pt x="453" y="701"/>
                        </a:lnTo>
                        <a:lnTo>
                          <a:pt x="456" y="701"/>
                        </a:lnTo>
                        <a:lnTo>
                          <a:pt x="459" y="701"/>
                        </a:lnTo>
                        <a:lnTo>
                          <a:pt x="462" y="701"/>
                        </a:lnTo>
                        <a:lnTo>
                          <a:pt x="465" y="701"/>
                        </a:lnTo>
                        <a:lnTo>
                          <a:pt x="468" y="701"/>
                        </a:lnTo>
                        <a:lnTo>
                          <a:pt x="471" y="701"/>
                        </a:lnTo>
                        <a:lnTo>
                          <a:pt x="474" y="701"/>
                        </a:lnTo>
                        <a:lnTo>
                          <a:pt x="477" y="701"/>
                        </a:lnTo>
                        <a:lnTo>
                          <a:pt x="480" y="701"/>
                        </a:lnTo>
                        <a:lnTo>
                          <a:pt x="483" y="701"/>
                        </a:lnTo>
                        <a:lnTo>
                          <a:pt x="485" y="701"/>
                        </a:lnTo>
                        <a:lnTo>
                          <a:pt x="488" y="701"/>
                        </a:lnTo>
                        <a:lnTo>
                          <a:pt x="491" y="701"/>
                        </a:lnTo>
                        <a:lnTo>
                          <a:pt x="494" y="701"/>
                        </a:lnTo>
                        <a:lnTo>
                          <a:pt x="497" y="701"/>
                        </a:lnTo>
                        <a:lnTo>
                          <a:pt x="500" y="701"/>
                        </a:lnTo>
                        <a:lnTo>
                          <a:pt x="503" y="701"/>
                        </a:lnTo>
                        <a:lnTo>
                          <a:pt x="506" y="701"/>
                        </a:lnTo>
                        <a:lnTo>
                          <a:pt x="509" y="701"/>
                        </a:lnTo>
                        <a:lnTo>
                          <a:pt x="512" y="701"/>
                        </a:lnTo>
                        <a:lnTo>
                          <a:pt x="515" y="701"/>
                        </a:lnTo>
                        <a:lnTo>
                          <a:pt x="518" y="701"/>
                        </a:lnTo>
                        <a:lnTo>
                          <a:pt x="521" y="701"/>
                        </a:lnTo>
                        <a:lnTo>
                          <a:pt x="524" y="701"/>
                        </a:lnTo>
                        <a:lnTo>
                          <a:pt x="527" y="701"/>
                        </a:lnTo>
                        <a:lnTo>
                          <a:pt x="530" y="701"/>
                        </a:lnTo>
                        <a:lnTo>
                          <a:pt x="533" y="701"/>
                        </a:lnTo>
                        <a:lnTo>
                          <a:pt x="536" y="701"/>
                        </a:lnTo>
                        <a:lnTo>
                          <a:pt x="539" y="701"/>
                        </a:lnTo>
                        <a:lnTo>
                          <a:pt x="542" y="701"/>
                        </a:lnTo>
                        <a:lnTo>
                          <a:pt x="545" y="701"/>
                        </a:lnTo>
                        <a:lnTo>
                          <a:pt x="548" y="701"/>
                        </a:lnTo>
                        <a:lnTo>
                          <a:pt x="551" y="701"/>
                        </a:lnTo>
                        <a:lnTo>
                          <a:pt x="554" y="701"/>
                        </a:lnTo>
                        <a:lnTo>
                          <a:pt x="557" y="701"/>
                        </a:lnTo>
                        <a:lnTo>
                          <a:pt x="559" y="701"/>
                        </a:lnTo>
                        <a:lnTo>
                          <a:pt x="562" y="701"/>
                        </a:lnTo>
                        <a:lnTo>
                          <a:pt x="565" y="701"/>
                        </a:lnTo>
                        <a:lnTo>
                          <a:pt x="568" y="701"/>
                        </a:lnTo>
                        <a:lnTo>
                          <a:pt x="571" y="701"/>
                        </a:lnTo>
                        <a:lnTo>
                          <a:pt x="574" y="701"/>
                        </a:lnTo>
                        <a:lnTo>
                          <a:pt x="577" y="701"/>
                        </a:lnTo>
                        <a:lnTo>
                          <a:pt x="580" y="701"/>
                        </a:lnTo>
                        <a:lnTo>
                          <a:pt x="583" y="701"/>
                        </a:lnTo>
                        <a:lnTo>
                          <a:pt x="586" y="701"/>
                        </a:lnTo>
                        <a:lnTo>
                          <a:pt x="589" y="701"/>
                        </a:lnTo>
                        <a:lnTo>
                          <a:pt x="592" y="701"/>
                        </a:lnTo>
                        <a:lnTo>
                          <a:pt x="595" y="701"/>
                        </a:lnTo>
                        <a:lnTo>
                          <a:pt x="598" y="701"/>
                        </a:lnTo>
                        <a:lnTo>
                          <a:pt x="601" y="701"/>
                        </a:lnTo>
                        <a:lnTo>
                          <a:pt x="604" y="701"/>
                        </a:lnTo>
                        <a:lnTo>
                          <a:pt x="607" y="701"/>
                        </a:lnTo>
                        <a:lnTo>
                          <a:pt x="610" y="701"/>
                        </a:lnTo>
                        <a:lnTo>
                          <a:pt x="613" y="701"/>
                        </a:lnTo>
                        <a:lnTo>
                          <a:pt x="616" y="701"/>
                        </a:lnTo>
                        <a:lnTo>
                          <a:pt x="619" y="701"/>
                        </a:lnTo>
                        <a:lnTo>
                          <a:pt x="622" y="701"/>
                        </a:lnTo>
                        <a:lnTo>
                          <a:pt x="625" y="701"/>
                        </a:lnTo>
                        <a:lnTo>
                          <a:pt x="628" y="701"/>
                        </a:lnTo>
                        <a:lnTo>
                          <a:pt x="631" y="701"/>
                        </a:lnTo>
                        <a:lnTo>
                          <a:pt x="634" y="701"/>
                        </a:lnTo>
                        <a:lnTo>
                          <a:pt x="636" y="701"/>
                        </a:lnTo>
                        <a:lnTo>
                          <a:pt x="639" y="701"/>
                        </a:lnTo>
                        <a:lnTo>
                          <a:pt x="642" y="701"/>
                        </a:lnTo>
                        <a:lnTo>
                          <a:pt x="645" y="701"/>
                        </a:lnTo>
                        <a:lnTo>
                          <a:pt x="648" y="701"/>
                        </a:lnTo>
                        <a:lnTo>
                          <a:pt x="651" y="701"/>
                        </a:lnTo>
                        <a:lnTo>
                          <a:pt x="654" y="701"/>
                        </a:lnTo>
                        <a:lnTo>
                          <a:pt x="657" y="701"/>
                        </a:lnTo>
                        <a:lnTo>
                          <a:pt x="660" y="701"/>
                        </a:lnTo>
                        <a:lnTo>
                          <a:pt x="663" y="701"/>
                        </a:lnTo>
                        <a:lnTo>
                          <a:pt x="666" y="701"/>
                        </a:lnTo>
                        <a:lnTo>
                          <a:pt x="669" y="701"/>
                        </a:lnTo>
                        <a:lnTo>
                          <a:pt x="672" y="701"/>
                        </a:lnTo>
                        <a:lnTo>
                          <a:pt x="675" y="701"/>
                        </a:lnTo>
                        <a:lnTo>
                          <a:pt x="678" y="701"/>
                        </a:lnTo>
                        <a:lnTo>
                          <a:pt x="681" y="701"/>
                        </a:lnTo>
                        <a:lnTo>
                          <a:pt x="684" y="701"/>
                        </a:lnTo>
                        <a:lnTo>
                          <a:pt x="687" y="701"/>
                        </a:lnTo>
                        <a:lnTo>
                          <a:pt x="690" y="701"/>
                        </a:lnTo>
                        <a:lnTo>
                          <a:pt x="693" y="701"/>
                        </a:lnTo>
                        <a:lnTo>
                          <a:pt x="696" y="701"/>
                        </a:lnTo>
                        <a:lnTo>
                          <a:pt x="699" y="701"/>
                        </a:lnTo>
                        <a:lnTo>
                          <a:pt x="702" y="701"/>
                        </a:lnTo>
                        <a:lnTo>
                          <a:pt x="705" y="701"/>
                        </a:lnTo>
                        <a:lnTo>
                          <a:pt x="708" y="701"/>
                        </a:lnTo>
                        <a:lnTo>
                          <a:pt x="710" y="701"/>
                        </a:lnTo>
                        <a:lnTo>
                          <a:pt x="713" y="701"/>
                        </a:lnTo>
                        <a:lnTo>
                          <a:pt x="716" y="701"/>
                        </a:lnTo>
                        <a:lnTo>
                          <a:pt x="719" y="701"/>
                        </a:lnTo>
                        <a:lnTo>
                          <a:pt x="722" y="701"/>
                        </a:lnTo>
                        <a:lnTo>
                          <a:pt x="725" y="701"/>
                        </a:lnTo>
                        <a:lnTo>
                          <a:pt x="728" y="701"/>
                        </a:lnTo>
                        <a:lnTo>
                          <a:pt x="731" y="701"/>
                        </a:lnTo>
                        <a:lnTo>
                          <a:pt x="734" y="701"/>
                        </a:lnTo>
                        <a:lnTo>
                          <a:pt x="737" y="701"/>
                        </a:lnTo>
                        <a:lnTo>
                          <a:pt x="740" y="701"/>
                        </a:lnTo>
                        <a:lnTo>
                          <a:pt x="743" y="701"/>
                        </a:lnTo>
                        <a:lnTo>
                          <a:pt x="746" y="701"/>
                        </a:lnTo>
                        <a:lnTo>
                          <a:pt x="749" y="701"/>
                        </a:lnTo>
                        <a:lnTo>
                          <a:pt x="752" y="701"/>
                        </a:lnTo>
                      </a:path>
                    </a:pathLst>
                  </a:custGeom>
                  <a:noFill/>
                  <a:ln w="4763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</p:grpSp>
          <p:grpSp>
            <p:nvGrpSpPr>
              <p:cNvPr id="1197" name="Group 332"/>
              <p:cNvGrpSpPr>
                <a:grpSpLocks noChangeAspect="1"/>
              </p:cNvGrpSpPr>
              <p:nvPr/>
            </p:nvGrpSpPr>
            <p:grpSpPr bwMode="auto">
              <a:xfrm>
                <a:off x="5493699" y="2616944"/>
                <a:ext cx="1528808" cy="1417320"/>
                <a:chOff x="3499" y="2219"/>
                <a:chExt cx="1289" cy="1195"/>
              </a:xfrm>
            </p:grpSpPr>
            <p:grpSp>
              <p:nvGrpSpPr>
                <p:cNvPr id="1198" name="Group 330"/>
                <p:cNvGrpSpPr>
                  <a:grpSpLocks/>
                </p:cNvGrpSpPr>
                <p:nvPr/>
              </p:nvGrpSpPr>
              <p:grpSpPr bwMode="auto">
                <a:xfrm>
                  <a:off x="3499" y="2219"/>
                  <a:ext cx="1289" cy="1195"/>
                  <a:chOff x="3499" y="2219"/>
                  <a:chExt cx="1289" cy="1195"/>
                </a:xfrm>
              </p:grpSpPr>
              <p:sp>
                <p:nvSpPr>
                  <p:cNvPr id="1200" name="Rectangle 250"/>
                  <p:cNvSpPr>
                    <a:spLocks noChangeArrowheads="1"/>
                  </p:cNvSpPr>
                  <p:nvPr/>
                </p:nvSpPr>
                <p:spPr bwMode="auto">
                  <a:xfrm>
                    <a:off x="3637" y="2253"/>
                    <a:ext cx="1032" cy="1032"/>
                  </a:xfrm>
                  <a:prstGeom prst="rect">
                    <a:avLst/>
                  </a:prstGeom>
                  <a:solidFill>
                    <a:srgbClr val="FFFFFF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1201" name="Group 297"/>
                  <p:cNvGrpSpPr>
                    <a:grpSpLocks/>
                  </p:cNvGrpSpPr>
                  <p:nvPr/>
                </p:nvGrpSpPr>
                <p:grpSpPr bwMode="auto">
                  <a:xfrm>
                    <a:off x="3619" y="3283"/>
                    <a:ext cx="1169" cy="131"/>
                    <a:chOff x="3619" y="3283"/>
                    <a:chExt cx="1169" cy="131"/>
                  </a:xfrm>
                </p:grpSpPr>
                <p:sp>
                  <p:nvSpPr>
                    <p:cNvPr id="564" name="Line 25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635" y="3283"/>
                      <a:ext cx="1032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565" name="Group 28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635" y="3287"/>
                      <a:ext cx="1032" cy="24"/>
                      <a:chOff x="3635" y="3287"/>
                      <a:chExt cx="1032" cy="24"/>
                    </a:xfrm>
                  </p:grpSpPr>
                  <p:sp>
                    <p:nvSpPr>
                      <p:cNvPr id="573" name="Line 25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35" y="3287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74" name="Line 25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1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75" name="Line 25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5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48" name="Line 25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8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49" name="Line 25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15" y="3287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0" name="Line 25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3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1" name="Line 25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5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2" name="Line 25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6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3" name="Line 26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79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4" name="Line 26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91" y="3287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5" name="Line 26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7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6" name="Line 26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1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7" name="Line 26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4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8" name="Line 26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71" y="3287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59" name="Line 26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9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0" name="Line 26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1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1" name="Line 26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2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2" name="Line 26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39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3" name="Line 27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51" y="3287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4" name="Line 27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2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6" name="Line 27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7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7" name="Line 27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0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8" name="Line 27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31" y="3287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69" name="Line 27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5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0" name="Line 27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7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1" name="Line 27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83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2" name="Line 27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99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3" name="Line 27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11" y="3287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4" name="Line 28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8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5" name="Line 28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3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6" name="Line 28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6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7" name="Line 28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91" y="3287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8" name="Line 28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11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79" name="Line 28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27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8" name="Line 28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43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29" name="Line 28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55" y="3287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30" name="Line 28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67" y="3287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566" name="Group 29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619" y="3327"/>
                      <a:ext cx="1169" cy="87"/>
                      <a:chOff x="3619" y="3327"/>
                      <a:chExt cx="1169" cy="87"/>
                    </a:xfrm>
                  </p:grpSpPr>
                  <p:sp>
                    <p:nvSpPr>
                      <p:cNvPr id="568" name="Rectangle 29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619" y="3327"/>
                        <a:ext cx="56" cy="7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0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</a:t>
                        </a:r>
                        <a:endParaRPr kumimoji="0" lang="en-US" altLang="en-US" sz="1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9" name="Rectangle 29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59" y="3327"/>
                        <a:ext cx="80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70" name="Rectangle 29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103" y="3327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71" name="Rectangle 29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347" y="3327"/>
                        <a:ext cx="16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72" name="Rectangle 29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587" y="3327"/>
                        <a:ext cx="20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1202" name="Group 329"/>
                  <p:cNvGrpSpPr>
                    <a:grpSpLocks/>
                  </p:cNvGrpSpPr>
                  <p:nvPr/>
                </p:nvGrpSpPr>
                <p:grpSpPr bwMode="auto">
                  <a:xfrm>
                    <a:off x="3499" y="2219"/>
                    <a:ext cx="136" cy="1123"/>
                    <a:chOff x="3499" y="2219"/>
                    <a:chExt cx="136" cy="1123"/>
                  </a:xfrm>
                </p:grpSpPr>
                <p:sp>
                  <p:nvSpPr>
                    <p:cNvPr id="1203" name="Line 298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3635" y="2251"/>
                      <a:ext cx="0" cy="1032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204" name="Group 305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499" y="2219"/>
                      <a:ext cx="121" cy="1123"/>
                      <a:chOff x="3499" y="2219"/>
                      <a:chExt cx="121" cy="1123"/>
                    </a:xfrm>
                  </p:grpSpPr>
                  <p:sp>
                    <p:nvSpPr>
                      <p:cNvPr id="558" name="Rectangle 29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563" y="3255"/>
                        <a:ext cx="40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59" name="Rectangle 30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99" y="3051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0" name="Rectangle 30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99" y="2843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1" name="Rectangle 30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99" y="2635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3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2" name="Rectangle 30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99" y="2427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563" name="Rectangle 30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499" y="2219"/>
                        <a:ext cx="121" cy="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500</a:t>
                        </a:r>
                        <a:endParaRPr kumimoji="0" lang="en-US" altLang="en-US" sz="1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grpSp>
                  <p:nvGrpSpPr>
                    <p:cNvPr id="1205" name="Group 327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611" y="2247"/>
                      <a:ext cx="24" cy="1036"/>
                      <a:chOff x="3611" y="2247"/>
                      <a:chExt cx="24" cy="1036"/>
                    </a:xfrm>
                  </p:grpSpPr>
                  <p:sp>
                    <p:nvSpPr>
                      <p:cNvPr id="1207" name="Line 30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3283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08" name="Line 30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3235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09" name="Line 30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3183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0" name="Line 30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3131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1" name="Line 31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3079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2" name="Line 31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3027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3" name="Line 31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975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4" name="Line 31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923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15" name="Line 31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2871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4" name="Line 31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819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5" name="Line 31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767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6" name="Line 31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715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7" name="Line 31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2663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8" name="Line 31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611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49" name="Line 32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559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0" name="Line 32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507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1" name="Line 32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2455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2" name="Line 32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403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3" name="Line 32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351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4" name="Line 32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27" y="2299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557" name="Line 32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611" y="2247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</p:grpSp>
            </p:grpSp>
            <p:sp>
              <p:nvSpPr>
                <p:cNvPr id="1199" name="Freeform 331"/>
                <p:cNvSpPr>
                  <a:spLocks/>
                </p:cNvSpPr>
                <p:nvPr/>
              </p:nvSpPr>
              <p:spPr bwMode="auto">
                <a:xfrm>
                  <a:off x="3643" y="2959"/>
                  <a:ext cx="1016" cy="320"/>
                </a:xfrm>
                <a:custGeom>
                  <a:avLst/>
                  <a:gdLst>
                    <a:gd name="T0" fmla="*/ 12 w 1016"/>
                    <a:gd name="T1" fmla="*/ 320 h 320"/>
                    <a:gd name="T2" fmla="*/ 32 w 1016"/>
                    <a:gd name="T3" fmla="*/ 320 h 320"/>
                    <a:gd name="T4" fmla="*/ 52 w 1016"/>
                    <a:gd name="T5" fmla="*/ 320 h 320"/>
                    <a:gd name="T6" fmla="*/ 72 w 1016"/>
                    <a:gd name="T7" fmla="*/ 320 h 320"/>
                    <a:gd name="T8" fmla="*/ 92 w 1016"/>
                    <a:gd name="T9" fmla="*/ 316 h 320"/>
                    <a:gd name="T10" fmla="*/ 112 w 1016"/>
                    <a:gd name="T11" fmla="*/ 312 h 320"/>
                    <a:gd name="T12" fmla="*/ 132 w 1016"/>
                    <a:gd name="T13" fmla="*/ 292 h 320"/>
                    <a:gd name="T14" fmla="*/ 152 w 1016"/>
                    <a:gd name="T15" fmla="*/ 244 h 320"/>
                    <a:gd name="T16" fmla="*/ 172 w 1016"/>
                    <a:gd name="T17" fmla="*/ 196 h 320"/>
                    <a:gd name="T18" fmla="*/ 192 w 1016"/>
                    <a:gd name="T19" fmla="*/ 116 h 320"/>
                    <a:gd name="T20" fmla="*/ 212 w 1016"/>
                    <a:gd name="T21" fmla="*/ 48 h 320"/>
                    <a:gd name="T22" fmla="*/ 232 w 1016"/>
                    <a:gd name="T23" fmla="*/ 44 h 320"/>
                    <a:gd name="T24" fmla="*/ 252 w 1016"/>
                    <a:gd name="T25" fmla="*/ 152 h 320"/>
                    <a:gd name="T26" fmla="*/ 272 w 1016"/>
                    <a:gd name="T27" fmla="*/ 272 h 320"/>
                    <a:gd name="T28" fmla="*/ 292 w 1016"/>
                    <a:gd name="T29" fmla="*/ 292 h 320"/>
                    <a:gd name="T30" fmla="*/ 312 w 1016"/>
                    <a:gd name="T31" fmla="*/ 292 h 320"/>
                    <a:gd name="T32" fmla="*/ 332 w 1016"/>
                    <a:gd name="T33" fmla="*/ 280 h 320"/>
                    <a:gd name="T34" fmla="*/ 352 w 1016"/>
                    <a:gd name="T35" fmla="*/ 240 h 320"/>
                    <a:gd name="T36" fmla="*/ 372 w 1016"/>
                    <a:gd name="T37" fmla="*/ 224 h 320"/>
                    <a:gd name="T38" fmla="*/ 392 w 1016"/>
                    <a:gd name="T39" fmla="*/ 168 h 320"/>
                    <a:gd name="T40" fmla="*/ 412 w 1016"/>
                    <a:gd name="T41" fmla="*/ 104 h 320"/>
                    <a:gd name="T42" fmla="*/ 432 w 1016"/>
                    <a:gd name="T43" fmla="*/ 64 h 320"/>
                    <a:gd name="T44" fmla="*/ 452 w 1016"/>
                    <a:gd name="T45" fmla="*/ 36 h 320"/>
                    <a:gd name="T46" fmla="*/ 472 w 1016"/>
                    <a:gd name="T47" fmla="*/ 24 h 320"/>
                    <a:gd name="T48" fmla="*/ 492 w 1016"/>
                    <a:gd name="T49" fmla="*/ 36 h 320"/>
                    <a:gd name="T50" fmla="*/ 512 w 1016"/>
                    <a:gd name="T51" fmla="*/ 0 h 320"/>
                    <a:gd name="T52" fmla="*/ 532 w 1016"/>
                    <a:gd name="T53" fmla="*/ 40 h 320"/>
                    <a:gd name="T54" fmla="*/ 552 w 1016"/>
                    <a:gd name="T55" fmla="*/ 116 h 320"/>
                    <a:gd name="T56" fmla="*/ 572 w 1016"/>
                    <a:gd name="T57" fmla="*/ 196 h 320"/>
                    <a:gd name="T58" fmla="*/ 592 w 1016"/>
                    <a:gd name="T59" fmla="*/ 240 h 320"/>
                    <a:gd name="T60" fmla="*/ 612 w 1016"/>
                    <a:gd name="T61" fmla="*/ 296 h 320"/>
                    <a:gd name="T62" fmla="*/ 632 w 1016"/>
                    <a:gd name="T63" fmla="*/ 316 h 320"/>
                    <a:gd name="T64" fmla="*/ 652 w 1016"/>
                    <a:gd name="T65" fmla="*/ 316 h 320"/>
                    <a:gd name="T66" fmla="*/ 672 w 1016"/>
                    <a:gd name="T67" fmla="*/ 320 h 320"/>
                    <a:gd name="T68" fmla="*/ 692 w 1016"/>
                    <a:gd name="T69" fmla="*/ 320 h 320"/>
                    <a:gd name="T70" fmla="*/ 712 w 1016"/>
                    <a:gd name="T71" fmla="*/ 320 h 320"/>
                    <a:gd name="T72" fmla="*/ 732 w 1016"/>
                    <a:gd name="T73" fmla="*/ 320 h 320"/>
                    <a:gd name="T74" fmla="*/ 752 w 1016"/>
                    <a:gd name="T75" fmla="*/ 320 h 320"/>
                    <a:gd name="T76" fmla="*/ 772 w 1016"/>
                    <a:gd name="T77" fmla="*/ 320 h 320"/>
                    <a:gd name="T78" fmla="*/ 792 w 1016"/>
                    <a:gd name="T79" fmla="*/ 320 h 320"/>
                    <a:gd name="T80" fmla="*/ 812 w 1016"/>
                    <a:gd name="T81" fmla="*/ 320 h 320"/>
                    <a:gd name="T82" fmla="*/ 832 w 1016"/>
                    <a:gd name="T83" fmla="*/ 320 h 320"/>
                    <a:gd name="T84" fmla="*/ 852 w 1016"/>
                    <a:gd name="T85" fmla="*/ 320 h 320"/>
                    <a:gd name="T86" fmla="*/ 872 w 1016"/>
                    <a:gd name="T87" fmla="*/ 320 h 320"/>
                    <a:gd name="T88" fmla="*/ 892 w 1016"/>
                    <a:gd name="T89" fmla="*/ 320 h 320"/>
                    <a:gd name="T90" fmla="*/ 912 w 1016"/>
                    <a:gd name="T91" fmla="*/ 320 h 320"/>
                    <a:gd name="T92" fmla="*/ 932 w 1016"/>
                    <a:gd name="T93" fmla="*/ 320 h 320"/>
                    <a:gd name="T94" fmla="*/ 952 w 1016"/>
                    <a:gd name="T95" fmla="*/ 320 h 320"/>
                    <a:gd name="T96" fmla="*/ 972 w 1016"/>
                    <a:gd name="T97" fmla="*/ 320 h 320"/>
                    <a:gd name="T98" fmla="*/ 992 w 1016"/>
                    <a:gd name="T99" fmla="*/ 320 h 320"/>
                    <a:gd name="T100" fmla="*/ 1012 w 1016"/>
                    <a:gd name="T101" fmla="*/ 320 h 3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1016" h="320">
                      <a:moveTo>
                        <a:pt x="0" y="320"/>
                      </a:moveTo>
                      <a:lnTo>
                        <a:pt x="0" y="316"/>
                      </a:lnTo>
                      <a:lnTo>
                        <a:pt x="4" y="320"/>
                      </a:lnTo>
                      <a:lnTo>
                        <a:pt x="8" y="320"/>
                      </a:lnTo>
                      <a:lnTo>
                        <a:pt x="12" y="320"/>
                      </a:lnTo>
                      <a:lnTo>
                        <a:pt x="16" y="320"/>
                      </a:lnTo>
                      <a:lnTo>
                        <a:pt x="20" y="320"/>
                      </a:lnTo>
                      <a:lnTo>
                        <a:pt x="24" y="320"/>
                      </a:lnTo>
                      <a:lnTo>
                        <a:pt x="28" y="320"/>
                      </a:lnTo>
                      <a:lnTo>
                        <a:pt x="32" y="320"/>
                      </a:lnTo>
                      <a:lnTo>
                        <a:pt x="36" y="320"/>
                      </a:lnTo>
                      <a:lnTo>
                        <a:pt x="40" y="320"/>
                      </a:lnTo>
                      <a:lnTo>
                        <a:pt x="44" y="320"/>
                      </a:lnTo>
                      <a:lnTo>
                        <a:pt x="48" y="320"/>
                      </a:lnTo>
                      <a:lnTo>
                        <a:pt x="52" y="320"/>
                      </a:lnTo>
                      <a:lnTo>
                        <a:pt x="56" y="320"/>
                      </a:lnTo>
                      <a:lnTo>
                        <a:pt x="60" y="320"/>
                      </a:lnTo>
                      <a:lnTo>
                        <a:pt x="64" y="320"/>
                      </a:lnTo>
                      <a:lnTo>
                        <a:pt x="68" y="320"/>
                      </a:lnTo>
                      <a:lnTo>
                        <a:pt x="72" y="320"/>
                      </a:lnTo>
                      <a:lnTo>
                        <a:pt x="76" y="320"/>
                      </a:lnTo>
                      <a:lnTo>
                        <a:pt x="80" y="320"/>
                      </a:lnTo>
                      <a:lnTo>
                        <a:pt x="84" y="320"/>
                      </a:lnTo>
                      <a:lnTo>
                        <a:pt x="88" y="320"/>
                      </a:lnTo>
                      <a:lnTo>
                        <a:pt x="92" y="316"/>
                      </a:lnTo>
                      <a:lnTo>
                        <a:pt x="96" y="316"/>
                      </a:lnTo>
                      <a:lnTo>
                        <a:pt x="100" y="316"/>
                      </a:lnTo>
                      <a:lnTo>
                        <a:pt x="104" y="316"/>
                      </a:lnTo>
                      <a:lnTo>
                        <a:pt x="108" y="312"/>
                      </a:lnTo>
                      <a:lnTo>
                        <a:pt x="112" y="312"/>
                      </a:lnTo>
                      <a:lnTo>
                        <a:pt x="116" y="308"/>
                      </a:lnTo>
                      <a:lnTo>
                        <a:pt x="120" y="304"/>
                      </a:lnTo>
                      <a:lnTo>
                        <a:pt x="124" y="304"/>
                      </a:lnTo>
                      <a:lnTo>
                        <a:pt x="128" y="300"/>
                      </a:lnTo>
                      <a:lnTo>
                        <a:pt x="132" y="292"/>
                      </a:lnTo>
                      <a:lnTo>
                        <a:pt x="136" y="284"/>
                      </a:lnTo>
                      <a:lnTo>
                        <a:pt x="140" y="272"/>
                      </a:lnTo>
                      <a:lnTo>
                        <a:pt x="144" y="264"/>
                      </a:lnTo>
                      <a:lnTo>
                        <a:pt x="148" y="252"/>
                      </a:lnTo>
                      <a:lnTo>
                        <a:pt x="152" y="244"/>
                      </a:lnTo>
                      <a:lnTo>
                        <a:pt x="156" y="236"/>
                      </a:lnTo>
                      <a:lnTo>
                        <a:pt x="160" y="228"/>
                      </a:lnTo>
                      <a:lnTo>
                        <a:pt x="164" y="224"/>
                      </a:lnTo>
                      <a:lnTo>
                        <a:pt x="168" y="212"/>
                      </a:lnTo>
                      <a:lnTo>
                        <a:pt x="172" y="196"/>
                      </a:lnTo>
                      <a:lnTo>
                        <a:pt x="176" y="180"/>
                      </a:lnTo>
                      <a:lnTo>
                        <a:pt x="180" y="164"/>
                      </a:lnTo>
                      <a:lnTo>
                        <a:pt x="184" y="152"/>
                      </a:lnTo>
                      <a:lnTo>
                        <a:pt x="188" y="136"/>
                      </a:lnTo>
                      <a:lnTo>
                        <a:pt x="192" y="116"/>
                      </a:lnTo>
                      <a:lnTo>
                        <a:pt x="196" y="112"/>
                      </a:lnTo>
                      <a:lnTo>
                        <a:pt x="200" y="96"/>
                      </a:lnTo>
                      <a:lnTo>
                        <a:pt x="204" y="64"/>
                      </a:lnTo>
                      <a:lnTo>
                        <a:pt x="208" y="52"/>
                      </a:lnTo>
                      <a:lnTo>
                        <a:pt x="212" y="48"/>
                      </a:lnTo>
                      <a:lnTo>
                        <a:pt x="216" y="32"/>
                      </a:lnTo>
                      <a:lnTo>
                        <a:pt x="220" y="12"/>
                      </a:lnTo>
                      <a:lnTo>
                        <a:pt x="224" y="12"/>
                      </a:lnTo>
                      <a:lnTo>
                        <a:pt x="228" y="36"/>
                      </a:lnTo>
                      <a:lnTo>
                        <a:pt x="232" y="44"/>
                      </a:lnTo>
                      <a:lnTo>
                        <a:pt x="236" y="48"/>
                      </a:lnTo>
                      <a:lnTo>
                        <a:pt x="240" y="72"/>
                      </a:lnTo>
                      <a:lnTo>
                        <a:pt x="244" y="108"/>
                      </a:lnTo>
                      <a:lnTo>
                        <a:pt x="248" y="136"/>
                      </a:lnTo>
                      <a:lnTo>
                        <a:pt x="252" y="152"/>
                      </a:lnTo>
                      <a:lnTo>
                        <a:pt x="256" y="172"/>
                      </a:lnTo>
                      <a:lnTo>
                        <a:pt x="260" y="204"/>
                      </a:lnTo>
                      <a:lnTo>
                        <a:pt x="264" y="232"/>
                      </a:lnTo>
                      <a:lnTo>
                        <a:pt x="268" y="256"/>
                      </a:lnTo>
                      <a:lnTo>
                        <a:pt x="272" y="272"/>
                      </a:lnTo>
                      <a:lnTo>
                        <a:pt x="276" y="276"/>
                      </a:lnTo>
                      <a:lnTo>
                        <a:pt x="280" y="280"/>
                      </a:lnTo>
                      <a:lnTo>
                        <a:pt x="284" y="284"/>
                      </a:lnTo>
                      <a:lnTo>
                        <a:pt x="288" y="288"/>
                      </a:lnTo>
                      <a:lnTo>
                        <a:pt x="292" y="292"/>
                      </a:lnTo>
                      <a:lnTo>
                        <a:pt x="296" y="292"/>
                      </a:lnTo>
                      <a:lnTo>
                        <a:pt x="300" y="292"/>
                      </a:lnTo>
                      <a:lnTo>
                        <a:pt x="304" y="292"/>
                      </a:lnTo>
                      <a:lnTo>
                        <a:pt x="308" y="292"/>
                      </a:lnTo>
                      <a:lnTo>
                        <a:pt x="312" y="292"/>
                      </a:lnTo>
                      <a:lnTo>
                        <a:pt x="316" y="288"/>
                      </a:lnTo>
                      <a:lnTo>
                        <a:pt x="320" y="284"/>
                      </a:lnTo>
                      <a:lnTo>
                        <a:pt x="324" y="280"/>
                      </a:lnTo>
                      <a:lnTo>
                        <a:pt x="328" y="280"/>
                      </a:lnTo>
                      <a:lnTo>
                        <a:pt x="332" y="280"/>
                      </a:lnTo>
                      <a:lnTo>
                        <a:pt x="336" y="276"/>
                      </a:lnTo>
                      <a:lnTo>
                        <a:pt x="340" y="268"/>
                      </a:lnTo>
                      <a:lnTo>
                        <a:pt x="344" y="252"/>
                      </a:lnTo>
                      <a:lnTo>
                        <a:pt x="348" y="244"/>
                      </a:lnTo>
                      <a:lnTo>
                        <a:pt x="352" y="240"/>
                      </a:lnTo>
                      <a:lnTo>
                        <a:pt x="356" y="244"/>
                      </a:lnTo>
                      <a:lnTo>
                        <a:pt x="360" y="248"/>
                      </a:lnTo>
                      <a:lnTo>
                        <a:pt x="364" y="244"/>
                      </a:lnTo>
                      <a:lnTo>
                        <a:pt x="368" y="236"/>
                      </a:lnTo>
                      <a:lnTo>
                        <a:pt x="372" y="224"/>
                      </a:lnTo>
                      <a:lnTo>
                        <a:pt x="376" y="212"/>
                      </a:lnTo>
                      <a:lnTo>
                        <a:pt x="380" y="204"/>
                      </a:lnTo>
                      <a:lnTo>
                        <a:pt x="384" y="196"/>
                      </a:lnTo>
                      <a:lnTo>
                        <a:pt x="388" y="184"/>
                      </a:lnTo>
                      <a:lnTo>
                        <a:pt x="392" y="168"/>
                      </a:lnTo>
                      <a:lnTo>
                        <a:pt x="396" y="148"/>
                      </a:lnTo>
                      <a:lnTo>
                        <a:pt x="400" y="124"/>
                      </a:lnTo>
                      <a:lnTo>
                        <a:pt x="404" y="108"/>
                      </a:lnTo>
                      <a:lnTo>
                        <a:pt x="408" y="108"/>
                      </a:lnTo>
                      <a:lnTo>
                        <a:pt x="412" y="104"/>
                      </a:lnTo>
                      <a:lnTo>
                        <a:pt x="416" y="84"/>
                      </a:lnTo>
                      <a:lnTo>
                        <a:pt x="420" y="72"/>
                      </a:lnTo>
                      <a:lnTo>
                        <a:pt x="424" y="76"/>
                      </a:lnTo>
                      <a:lnTo>
                        <a:pt x="428" y="84"/>
                      </a:lnTo>
                      <a:lnTo>
                        <a:pt x="432" y="64"/>
                      </a:lnTo>
                      <a:lnTo>
                        <a:pt x="436" y="36"/>
                      </a:lnTo>
                      <a:lnTo>
                        <a:pt x="440" y="32"/>
                      </a:lnTo>
                      <a:lnTo>
                        <a:pt x="444" y="40"/>
                      </a:lnTo>
                      <a:lnTo>
                        <a:pt x="448" y="36"/>
                      </a:lnTo>
                      <a:lnTo>
                        <a:pt x="452" y="36"/>
                      </a:lnTo>
                      <a:lnTo>
                        <a:pt x="456" y="36"/>
                      </a:lnTo>
                      <a:lnTo>
                        <a:pt x="460" y="28"/>
                      </a:lnTo>
                      <a:lnTo>
                        <a:pt x="464" y="28"/>
                      </a:lnTo>
                      <a:lnTo>
                        <a:pt x="468" y="28"/>
                      </a:lnTo>
                      <a:lnTo>
                        <a:pt x="472" y="24"/>
                      </a:lnTo>
                      <a:lnTo>
                        <a:pt x="476" y="24"/>
                      </a:lnTo>
                      <a:lnTo>
                        <a:pt x="480" y="24"/>
                      </a:lnTo>
                      <a:lnTo>
                        <a:pt x="484" y="36"/>
                      </a:lnTo>
                      <a:lnTo>
                        <a:pt x="488" y="44"/>
                      </a:lnTo>
                      <a:lnTo>
                        <a:pt x="492" y="36"/>
                      </a:lnTo>
                      <a:lnTo>
                        <a:pt x="496" y="8"/>
                      </a:lnTo>
                      <a:lnTo>
                        <a:pt x="500" y="16"/>
                      </a:lnTo>
                      <a:lnTo>
                        <a:pt x="504" y="28"/>
                      </a:lnTo>
                      <a:lnTo>
                        <a:pt x="508" y="12"/>
                      </a:lnTo>
                      <a:lnTo>
                        <a:pt x="512" y="0"/>
                      </a:lnTo>
                      <a:lnTo>
                        <a:pt x="516" y="24"/>
                      </a:lnTo>
                      <a:lnTo>
                        <a:pt x="520" y="48"/>
                      </a:lnTo>
                      <a:lnTo>
                        <a:pt x="524" y="52"/>
                      </a:lnTo>
                      <a:lnTo>
                        <a:pt x="528" y="48"/>
                      </a:lnTo>
                      <a:lnTo>
                        <a:pt x="532" y="40"/>
                      </a:lnTo>
                      <a:lnTo>
                        <a:pt x="536" y="44"/>
                      </a:lnTo>
                      <a:lnTo>
                        <a:pt x="540" y="64"/>
                      </a:lnTo>
                      <a:lnTo>
                        <a:pt x="544" y="88"/>
                      </a:lnTo>
                      <a:lnTo>
                        <a:pt x="548" y="104"/>
                      </a:lnTo>
                      <a:lnTo>
                        <a:pt x="552" y="116"/>
                      </a:lnTo>
                      <a:lnTo>
                        <a:pt x="556" y="132"/>
                      </a:lnTo>
                      <a:lnTo>
                        <a:pt x="560" y="140"/>
                      </a:lnTo>
                      <a:lnTo>
                        <a:pt x="564" y="152"/>
                      </a:lnTo>
                      <a:lnTo>
                        <a:pt x="568" y="168"/>
                      </a:lnTo>
                      <a:lnTo>
                        <a:pt x="572" y="196"/>
                      </a:lnTo>
                      <a:lnTo>
                        <a:pt x="576" y="216"/>
                      </a:lnTo>
                      <a:lnTo>
                        <a:pt x="580" y="228"/>
                      </a:lnTo>
                      <a:lnTo>
                        <a:pt x="584" y="232"/>
                      </a:lnTo>
                      <a:lnTo>
                        <a:pt x="588" y="232"/>
                      </a:lnTo>
                      <a:lnTo>
                        <a:pt x="592" y="240"/>
                      </a:lnTo>
                      <a:lnTo>
                        <a:pt x="596" y="256"/>
                      </a:lnTo>
                      <a:lnTo>
                        <a:pt x="600" y="272"/>
                      </a:lnTo>
                      <a:lnTo>
                        <a:pt x="604" y="284"/>
                      </a:lnTo>
                      <a:lnTo>
                        <a:pt x="608" y="288"/>
                      </a:lnTo>
                      <a:lnTo>
                        <a:pt x="612" y="296"/>
                      </a:lnTo>
                      <a:lnTo>
                        <a:pt x="616" y="300"/>
                      </a:lnTo>
                      <a:lnTo>
                        <a:pt x="620" y="308"/>
                      </a:lnTo>
                      <a:lnTo>
                        <a:pt x="624" y="312"/>
                      </a:lnTo>
                      <a:lnTo>
                        <a:pt x="628" y="312"/>
                      </a:lnTo>
                      <a:lnTo>
                        <a:pt x="632" y="316"/>
                      </a:lnTo>
                      <a:lnTo>
                        <a:pt x="636" y="316"/>
                      </a:lnTo>
                      <a:lnTo>
                        <a:pt x="640" y="316"/>
                      </a:lnTo>
                      <a:lnTo>
                        <a:pt x="644" y="316"/>
                      </a:lnTo>
                      <a:lnTo>
                        <a:pt x="648" y="316"/>
                      </a:lnTo>
                      <a:lnTo>
                        <a:pt x="652" y="316"/>
                      </a:lnTo>
                      <a:lnTo>
                        <a:pt x="656" y="320"/>
                      </a:lnTo>
                      <a:lnTo>
                        <a:pt x="660" y="320"/>
                      </a:lnTo>
                      <a:lnTo>
                        <a:pt x="664" y="320"/>
                      </a:lnTo>
                      <a:lnTo>
                        <a:pt x="668" y="320"/>
                      </a:lnTo>
                      <a:lnTo>
                        <a:pt x="672" y="320"/>
                      </a:lnTo>
                      <a:lnTo>
                        <a:pt x="676" y="320"/>
                      </a:lnTo>
                      <a:lnTo>
                        <a:pt x="680" y="320"/>
                      </a:lnTo>
                      <a:lnTo>
                        <a:pt x="684" y="320"/>
                      </a:lnTo>
                      <a:lnTo>
                        <a:pt x="688" y="320"/>
                      </a:lnTo>
                      <a:lnTo>
                        <a:pt x="692" y="320"/>
                      </a:lnTo>
                      <a:lnTo>
                        <a:pt x="696" y="320"/>
                      </a:lnTo>
                      <a:lnTo>
                        <a:pt x="700" y="320"/>
                      </a:lnTo>
                      <a:lnTo>
                        <a:pt x="704" y="320"/>
                      </a:lnTo>
                      <a:lnTo>
                        <a:pt x="708" y="320"/>
                      </a:lnTo>
                      <a:lnTo>
                        <a:pt x="712" y="320"/>
                      </a:lnTo>
                      <a:lnTo>
                        <a:pt x="716" y="320"/>
                      </a:lnTo>
                      <a:lnTo>
                        <a:pt x="720" y="320"/>
                      </a:lnTo>
                      <a:lnTo>
                        <a:pt x="724" y="320"/>
                      </a:lnTo>
                      <a:lnTo>
                        <a:pt x="728" y="320"/>
                      </a:lnTo>
                      <a:lnTo>
                        <a:pt x="732" y="320"/>
                      </a:lnTo>
                      <a:lnTo>
                        <a:pt x="736" y="320"/>
                      </a:lnTo>
                      <a:lnTo>
                        <a:pt x="740" y="320"/>
                      </a:lnTo>
                      <a:lnTo>
                        <a:pt x="744" y="320"/>
                      </a:lnTo>
                      <a:lnTo>
                        <a:pt x="748" y="320"/>
                      </a:lnTo>
                      <a:lnTo>
                        <a:pt x="752" y="320"/>
                      </a:lnTo>
                      <a:lnTo>
                        <a:pt x="756" y="320"/>
                      </a:lnTo>
                      <a:lnTo>
                        <a:pt x="760" y="320"/>
                      </a:lnTo>
                      <a:lnTo>
                        <a:pt x="764" y="320"/>
                      </a:lnTo>
                      <a:lnTo>
                        <a:pt x="768" y="320"/>
                      </a:lnTo>
                      <a:lnTo>
                        <a:pt x="772" y="320"/>
                      </a:lnTo>
                      <a:lnTo>
                        <a:pt x="776" y="320"/>
                      </a:lnTo>
                      <a:lnTo>
                        <a:pt x="780" y="320"/>
                      </a:lnTo>
                      <a:lnTo>
                        <a:pt x="784" y="320"/>
                      </a:lnTo>
                      <a:lnTo>
                        <a:pt x="788" y="320"/>
                      </a:lnTo>
                      <a:lnTo>
                        <a:pt x="792" y="320"/>
                      </a:lnTo>
                      <a:lnTo>
                        <a:pt x="796" y="320"/>
                      </a:lnTo>
                      <a:lnTo>
                        <a:pt x="800" y="320"/>
                      </a:lnTo>
                      <a:lnTo>
                        <a:pt x="804" y="320"/>
                      </a:lnTo>
                      <a:lnTo>
                        <a:pt x="808" y="320"/>
                      </a:lnTo>
                      <a:lnTo>
                        <a:pt x="812" y="320"/>
                      </a:lnTo>
                      <a:lnTo>
                        <a:pt x="816" y="320"/>
                      </a:lnTo>
                      <a:lnTo>
                        <a:pt x="820" y="320"/>
                      </a:lnTo>
                      <a:lnTo>
                        <a:pt x="824" y="320"/>
                      </a:lnTo>
                      <a:lnTo>
                        <a:pt x="828" y="320"/>
                      </a:lnTo>
                      <a:lnTo>
                        <a:pt x="832" y="320"/>
                      </a:lnTo>
                      <a:lnTo>
                        <a:pt x="836" y="320"/>
                      </a:lnTo>
                      <a:lnTo>
                        <a:pt x="840" y="320"/>
                      </a:lnTo>
                      <a:lnTo>
                        <a:pt x="844" y="320"/>
                      </a:lnTo>
                      <a:lnTo>
                        <a:pt x="848" y="320"/>
                      </a:lnTo>
                      <a:lnTo>
                        <a:pt x="852" y="320"/>
                      </a:lnTo>
                      <a:lnTo>
                        <a:pt x="856" y="320"/>
                      </a:lnTo>
                      <a:lnTo>
                        <a:pt x="860" y="320"/>
                      </a:lnTo>
                      <a:lnTo>
                        <a:pt x="864" y="320"/>
                      </a:lnTo>
                      <a:lnTo>
                        <a:pt x="868" y="320"/>
                      </a:lnTo>
                      <a:lnTo>
                        <a:pt x="872" y="320"/>
                      </a:lnTo>
                      <a:lnTo>
                        <a:pt x="876" y="320"/>
                      </a:lnTo>
                      <a:lnTo>
                        <a:pt x="880" y="320"/>
                      </a:lnTo>
                      <a:lnTo>
                        <a:pt x="884" y="320"/>
                      </a:lnTo>
                      <a:lnTo>
                        <a:pt x="888" y="320"/>
                      </a:lnTo>
                      <a:lnTo>
                        <a:pt x="892" y="320"/>
                      </a:lnTo>
                      <a:lnTo>
                        <a:pt x="896" y="320"/>
                      </a:lnTo>
                      <a:lnTo>
                        <a:pt x="900" y="320"/>
                      </a:lnTo>
                      <a:lnTo>
                        <a:pt x="904" y="320"/>
                      </a:lnTo>
                      <a:lnTo>
                        <a:pt x="908" y="320"/>
                      </a:lnTo>
                      <a:lnTo>
                        <a:pt x="912" y="320"/>
                      </a:lnTo>
                      <a:lnTo>
                        <a:pt x="916" y="320"/>
                      </a:lnTo>
                      <a:lnTo>
                        <a:pt x="920" y="320"/>
                      </a:lnTo>
                      <a:lnTo>
                        <a:pt x="924" y="320"/>
                      </a:lnTo>
                      <a:lnTo>
                        <a:pt x="928" y="320"/>
                      </a:lnTo>
                      <a:lnTo>
                        <a:pt x="932" y="320"/>
                      </a:lnTo>
                      <a:lnTo>
                        <a:pt x="936" y="320"/>
                      </a:lnTo>
                      <a:lnTo>
                        <a:pt x="940" y="320"/>
                      </a:lnTo>
                      <a:lnTo>
                        <a:pt x="944" y="320"/>
                      </a:lnTo>
                      <a:lnTo>
                        <a:pt x="948" y="320"/>
                      </a:lnTo>
                      <a:lnTo>
                        <a:pt x="952" y="320"/>
                      </a:lnTo>
                      <a:lnTo>
                        <a:pt x="956" y="320"/>
                      </a:lnTo>
                      <a:lnTo>
                        <a:pt x="960" y="320"/>
                      </a:lnTo>
                      <a:lnTo>
                        <a:pt x="964" y="320"/>
                      </a:lnTo>
                      <a:lnTo>
                        <a:pt x="968" y="320"/>
                      </a:lnTo>
                      <a:lnTo>
                        <a:pt x="972" y="320"/>
                      </a:lnTo>
                      <a:lnTo>
                        <a:pt x="976" y="320"/>
                      </a:lnTo>
                      <a:lnTo>
                        <a:pt x="980" y="320"/>
                      </a:lnTo>
                      <a:lnTo>
                        <a:pt x="984" y="320"/>
                      </a:lnTo>
                      <a:lnTo>
                        <a:pt x="988" y="320"/>
                      </a:lnTo>
                      <a:lnTo>
                        <a:pt x="992" y="320"/>
                      </a:lnTo>
                      <a:lnTo>
                        <a:pt x="996" y="320"/>
                      </a:lnTo>
                      <a:lnTo>
                        <a:pt x="1000" y="320"/>
                      </a:lnTo>
                      <a:lnTo>
                        <a:pt x="1004" y="320"/>
                      </a:lnTo>
                      <a:lnTo>
                        <a:pt x="1008" y="320"/>
                      </a:lnTo>
                      <a:lnTo>
                        <a:pt x="1012" y="320"/>
                      </a:lnTo>
                      <a:lnTo>
                        <a:pt x="1016" y="32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  <p:grpSp>
            <p:nvGrpSpPr>
              <p:cNvPr id="2549" name="Group 166"/>
              <p:cNvGrpSpPr>
                <a:grpSpLocks noChangeAspect="1"/>
              </p:cNvGrpSpPr>
              <p:nvPr/>
            </p:nvGrpSpPr>
            <p:grpSpPr bwMode="auto">
              <a:xfrm>
                <a:off x="7143642" y="2618258"/>
                <a:ext cx="1544440" cy="1426552"/>
                <a:chOff x="4020" y="2220"/>
                <a:chExt cx="1297" cy="1198"/>
              </a:xfrm>
            </p:grpSpPr>
            <p:grpSp>
              <p:nvGrpSpPr>
                <p:cNvPr id="2550" name="Group 164"/>
                <p:cNvGrpSpPr>
                  <a:grpSpLocks/>
                </p:cNvGrpSpPr>
                <p:nvPr/>
              </p:nvGrpSpPr>
              <p:grpSpPr bwMode="auto">
                <a:xfrm>
                  <a:off x="4020" y="2220"/>
                  <a:ext cx="1297" cy="1198"/>
                  <a:chOff x="4020" y="2220"/>
                  <a:chExt cx="1297" cy="1198"/>
                </a:xfrm>
              </p:grpSpPr>
              <p:sp>
                <p:nvSpPr>
                  <p:cNvPr id="2552" name="Rectangle 84"/>
                  <p:cNvSpPr>
                    <a:spLocks noChangeArrowheads="1"/>
                  </p:cNvSpPr>
                  <p:nvPr/>
                </p:nvSpPr>
                <p:spPr bwMode="auto">
                  <a:xfrm>
                    <a:off x="4158" y="2254"/>
                    <a:ext cx="1032" cy="1032"/>
                  </a:xfrm>
                  <a:prstGeom prst="rect">
                    <a:avLst/>
                  </a:prstGeom>
                  <a:solidFill>
                    <a:srgbClr val="FFFFFF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2553" name="Group 131"/>
                  <p:cNvGrpSpPr>
                    <a:grpSpLocks/>
                  </p:cNvGrpSpPr>
                  <p:nvPr/>
                </p:nvGrpSpPr>
                <p:grpSpPr bwMode="auto">
                  <a:xfrm>
                    <a:off x="4140" y="3284"/>
                    <a:ext cx="1177" cy="134"/>
                    <a:chOff x="4140" y="3284"/>
                    <a:chExt cx="1177" cy="134"/>
                  </a:xfrm>
                </p:grpSpPr>
                <p:sp>
                  <p:nvSpPr>
                    <p:cNvPr id="699" name="Line 8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4156" y="3284"/>
                      <a:ext cx="1032" cy="0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700" name="Group 123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156" y="3288"/>
                      <a:ext cx="1032" cy="24"/>
                      <a:chOff x="4156" y="3288"/>
                      <a:chExt cx="1032" cy="24"/>
                    </a:xfrm>
                  </p:grpSpPr>
                  <p:sp>
                    <p:nvSpPr>
                      <p:cNvPr id="1194" name="Line 8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56" y="328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95" name="Line 8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3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96" name="Line 8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7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206" name="Line 8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0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0" name="Line 9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36" y="3288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1" name="Line 9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5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2" name="Line 9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7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3" name="Line 9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8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4" name="Line 9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00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5" name="Line 9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12" y="328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6" name="Line 9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9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7" name="Line 9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3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8" name="Line 9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6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9" name="Line 9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92" y="3288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0" name="Line 10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1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1" name="Line 10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3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2" name="Line 10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4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3" name="Line 10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60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4" name="Line 10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72" y="328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5" name="Line 10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4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6" name="Line 10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9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7" name="Line 10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2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8" name="Line 10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52" y="3288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79" name="Line 10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7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0" name="Line 11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9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1" name="Line 11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904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2" name="Line 11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920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3" name="Line 11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932" y="328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4" name="Line 11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00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5" name="Line 11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05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6" name="Line 11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08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7" name="Line 11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12" y="3288"/>
                        <a:ext cx="0" cy="16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8" name="Line 11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32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9" name="Line 11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48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90" name="Line 12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64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91" name="Line 12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76" y="3288"/>
                        <a:ext cx="0" cy="8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92" name="Line 12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88" y="3288"/>
                        <a:ext cx="0" cy="24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701" name="Group 12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140" y="3328"/>
                      <a:ext cx="1177" cy="90"/>
                      <a:chOff x="4140" y="3328"/>
                      <a:chExt cx="1177" cy="90"/>
                    </a:xfrm>
                  </p:grpSpPr>
                  <p:sp>
                    <p:nvSpPr>
                      <p:cNvPr id="703" name="Rectangle 12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140" y="3328"/>
                        <a:ext cx="42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90" name="Rectangle 12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380" y="3328"/>
                        <a:ext cx="83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91" name="Rectangle 12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24" y="3328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92" name="Rectangle 12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868" y="3328"/>
                        <a:ext cx="167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1193" name="Rectangle 12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108" y="3328"/>
                        <a:ext cx="209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2554" name="Group 163"/>
                  <p:cNvGrpSpPr>
                    <a:grpSpLocks/>
                  </p:cNvGrpSpPr>
                  <p:nvPr/>
                </p:nvGrpSpPr>
                <p:grpSpPr bwMode="auto">
                  <a:xfrm>
                    <a:off x="4020" y="2220"/>
                    <a:ext cx="136" cy="1126"/>
                    <a:chOff x="4020" y="2220"/>
                    <a:chExt cx="136" cy="1126"/>
                  </a:xfrm>
                </p:grpSpPr>
                <p:sp>
                  <p:nvSpPr>
                    <p:cNvPr id="2555" name="Line 13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156" y="2252"/>
                      <a:ext cx="0" cy="1032"/>
                    </a:xfrm>
                    <a:prstGeom prst="line">
                      <a:avLst/>
                    </a:prstGeom>
                    <a:noFill/>
                    <a:ln w="6350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556" name="Group 13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020" y="2220"/>
                      <a:ext cx="125" cy="1126"/>
                      <a:chOff x="4020" y="2220"/>
                      <a:chExt cx="125" cy="1126"/>
                    </a:xfrm>
                  </p:grpSpPr>
                  <p:sp>
                    <p:nvSpPr>
                      <p:cNvPr id="693" name="Rectangle 1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84" y="3256"/>
                        <a:ext cx="42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94" name="Rectangle 1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20" y="3052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95" name="Rectangle 1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20" y="2844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96" name="Rectangle 1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20" y="2636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3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97" name="Rectangle 1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20" y="2428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8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698" name="Rectangle 13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020" y="2220"/>
                        <a:ext cx="125" cy="9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7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500</a:t>
                        </a:r>
                        <a:endParaRPr kumimoji="0" lang="en-US" altLang="en-US" sz="1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grpSp>
                  <p:nvGrpSpPr>
                    <p:cNvPr id="2557" name="Group 16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4132" y="2248"/>
                      <a:ext cx="24" cy="1036"/>
                      <a:chOff x="4132" y="2248"/>
                      <a:chExt cx="24" cy="1036"/>
                    </a:xfrm>
                  </p:grpSpPr>
                  <p:sp>
                    <p:nvSpPr>
                      <p:cNvPr id="2559" name="Line 14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328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2" name="Line 14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323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3" name="Line 14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318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4" name="Line 14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313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5" name="Line 14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3080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6" name="Line 14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302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7" name="Line 14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97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8" name="Line 14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92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9" name="Line 14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2872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0" name="Line 14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82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1" name="Line 15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76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3" name="Line 15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716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4" name="Line 15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2664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5" name="Line 15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61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6" name="Line 15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56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7" name="Line 15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508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8" name="Line 15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2456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89" name="Line 15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404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90" name="Line 15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352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91" name="Line 15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48" y="2300"/>
                        <a:ext cx="8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92" name="Line 16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4132" y="2248"/>
                        <a:ext cx="24" cy="0"/>
                      </a:xfrm>
                      <a:prstGeom prst="line">
                        <a:avLst/>
                      </a:prstGeom>
                      <a:noFill/>
                      <a:ln w="6350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</p:grpSp>
            </p:grpSp>
            <p:sp>
              <p:nvSpPr>
                <p:cNvPr id="2551" name="Freeform 165"/>
                <p:cNvSpPr>
                  <a:spLocks/>
                </p:cNvSpPr>
                <p:nvPr/>
              </p:nvSpPr>
              <p:spPr bwMode="auto">
                <a:xfrm>
                  <a:off x="4164" y="2808"/>
                  <a:ext cx="1016" cy="472"/>
                </a:xfrm>
                <a:custGeom>
                  <a:avLst/>
                  <a:gdLst>
                    <a:gd name="T0" fmla="*/ 12 w 1016"/>
                    <a:gd name="T1" fmla="*/ 472 h 472"/>
                    <a:gd name="T2" fmla="*/ 32 w 1016"/>
                    <a:gd name="T3" fmla="*/ 472 h 472"/>
                    <a:gd name="T4" fmla="*/ 52 w 1016"/>
                    <a:gd name="T5" fmla="*/ 472 h 472"/>
                    <a:gd name="T6" fmla="*/ 72 w 1016"/>
                    <a:gd name="T7" fmla="*/ 472 h 472"/>
                    <a:gd name="T8" fmla="*/ 92 w 1016"/>
                    <a:gd name="T9" fmla="*/ 472 h 472"/>
                    <a:gd name="T10" fmla="*/ 112 w 1016"/>
                    <a:gd name="T11" fmla="*/ 472 h 472"/>
                    <a:gd name="T12" fmla="*/ 132 w 1016"/>
                    <a:gd name="T13" fmla="*/ 472 h 472"/>
                    <a:gd name="T14" fmla="*/ 152 w 1016"/>
                    <a:gd name="T15" fmla="*/ 472 h 472"/>
                    <a:gd name="T16" fmla="*/ 172 w 1016"/>
                    <a:gd name="T17" fmla="*/ 472 h 472"/>
                    <a:gd name="T18" fmla="*/ 192 w 1016"/>
                    <a:gd name="T19" fmla="*/ 468 h 472"/>
                    <a:gd name="T20" fmla="*/ 212 w 1016"/>
                    <a:gd name="T21" fmla="*/ 468 h 472"/>
                    <a:gd name="T22" fmla="*/ 232 w 1016"/>
                    <a:gd name="T23" fmla="*/ 468 h 472"/>
                    <a:gd name="T24" fmla="*/ 252 w 1016"/>
                    <a:gd name="T25" fmla="*/ 468 h 472"/>
                    <a:gd name="T26" fmla="*/ 272 w 1016"/>
                    <a:gd name="T27" fmla="*/ 468 h 472"/>
                    <a:gd name="T28" fmla="*/ 292 w 1016"/>
                    <a:gd name="T29" fmla="*/ 460 h 472"/>
                    <a:gd name="T30" fmla="*/ 312 w 1016"/>
                    <a:gd name="T31" fmla="*/ 452 h 472"/>
                    <a:gd name="T32" fmla="*/ 332 w 1016"/>
                    <a:gd name="T33" fmla="*/ 436 h 472"/>
                    <a:gd name="T34" fmla="*/ 352 w 1016"/>
                    <a:gd name="T35" fmla="*/ 432 h 472"/>
                    <a:gd name="T36" fmla="*/ 372 w 1016"/>
                    <a:gd name="T37" fmla="*/ 380 h 472"/>
                    <a:gd name="T38" fmla="*/ 392 w 1016"/>
                    <a:gd name="T39" fmla="*/ 300 h 472"/>
                    <a:gd name="T40" fmla="*/ 412 w 1016"/>
                    <a:gd name="T41" fmla="*/ 184 h 472"/>
                    <a:gd name="T42" fmla="*/ 432 w 1016"/>
                    <a:gd name="T43" fmla="*/ 60 h 472"/>
                    <a:gd name="T44" fmla="*/ 452 w 1016"/>
                    <a:gd name="T45" fmla="*/ 8 h 472"/>
                    <a:gd name="T46" fmla="*/ 472 w 1016"/>
                    <a:gd name="T47" fmla="*/ 16 h 472"/>
                    <a:gd name="T48" fmla="*/ 492 w 1016"/>
                    <a:gd name="T49" fmla="*/ 44 h 472"/>
                    <a:gd name="T50" fmla="*/ 512 w 1016"/>
                    <a:gd name="T51" fmla="*/ 68 h 472"/>
                    <a:gd name="T52" fmla="*/ 532 w 1016"/>
                    <a:gd name="T53" fmla="*/ 64 h 472"/>
                    <a:gd name="T54" fmla="*/ 552 w 1016"/>
                    <a:gd name="T55" fmla="*/ 132 h 472"/>
                    <a:gd name="T56" fmla="*/ 572 w 1016"/>
                    <a:gd name="T57" fmla="*/ 240 h 472"/>
                    <a:gd name="T58" fmla="*/ 592 w 1016"/>
                    <a:gd name="T59" fmla="*/ 364 h 472"/>
                    <a:gd name="T60" fmla="*/ 612 w 1016"/>
                    <a:gd name="T61" fmla="*/ 436 h 472"/>
                    <a:gd name="T62" fmla="*/ 632 w 1016"/>
                    <a:gd name="T63" fmla="*/ 456 h 472"/>
                    <a:gd name="T64" fmla="*/ 652 w 1016"/>
                    <a:gd name="T65" fmla="*/ 468 h 472"/>
                    <a:gd name="T66" fmla="*/ 672 w 1016"/>
                    <a:gd name="T67" fmla="*/ 472 h 472"/>
                    <a:gd name="T68" fmla="*/ 692 w 1016"/>
                    <a:gd name="T69" fmla="*/ 472 h 472"/>
                    <a:gd name="T70" fmla="*/ 712 w 1016"/>
                    <a:gd name="T71" fmla="*/ 472 h 472"/>
                    <a:gd name="T72" fmla="*/ 732 w 1016"/>
                    <a:gd name="T73" fmla="*/ 472 h 472"/>
                    <a:gd name="T74" fmla="*/ 752 w 1016"/>
                    <a:gd name="T75" fmla="*/ 472 h 472"/>
                    <a:gd name="T76" fmla="*/ 772 w 1016"/>
                    <a:gd name="T77" fmla="*/ 472 h 472"/>
                    <a:gd name="T78" fmla="*/ 792 w 1016"/>
                    <a:gd name="T79" fmla="*/ 472 h 472"/>
                    <a:gd name="T80" fmla="*/ 812 w 1016"/>
                    <a:gd name="T81" fmla="*/ 472 h 472"/>
                    <a:gd name="T82" fmla="*/ 832 w 1016"/>
                    <a:gd name="T83" fmla="*/ 472 h 472"/>
                    <a:gd name="T84" fmla="*/ 852 w 1016"/>
                    <a:gd name="T85" fmla="*/ 472 h 472"/>
                    <a:gd name="T86" fmla="*/ 872 w 1016"/>
                    <a:gd name="T87" fmla="*/ 472 h 472"/>
                    <a:gd name="T88" fmla="*/ 892 w 1016"/>
                    <a:gd name="T89" fmla="*/ 472 h 472"/>
                    <a:gd name="T90" fmla="*/ 912 w 1016"/>
                    <a:gd name="T91" fmla="*/ 472 h 472"/>
                    <a:gd name="T92" fmla="*/ 932 w 1016"/>
                    <a:gd name="T93" fmla="*/ 472 h 472"/>
                    <a:gd name="T94" fmla="*/ 952 w 1016"/>
                    <a:gd name="T95" fmla="*/ 472 h 472"/>
                    <a:gd name="T96" fmla="*/ 972 w 1016"/>
                    <a:gd name="T97" fmla="*/ 472 h 472"/>
                    <a:gd name="T98" fmla="*/ 992 w 1016"/>
                    <a:gd name="T99" fmla="*/ 472 h 472"/>
                    <a:gd name="T100" fmla="*/ 1012 w 1016"/>
                    <a:gd name="T101" fmla="*/ 472 h 4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  <a:cxn ang="0">
                      <a:pos x="T16" y="T17"/>
                    </a:cxn>
                    <a:cxn ang="0">
                      <a:pos x="T18" y="T19"/>
                    </a:cxn>
                    <a:cxn ang="0">
                      <a:pos x="T20" y="T21"/>
                    </a:cxn>
                    <a:cxn ang="0">
                      <a:pos x="T22" y="T23"/>
                    </a:cxn>
                    <a:cxn ang="0">
                      <a:pos x="T24" y="T25"/>
                    </a:cxn>
                    <a:cxn ang="0">
                      <a:pos x="T26" y="T27"/>
                    </a:cxn>
                    <a:cxn ang="0">
                      <a:pos x="T28" y="T29"/>
                    </a:cxn>
                    <a:cxn ang="0">
                      <a:pos x="T30" y="T31"/>
                    </a:cxn>
                    <a:cxn ang="0">
                      <a:pos x="T32" y="T33"/>
                    </a:cxn>
                    <a:cxn ang="0">
                      <a:pos x="T34" y="T35"/>
                    </a:cxn>
                    <a:cxn ang="0">
                      <a:pos x="T36" y="T37"/>
                    </a:cxn>
                    <a:cxn ang="0">
                      <a:pos x="T38" y="T39"/>
                    </a:cxn>
                    <a:cxn ang="0">
                      <a:pos x="T40" y="T41"/>
                    </a:cxn>
                    <a:cxn ang="0">
                      <a:pos x="T42" y="T43"/>
                    </a:cxn>
                    <a:cxn ang="0">
                      <a:pos x="T44" y="T45"/>
                    </a:cxn>
                    <a:cxn ang="0">
                      <a:pos x="T46" y="T47"/>
                    </a:cxn>
                    <a:cxn ang="0">
                      <a:pos x="T48" y="T49"/>
                    </a:cxn>
                    <a:cxn ang="0">
                      <a:pos x="T50" y="T51"/>
                    </a:cxn>
                    <a:cxn ang="0">
                      <a:pos x="T52" y="T53"/>
                    </a:cxn>
                    <a:cxn ang="0">
                      <a:pos x="T54" y="T55"/>
                    </a:cxn>
                    <a:cxn ang="0">
                      <a:pos x="T56" y="T57"/>
                    </a:cxn>
                    <a:cxn ang="0">
                      <a:pos x="T58" y="T59"/>
                    </a:cxn>
                    <a:cxn ang="0">
                      <a:pos x="T60" y="T61"/>
                    </a:cxn>
                    <a:cxn ang="0">
                      <a:pos x="T62" y="T63"/>
                    </a:cxn>
                    <a:cxn ang="0">
                      <a:pos x="T64" y="T65"/>
                    </a:cxn>
                    <a:cxn ang="0">
                      <a:pos x="T66" y="T67"/>
                    </a:cxn>
                    <a:cxn ang="0">
                      <a:pos x="T68" y="T69"/>
                    </a:cxn>
                    <a:cxn ang="0">
                      <a:pos x="T70" y="T71"/>
                    </a:cxn>
                    <a:cxn ang="0">
                      <a:pos x="T72" y="T73"/>
                    </a:cxn>
                    <a:cxn ang="0">
                      <a:pos x="T74" y="T75"/>
                    </a:cxn>
                    <a:cxn ang="0">
                      <a:pos x="T76" y="T77"/>
                    </a:cxn>
                    <a:cxn ang="0">
                      <a:pos x="T78" y="T79"/>
                    </a:cxn>
                    <a:cxn ang="0">
                      <a:pos x="T80" y="T81"/>
                    </a:cxn>
                    <a:cxn ang="0">
                      <a:pos x="T82" y="T83"/>
                    </a:cxn>
                    <a:cxn ang="0">
                      <a:pos x="T84" y="T85"/>
                    </a:cxn>
                    <a:cxn ang="0">
                      <a:pos x="T86" y="T87"/>
                    </a:cxn>
                    <a:cxn ang="0">
                      <a:pos x="T88" y="T89"/>
                    </a:cxn>
                    <a:cxn ang="0">
                      <a:pos x="T90" y="T91"/>
                    </a:cxn>
                    <a:cxn ang="0">
                      <a:pos x="T92" y="T93"/>
                    </a:cxn>
                    <a:cxn ang="0">
                      <a:pos x="T94" y="T95"/>
                    </a:cxn>
                    <a:cxn ang="0">
                      <a:pos x="T96" y="T97"/>
                    </a:cxn>
                    <a:cxn ang="0">
                      <a:pos x="T98" y="T99"/>
                    </a:cxn>
                    <a:cxn ang="0">
                      <a:pos x="T100" y="T101"/>
                    </a:cxn>
                  </a:cxnLst>
                  <a:rect l="0" t="0" r="r" b="b"/>
                  <a:pathLst>
                    <a:path w="1016" h="472">
                      <a:moveTo>
                        <a:pt x="0" y="472"/>
                      </a:moveTo>
                      <a:lnTo>
                        <a:pt x="0" y="468"/>
                      </a:lnTo>
                      <a:lnTo>
                        <a:pt x="4" y="472"/>
                      </a:lnTo>
                      <a:lnTo>
                        <a:pt x="8" y="472"/>
                      </a:lnTo>
                      <a:lnTo>
                        <a:pt x="12" y="472"/>
                      </a:lnTo>
                      <a:lnTo>
                        <a:pt x="16" y="472"/>
                      </a:lnTo>
                      <a:lnTo>
                        <a:pt x="20" y="472"/>
                      </a:lnTo>
                      <a:lnTo>
                        <a:pt x="24" y="472"/>
                      </a:lnTo>
                      <a:lnTo>
                        <a:pt x="28" y="472"/>
                      </a:lnTo>
                      <a:lnTo>
                        <a:pt x="32" y="472"/>
                      </a:lnTo>
                      <a:lnTo>
                        <a:pt x="36" y="472"/>
                      </a:lnTo>
                      <a:lnTo>
                        <a:pt x="40" y="472"/>
                      </a:lnTo>
                      <a:lnTo>
                        <a:pt x="44" y="472"/>
                      </a:lnTo>
                      <a:lnTo>
                        <a:pt x="48" y="472"/>
                      </a:lnTo>
                      <a:lnTo>
                        <a:pt x="52" y="472"/>
                      </a:lnTo>
                      <a:lnTo>
                        <a:pt x="56" y="472"/>
                      </a:lnTo>
                      <a:lnTo>
                        <a:pt x="60" y="472"/>
                      </a:lnTo>
                      <a:lnTo>
                        <a:pt x="64" y="472"/>
                      </a:lnTo>
                      <a:lnTo>
                        <a:pt x="68" y="472"/>
                      </a:lnTo>
                      <a:lnTo>
                        <a:pt x="72" y="472"/>
                      </a:lnTo>
                      <a:lnTo>
                        <a:pt x="76" y="472"/>
                      </a:lnTo>
                      <a:lnTo>
                        <a:pt x="80" y="472"/>
                      </a:lnTo>
                      <a:lnTo>
                        <a:pt x="84" y="472"/>
                      </a:lnTo>
                      <a:lnTo>
                        <a:pt x="88" y="472"/>
                      </a:lnTo>
                      <a:lnTo>
                        <a:pt x="92" y="472"/>
                      </a:lnTo>
                      <a:lnTo>
                        <a:pt x="96" y="472"/>
                      </a:lnTo>
                      <a:lnTo>
                        <a:pt x="100" y="472"/>
                      </a:lnTo>
                      <a:lnTo>
                        <a:pt x="104" y="472"/>
                      </a:lnTo>
                      <a:lnTo>
                        <a:pt x="108" y="472"/>
                      </a:lnTo>
                      <a:lnTo>
                        <a:pt x="112" y="472"/>
                      </a:lnTo>
                      <a:lnTo>
                        <a:pt x="116" y="472"/>
                      </a:lnTo>
                      <a:lnTo>
                        <a:pt x="120" y="472"/>
                      </a:lnTo>
                      <a:lnTo>
                        <a:pt x="124" y="472"/>
                      </a:lnTo>
                      <a:lnTo>
                        <a:pt x="128" y="472"/>
                      </a:lnTo>
                      <a:lnTo>
                        <a:pt x="132" y="472"/>
                      </a:lnTo>
                      <a:lnTo>
                        <a:pt x="136" y="472"/>
                      </a:lnTo>
                      <a:lnTo>
                        <a:pt x="140" y="472"/>
                      </a:lnTo>
                      <a:lnTo>
                        <a:pt x="144" y="472"/>
                      </a:lnTo>
                      <a:lnTo>
                        <a:pt x="148" y="472"/>
                      </a:lnTo>
                      <a:lnTo>
                        <a:pt x="152" y="472"/>
                      </a:lnTo>
                      <a:lnTo>
                        <a:pt x="156" y="472"/>
                      </a:lnTo>
                      <a:lnTo>
                        <a:pt x="160" y="472"/>
                      </a:lnTo>
                      <a:lnTo>
                        <a:pt x="164" y="472"/>
                      </a:lnTo>
                      <a:lnTo>
                        <a:pt x="168" y="472"/>
                      </a:lnTo>
                      <a:lnTo>
                        <a:pt x="172" y="472"/>
                      </a:lnTo>
                      <a:lnTo>
                        <a:pt x="176" y="472"/>
                      </a:lnTo>
                      <a:lnTo>
                        <a:pt x="180" y="472"/>
                      </a:lnTo>
                      <a:lnTo>
                        <a:pt x="184" y="472"/>
                      </a:lnTo>
                      <a:lnTo>
                        <a:pt x="188" y="472"/>
                      </a:lnTo>
                      <a:lnTo>
                        <a:pt x="192" y="468"/>
                      </a:lnTo>
                      <a:lnTo>
                        <a:pt x="196" y="468"/>
                      </a:lnTo>
                      <a:lnTo>
                        <a:pt x="200" y="468"/>
                      </a:lnTo>
                      <a:lnTo>
                        <a:pt x="204" y="468"/>
                      </a:lnTo>
                      <a:lnTo>
                        <a:pt x="208" y="468"/>
                      </a:lnTo>
                      <a:lnTo>
                        <a:pt x="212" y="468"/>
                      </a:lnTo>
                      <a:lnTo>
                        <a:pt x="216" y="468"/>
                      </a:lnTo>
                      <a:lnTo>
                        <a:pt x="220" y="468"/>
                      </a:lnTo>
                      <a:lnTo>
                        <a:pt x="224" y="468"/>
                      </a:lnTo>
                      <a:lnTo>
                        <a:pt x="228" y="468"/>
                      </a:lnTo>
                      <a:lnTo>
                        <a:pt x="232" y="468"/>
                      </a:lnTo>
                      <a:lnTo>
                        <a:pt x="236" y="464"/>
                      </a:lnTo>
                      <a:lnTo>
                        <a:pt x="240" y="464"/>
                      </a:lnTo>
                      <a:lnTo>
                        <a:pt x="244" y="464"/>
                      </a:lnTo>
                      <a:lnTo>
                        <a:pt x="248" y="468"/>
                      </a:lnTo>
                      <a:lnTo>
                        <a:pt x="252" y="468"/>
                      </a:lnTo>
                      <a:lnTo>
                        <a:pt x="256" y="468"/>
                      </a:lnTo>
                      <a:lnTo>
                        <a:pt x="260" y="468"/>
                      </a:lnTo>
                      <a:lnTo>
                        <a:pt x="264" y="468"/>
                      </a:lnTo>
                      <a:lnTo>
                        <a:pt x="268" y="468"/>
                      </a:lnTo>
                      <a:lnTo>
                        <a:pt x="272" y="468"/>
                      </a:lnTo>
                      <a:lnTo>
                        <a:pt x="276" y="468"/>
                      </a:lnTo>
                      <a:lnTo>
                        <a:pt x="280" y="468"/>
                      </a:lnTo>
                      <a:lnTo>
                        <a:pt x="284" y="464"/>
                      </a:lnTo>
                      <a:lnTo>
                        <a:pt x="288" y="464"/>
                      </a:lnTo>
                      <a:lnTo>
                        <a:pt x="292" y="460"/>
                      </a:lnTo>
                      <a:lnTo>
                        <a:pt x="296" y="460"/>
                      </a:lnTo>
                      <a:lnTo>
                        <a:pt x="300" y="456"/>
                      </a:lnTo>
                      <a:lnTo>
                        <a:pt x="304" y="456"/>
                      </a:lnTo>
                      <a:lnTo>
                        <a:pt x="308" y="456"/>
                      </a:lnTo>
                      <a:lnTo>
                        <a:pt x="312" y="452"/>
                      </a:lnTo>
                      <a:lnTo>
                        <a:pt x="316" y="448"/>
                      </a:lnTo>
                      <a:lnTo>
                        <a:pt x="320" y="444"/>
                      </a:lnTo>
                      <a:lnTo>
                        <a:pt x="324" y="440"/>
                      </a:lnTo>
                      <a:lnTo>
                        <a:pt x="328" y="436"/>
                      </a:lnTo>
                      <a:lnTo>
                        <a:pt x="332" y="436"/>
                      </a:lnTo>
                      <a:lnTo>
                        <a:pt x="336" y="436"/>
                      </a:lnTo>
                      <a:lnTo>
                        <a:pt x="340" y="432"/>
                      </a:lnTo>
                      <a:lnTo>
                        <a:pt x="344" y="432"/>
                      </a:lnTo>
                      <a:lnTo>
                        <a:pt x="348" y="432"/>
                      </a:lnTo>
                      <a:lnTo>
                        <a:pt x="352" y="432"/>
                      </a:lnTo>
                      <a:lnTo>
                        <a:pt x="356" y="428"/>
                      </a:lnTo>
                      <a:lnTo>
                        <a:pt x="360" y="412"/>
                      </a:lnTo>
                      <a:lnTo>
                        <a:pt x="364" y="396"/>
                      </a:lnTo>
                      <a:lnTo>
                        <a:pt x="368" y="384"/>
                      </a:lnTo>
                      <a:lnTo>
                        <a:pt x="372" y="380"/>
                      </a:lnTo>
                      <a:lnTo>
                        <a:pt x="376" y="372"/>
                      </a:lnTo>
                      <a:lnTo>
                        <a:pt x="380" y="352"/>
                      </a:lnTo>
                      <a:lnTo>
                        <a:pt x="384" y="332"/>
                      </a:lnTo>
                      <a:lnTo>
                        <a:pt x="388" y="320"/>
                      </a:lnTo>
                      <a:lnTo>
                        <a:pt x="392" y="300"/>
                      </a:lnTo>
                      <a:lnTo>
                        <a:pt x="396" y="276"/>
                      </a:lnTo>
                      <a:lnTo>
                        <a:pt x="400" y="260"/>
                      </a:lnTo>
                      <a:lnTo>
                        <a:pt x="404" y="236"/>
                      </a:lnTo>
                      <a:lnTo>
                        <a:pt x="408" y="212"/>
                      </a:lnTo>
                      <a:lnTo>
                        <a:pt x="412" y="184"/>
                      </a:lnTo>
                      <a:lnTo>
                        <a:pt x="416" y="160"/>
                      </a:lnTo>
                      <a:lnTo>
                        <a:pt x="420" y="144"/>
                      </a:lnTo>
                      <a:lnTo>
                        <a:pt x="424" y="112"/>
                      </a:lnTo>
                      <a:lnTo>
                        <a:pt x="428" y="92"/>
                      </a:lnTo>
                      <a:lnTo>
                        <a:pt x="432" y="60"/>
                      </a:lnTo>
                      <a:lnTo>
                        <a:pt x="436" y="16"/>
                      </a:lnTo>
                      <a:lnTo>
                        <a:pt x="440" y="0"/>
                      </a:lnTo>
                      <a:lnTo>
                        <a:pt x="444" y="0"/>
                      </a:lnTo>
                      <a:lnTo>
                        <a:pt x="448" y="12"/>
                      </a:lnTo>
                      <a:lnTo>
                        <a:pt x="452" y="8"/>
                      </a:lnTo>
                      <a:lnTo>
                        <a:pt x="456" y="16"/>
                      </a:lnTo>
                      <a:lnTo>
                        <a:pt x="460" y="16"/>
                      </a:lnTo>
                      <a:lnTo>
                        <a:pt x="464" y="0"/>
                      </a:lnTo>
                      <a:lnTo>
                        <a:pt x="468" y="0"/>
                      </a:lnTo>
                      <a:lnTo>
                        <a:pt x="472" y="16"/>
                      </a:lnTo>
                      <a:lnTo>
                        <a:pt x="476" y="20"/>
                      </a:lnTo>
                      <a:lnTo>
                        <a:pt x="480" y="20"/>
                      </a:lnTo>
                      <a:lnTo>
                        <a:pt x="484" y="16"/>
                      </a:lnTo>
                      <a:lnTo>
                        <a:pt x="488" y="36"/>
                      </a:lnTo>
                      <a:lnTo>
                        <a:pt x="492" y="44"/>
                      </a:lnTo>
                      <a:lnTo>
                        <a:pt x="496" y="32"/>
                      </a:lnTo>
                      <a:lnTo>
                        <a:pt x="500" y="44"/>
                      </a:lnTo>
                      <a:lnTo>
                        <a:pt x="504" y="48"/>
                      </a:lnTo>
                      <a:lnTo>
                        <a:pt x="508" y="60"/>
                      </a:lnTo>
                      <a:lnTo>
                        <a:pt x="512" y="68"/>
                      </a:lnTo>
                      <a:lnTo>
                        <a:pt x="516" y="64"/>
                      </a:lnTo>
                      <a:lnTo>
                        <a:pt x="520" y="40"/>
                      </a:lnTo>
                      <a:lnTo>
                        <a:pt x="524" y="28"/>
                      </a:lnTo>
                      <a:lnTo>
                        <a:pt x="528" y="32"/>
                      </a:lnTo>
                      <a:lnTo>
                        <a:pt x="532" y="64"/>
                      </a:lnTo>
                      <a:lnTo>
                        <a:pt x="536" y="100"/>
                      </a:lnTo>
                      <a:lnTo>
                        <a:pt x="540" y="108"/>
                      </a:lnTo>
                      <a:lnTo>
                        <a:pt x="544" y="96"/>
                      </a:lnTo>
                      <a:lnTo>
                        <a:pt x="548" y="108"/>
                      </a:lnTo>
                      <a:lnTo>
                        <a:pt x="552" y="132"/>
                      </a:lnTo>
                      <a:lnTo>
                        <a:pt x="556" y="152"/>
                      </a:lnTo>
                      <a:lnTo>
                        <a:pt x="560" y="160"/>
                      </a:lnTo>
                      <a:lnTo>
                        <a:pt x="564" y="172"/>
                      </a:lnTo>
                      <a:lnTo>
                        <a:pt x="568" y="204"/>
                      </a:lnTo>
                      <a:lnTo>
                        <a:pt x="572" y="240"/>
                      </a:lnTo>
                      <a:lnTo>
                        <a:pt x="576" y="276"/>
                      </a:lnTo>
                      <a:lnTo>
                        <a:pt x="580" y="308"/>
                      </a:lnTo>
                      <a:lnTo>
                        <a:pt x="584" y="332"/>
                      </a:lnTo>
                      <a:lnTo>
                        <a:pt x="588" y="348"/>
                      </a:lnTo>
                      <a:lnTo>
                        <a:pt x="592" y="364"/>
                      </a:lnTo>
                      <a:lnTo>
                        <a:pt x="596" y="388"/>
                      </a:lnTo>
                      <a:lnTo>
                        <a:pt x="600" y="408"/>
                      </a:lnTo>
                      <a:lnTo>
                        <a:pt x="604" y="424"/>
                      </a:lnTo>
                      <a:lnTo>
                        <a:pt x="608" y="432"/>
                      </a:lnTo>
                      <a:lnTo>
                        <a:pt x="612" y="436"/>
                      </a:lnTo>
                      <a:lnTo>
                        <a:pt x="616" y="444"/>
                      </a:lnTo>
                      <a:lnTo>
                        <a:pt x="620" y="448"/>
                      </a:lnTo>
                      <a:lnTo>
                        <a:pt x="624" y="452"/>
                      </a:lnTo>
                      <a:lnTo>
                        <a:pt x="628" y="456"/>
                      </a:lnTo>
                      <a:lnTo>
                        <a:pt x="632" y="456"/>
                      </a:lnTo>
                      <a:lnTo>
                        <a:pt x="636" y="460"/>
                      </a:lnTo>
                      <a:lnTo>
                        <a:pt x="640" y="464"/>
                      </a:lnTo>
                      <a:lnTo>
                        <a:pt x="644" y="464"/>
                      </a:lnTo>
                      <a:lnTo>
                        <a:pt x="648" y="468"/>
                      </a:lnTo>
                      <a:lnTo>
                        <a:pt x="652" y="468"/>
                      </a:lnTo>
                      <a:lnTo>
                        <a:pt x="656" y="468"/>
                      </a:lnTo>
                      <a:lnTo>
                        <a:pt x="660" y="468"/>
                      </a:lnTo>
                      <a:lnTo>
                        <a:pt x="664" y="472"/>
                      </a:lnTo>
                      <a:lnTo>
                        <a:pt x="668" y="472"/>
                      </a:lnTo>
                      <a:lnTo>
                        <a:pt x="672" y="472"/>
                      </a:lnTo>
                      <a:lnTo>
                        <a:pt x="676" y="472"/>
                      </a:lnTo>
                      <a:lnTo>
                        <a:pt x="680" y="472"/>
                      </a:lnTo>
                      <a:lnTo>
                        <a:pt x="684" y="472"/>
                      </a:lnTo>
                      <a:lnTo>
                        <a:pt x="688" y="472"/>
                      </a:lnTo>
                      <a:lnTo>
                        <a:pt x="692" y="472"/>
                      </a:lnTo>
                      <a:lnTo>
                        <a:pt x="696" y="472"/>
                      </a:lnTo>
                      <a:lnTo>
                        <a:pt x="700" y="472"/>
                      </a:lnTo>
                      <a:lnTo>
                        <a:pt x="704" y="472"/>
                      </a:lnTo>
                      <a:lnTo>
                        <a:pt x="708" y="472"/>
                      </a:lnTo>
                      <a:lnTo>
                        <a:pt x="712" y="472"/>
                      </a:lnTo>
                      <a:lnTo>
                        <a:pt x="716" y="472"/>
                      </a:lnTo>
                      <a:lnTo>
                        <a:pt x="720" y="472"/>
                      </a:lnTo>
                      <a:lnTo>
                        <a:pt x="724" y="472"/>
                      </a:lnTo>
                      <a:lnTo>
                        <a:pt x="728" y="472"/>
                      </a:lnTo>
                      <a:lnTo>
                        <a:pt x="732" y="472"/>
                      </a:lnTo>
                      <a:lnTo>
                        <a:pt x="736" y="472"/>
                      </a:lnTo>
                      <a:lnTo>
                        <a:pt x="740" y="472"/>
                      </a:lnTo>
                      <a:lnTo>
                        <a:pt x="744" y="472"/>
                      </a:lnTo>
                      <a:lnTo>
                        <a:pt x="748" y="472"/>
                      </a:lnTo>
                      <a:lnTo>
                        <a:pt x="752" y="472"/>
                      </a:lnTo>
                      <a:lnTo>
                        <a:pt x="756" y="472"/>
                      </a:lnTo>
                      <a:lnTo>
                        <a:pt x="760" y="472"/>
                      </a:lnTo>
                      <a:lnTo>
                        <a:pt x="764" y="472"/>
                      </a:lnTo>
                      <a:lnTo>
                        <a:pt x="768" y="472"/>
                      </a:lnTo>
                      <a:lnTo>
                        <a:pt x="772" y="472"/>
                      </a:lnTo>
                      <a:lnTo>
                        <a:pt x="776" y="472"/>
                      </a:lnTo>
                      <a:lnTo>
                        <a:pt x="780" y="472"/>
                      </a:lnTo>
                      <a:lnTo>
                        <a:pt x="784" y="472"/>
                      </a:lnTo>
                      <a:lnTo>
                        <a:pt x="788" y="472"/>
                      </a:lnTo>
                      <a:lnTo>
                        <a:pt x="792" y="472"/>
                      </a:lnTo>
                      <a:lnTo>
                        <a:pt x="796" y="472"/>
                      </a:lnTo>
                      <a:lnTo>
                        <a:pt x="800" y="472"/>
                      </a:lnTo>
                      <a:lnTo>
                        <a:pt x="804" y="472"/>
                      </a:lnTo>
                      <a:lnTo>
                        <a:pt x="808" y="472"/>
                      </a:lnTo>
                      <a:lnTo>
                        <a:pt x="812" y="472"/>
                      </a:lnTo>
                      <a:lnTo>
                        <a:pt x="816" y="472"/>
                      </a:lnTo>
                      <a:lnTo>
                        <a:pt x="820" y="472"/>
                      </a:lnTo>
                      <a:lnTo>
                        <a:pt x="824" y="472"/>
                      </a:lnTo>
                      <a:lnTo>
                        <a:pt x="828" y="472"/>
                      </a:lnTo>
                      <a:lnTo>
                        <a:pt x="832" y="472"/>
                      </a:lnTo>
                      <a:lnTo>
                        <a:pt x="836" y="472"/>
                      </a:lnTo>
                      <a:lnTo>
                        <a:pt x="840" y="472"/>
                      </a:lnTo>
                      <a:lnTo>
                        <a:pt x="844" y="472"/>
                      </a:lnTo>
                      <a:lnTo>
                        <a:pt x="848" y="472"/>
                      </a:lnTo>
                      <a:lnTo>
                        <a:pt x="852" y="472"/>
                      </a:lnTo>
                      <a:lnTo>
                        <a:pt x="856" y="472"/>
                      </a:lnTo>
                      <a:lnTo>
                        <a:pt x="860" y="472"/>
                      </a:lnTo>
                      <a:lnTo>
                        <a:pt x="864" y="472"/>
                      </a:lnTo>
                      <a:lnTo>
                        <a:pt x="868" y="472"/>
                      </a:lnTo>
                      <a:lnTo>
                        <a:pt x="872" y="472"/>
                      </a:lnTo>
                      <a:lnTo>
                        <a:pt x="876" y="472"/>
                      </a:lnTo>
                      <a:lnTo>
                        <a:pt x="880" y="472"/>
                      </a:lnTo>
                      <a:lnTo>
                        <a:pt x="884" y="472"/>
                      </a:lnTo>
                      <a:lnTo>
                        <a:pt x="888" y="472"/>
                      </a:lnTo>
                      <a:lnTo>
                        <a:pt x="892" y="472"/>
                      </a:lnTo>
                      <a:lnTo>
                        <a:pt x="896" y="472"/>
                      </a:lnTo>
                      <a:lnTo>
                        <a:pt x="900" y="472"/>
                      </a:lnTo>
                      <a:lnTo>
                        <a:pt x="904" y="472"/>
                      </a:lnTo>
                      <a:lnTo>
                        <a:pt x="908" y="472"/>
                      </a:lnTo>
                      <a:lnTo>
                        <a:pt x="912" y="472"/>
                      </a:lnTo>
                      <a:lnTo>
                        <a:pt x="916" y="472"/>
                      </a:lnTo>
                      <a:lnTo>
                        <a:pt x="920" y="472"/>
                      </a:lnTo>
                      <a:lnTo>
                        <a:pt x="924" y="472"/>
                      </a:lnTo>
                      <a:lnTo>
                        <a:pt x="928" y="472"/>
                      </a:lnTo>
                      <a:lnTo>
                        <a:pt x="932" y="472"/>
                      </a:lnTo>
                      <a:lnTo>
                        <a:pt x="936" y="472"/>
                      </a:lnTo>
                      <a:lnTo>
                        <a:pt x="940" y="472"/>
                      </a:lnTo>
                      <a:lnTo>
                        <a:pt x="944" y="472"/>
                      </a:lnTo>
                      <a:lnTo>
                        <a:pt x="948" y="472"/>
                      </a:lnTo>
                      <a:lnTo>
                        <a:pt x="952" y="472"/>
                      </a:lnTo>
                      <a:lnTo>
                        <a:pt x="956" y="472"/>
                      </a:lnTo>
                      <a:lnTo>
                        <a:pt x="960" y="472"/>
                      </a:lnTo>
                      <a:lnTo>
                        <a:pt x="964" y="472"/>
                      </a:lnTo>
                      <a:lnTo>
                        <a:pt x="968" y="472"/>
                      </a:lnTo>
                      <a:lnTo>
                        <a:pt x="972" y="472"/>
                      </a:lnTo>
                      <a:lnTo>
                        <a:pt x="976" y="472"/>
                      </a:lnTo>
                      <a:lnTo>
                        <a:pt x="980" y="472"/>
                      </a:lnTo>
                      <a:lnTo>
                        <a:pt x="984" y="472"/>
                      </a:lnTo>
                      <a:lnTo>
                        <a:pt x="988" y="472"/>
                      </a:lnTo>
                      <a:lnTo>
                        <a:pt x="992" y="472"/>
                      </a:lnTo>
                      <a:lnTo>
                        <a:pt x="996" y="472"/>
                      </a:lnTo>
                      <a:lnTo>
                        <a:pt x="1000" y="472"/>
                      </a:lnTo>
                      <a:lnTo>
                        <a:pt x="1004" y="472"/>
                      </a:lnTo>
                      <a:lnTo>
                        <a:pt x="1008" y="472"/>
                      </a:lnTo>
                      <a:lnTo>
                        <a:pt x="1012" y="472"/>
                      </a:lnTo>
                      <a:lnTo>
                        <a:pt x="1016" y="472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</p:grpSp>
        </p:grpSp>
        <p:sp>
          <p:nvSpPr>
            <p:cNvPr id="774" name="TextBox 12"/>
            <p:cNvSpPr txBox="1">
              <a:spLocks noChangeArrowheads="1"/>
            </p:cNvSpPr>
            <p:nvPr/>
          </p:nvSpPr>
          <p:spPr bwMode="auto">
            <a:xfrm>
              <a:off x="7300155" y="437592"/>
              <a:ext cx="1094017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200" dirty="0" smtClean="0"/>
                <a:t>1.0</a:t>
              </a:r>
              <a:r>
                <a:rPr lang="en-US" sz="1200" dirty="0" smtClean="0">
                  <a:latin typeface="Symbol" pitchFamily="18" charset="2"/>
                </a:rPr>
                <a:t>m</a:t>
              </a:r>
              <a:r>
                <a:rPr lang="en-US" sz="1200" dirty="0" smtClean="0"/>
                <a:t>M</a:t>
              </a:r>
            </a:p>
            <a:p>
              <a:pPr algn="ctr"/>
              <a:r>
                <a:rPr lang="en-US" sz="1200" dirty="0" smtClean="0"/>
                <a:t> </a:t>
              </a:r>
              <a:r>
                <a:rPr lang="en-US" sz="1200" dirty="0" err="1" smtClean="0"/>
                <a:t>Staurosporine</a:t>
              </a:r>
              <a:endParaRPr lang="en-US" sz="1200" dirty="0"/>
            </a:p>
          </p:txBody>
        </p:sp>
        <p:sp>
          <p:nvSpPr>
            <p:cNvPr id="2600" name="TextBox 2599"/>
            <p:cNvSpPr txBox="1"/>
            <p:nvPr/>
          </p:nvSpPr>
          <p:spPr>
            <a:xfrm rot="16200000">
              <a:off x="200569" y="3995020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# Cell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01" name="TextBox 2600"/>
            <p:cNvSpPr txBox="1"/>
            <p:nvPr/>
          </p:nvSpPr>
          <p:spPr>
            <a:xfrm>
              <a:off x="874518" y="4778603"/>
              <a:ext cx="696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ase 3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07" name="Group 2606"/>
            <p:cNvGrpSpPr/>
            <p:nvPr/>
          </p:nvGrpSpPr>
          <p:grpSpPr>
            <a:xfrm>
              <a:off x="755412" y="1406065"/>
              <a:ext cx="1132186" cy="1132186"/>
              <a:chOff x="755412" y="1406065"/>
              <a:chExt cx="1132186" cy="1132186"/>
            </a:xfrm>
          </p:grpSpPr>
          <p:cxnSp>
            <p:nvCxnSpPr>
              <p:cNvPr id="786" name="Straight Arrow Connector 785"/>
              <p:cNvCxnSpPr/>
              <p:nvPr/>
            </p:nvCxnSpPr>
            <p:spPr>
              <a:xfrm>
                <a:off x="755412" y="2525110"/>
                <a:ext cx="113218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7" name="Straight Arrow Connector 786"/>
              <p:cNvCxnSpPr/>
              <p:nvPr/>
            </p:nvCxnSpPr>
            <p:spPr>
              <a:xfrm rot="16200000">
                <a:off x="197044" y="1972158"/>
                <a:ext cx="113218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88" name="TextBox 787"/>
            <p:cNvSpPr txBox="1"/>
            <p:nvPr/>
          </p:nvSpPr>
          <p:spPr>
            <a:xfrm rot="16200000">
              <a:off x="315504" y="1908197"/>
              <a:ext cx="5036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9" name="TextBox 788"/>
            <p:cNvSpPr txBox="1"/>
            <p:nvPr/>
          </p:nvSpPr>
          <p:spPr>
            <a:xfrm>
              <a:off x="998523" y="2547776"/>
              <a:ext cx="4972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1" name="Group 790"/>
            <p:cNvGrpSpPr/>
            <p:nvPr/>
          </p:nvGrpSpPr>
          <p:grpSpPr>
            <a:xfrm>
              <a:off x="696296" y="3509036"/>
              <a:ext cx="1132186" cy="1132186"/>
              <a:chOff x="755412" y="1406065"/>
              <a:chExt cx="1132186" cy="1132186"/>
            </a:xfrm>
          </p:grpSpPr>
          <p:cxnSp>
            <p:nvCxnSpPr>
              <p:cNvPr id="792" name="Straight Arrow Connector 791"/>
              <p:cNvCxnSpPr/>
              <p:nvPr/>
            </p:nvCxnSpPr>
            <p:spPr>
              <a:xfrm>
                <a:off x="755412" y="2525110"/>
                <a:ext cx="113218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3" name="Straight Arrow Connector 792"/>
              <p:cNvCxnSpPr/>
              <p:nvPr/>
            </p:nvCxnSpPr>
            <p:spPr>
              <a:xfrm rot="16200000">
                <a:off x="197044" y="1972158"/>
                <a:ext cx="1132186" cy="0"/>
              </a:xfrm>
              <a:prstGeom prst="straightConnector1">
                <a:avLst/>
              </a:prstGeom>
              <a:ln w="28575">
                <a:solidFill>
                  <a:schemeClr val="tx1">
                    <a:lumMod val="95000"/>
                    <a:lumOff val="5000"/>
                  </a:schemeClr>
                </a:solidFill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08" name="TextBox 2607"/>
            <p:cNvSpPr txBox="1"/>
            <p:nvPr/>
          </p:nvSpPr>
          <p:spPr>
            <a:xfrm>
              <a:off x="169333" y="287867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7344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456267" y="1569497"/>
            <a:ext cx="5185200" cy="2571121"/>
            <a:chOff x="1456267" y="1569497"/>
            <a:chExt cx="5185200" cy="2571121"/>
          </a:xfrm>
        </p:grpSpPr>
        <p:grpSp>
          <p:nvGrpSpPr>
            <p:cNvPr id="2" name="Group 1"/>
            <p:cNvGrpSpPr/>
            <p:nvPr/>
          </p:nvGrpSpPr>
          <p:grpSpPr>
            <a:xfrm>
              <a:off x="2040185" y="1841118"/>
              <a:ext cx="4601282" cy="2299500"/>
              <a:chOff x="970603" y="838200"/>
              <a:chExt cx="4601282" cy="2299500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1413941" y="838200"/>
                <a:ext cx="13917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Untreated (Live) cells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3850961" y="838200"/>
                <a:ext cx="140936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taurosporine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treated</a:t>
                </a:r>
              </a:p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apoptotic cells)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1" name="Group 76"/>
              <p:cNvGrpSpPr>
                <a:grpSpLocks/>
              </p:cNvGrpSpPr>
              <p:nvPr/>
            </p:nvGrpSpPr>
            <p:grpSpPr bwMode="auto">
              <a:xfrm>
                <a:off x="3422883" y="1170039"/>
                <a:ext cx="2149002" cy="1967661"/>
                <a:chOff x="2996" y="787"/>
                <a:chExt cx="2062" cy="1888"/>
              </a:xfrm>
            </p:grpSpPr>
            <p:grpSp>
              <p:nvGrpSpPr>
                <p:cNvPr id="12" name="Group 74"/>
                <p:cNvGrpSpPr>
                  <a:grpSpLocks/>
                </p:cNvGrpSpPr>
                <p:nvPr/>
              </p:nvGrpSpPr>
              <p:grpSpPr bwMode="auto">
                <a:xfrm>
                  <a:off x="2996" y="787"/>
                  <a:ext cx="2062" cy="1888"/>
                  <a:chOff x="2996" y="787"/>
                  <a:chExt cx="2062" cy="1888"/>
                </a:xfrm>
              </p:grpSpPr>
              <p:sp>
                <p:nvSpPr>
                  <p:cNvPr id="13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3270" y="797"/>
                    <a:ext cx="1662" cy="1663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14" name="Group 41"/>
                  <p:cNvGrpSpPr>
                    <a:grpSpLocks/>
                  </p:cNvGrpSpPr>
                  <p:nvPr/>
                </p:nvGrpSpPr>
                <p:grpSpPr bwMode="auto">
                  <a:xfrm>
                    <a:off x="3241" y="2456"/>
                    <a:ext cx="1817" cy="219"/>
                    <a:chOff x="3241" y="2456"/>
                    <a:chExt cx="1817" cy="219"/>
                  </a:xfrm>
                </p:grpSpPr>
                <p:sp>
                  <p:nvSpPr>
                    <p:cNvPr id="2128" name="Line 1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267" y="2456"/>
                      <a:ext cx="1662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129" name="Group 32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267" y="2463"/>
                      <a:ext cx="1623" cy="38"/>
                      <a:chOff x="3267" y="2463"/>
                      <a:chExt cx="1623" cy="38"/>
                    </a:xfrm>
                  </p:grpSpPr>
                  <p:sp>
                    <p:nvSpPr>
                      <p:cNvPr id="2138" name="Line 1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267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39" name="Line 1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344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0" name="Line 1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428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1" name="Line 1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05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2" name="Line 1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589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3" name="Line 1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672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4" name="Line 1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750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5" name="Line 1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833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6" name="Line 1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17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7" name="Line 2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95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8" name="Line 2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78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49" name="Line 2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162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0" name="Line 2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239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1" name="Line 2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23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2" name="Line 2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07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3" name="Line 2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84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4" name="Line 2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568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5" name="Line 2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645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6" name="Line 2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29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7" name="Line 3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13" y="2463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58" name="Line 3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90" y="2463"/>
                        <a:ext cx="0" cy="38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130" name="Group 3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241" y="2527"/>
                      <a:ext cx="1817" cy="148"/>
                      <a:chOff x="3241" y="2527"/>
                      <a:chExt cx="1817" cy="148"/>
                    </a:xfrm>
                  </p:grpSpPr>
                  <p:sp>
                    <p:nvSpPr>
                      <p:cNvPr id="2132" name="Rectangle 3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241" y="2527"/>
                        <a:ext cx="68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33" name="Rectangle 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511" y="2527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34" name="Rectangle 3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40" y="2527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35" name="Rectangle 3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162" y="2527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36" name="Rectangle 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491" y="2527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37" name="Rectangle 3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787" y="2527"/>
                        <a:ext cx="271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15" name="Group 73"/>
                  <p:cNvGrpSpPr>
                    <a:grpSpLocks/>
                  </p:cNvGrpSpPr>
                  <p:nvPr/>
                </p:nvGrpSpPr>
                <p:grpSpPr bwMode="auto">
                  <a:xfrm>
                    <a:off x="2996" y="787"/>
                    <a:ext cx="271" cy="1772"/>
                    <a:chOff x="2996" y="787"/>
                    <a:chExt cx="271" cy="1772"/>
                  </a:xfrm>
                </p:grpSpPr>
                <p:sp>
                  <p:nvSpPr>
                    <p:cNvPr id="16" name="Line 4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3267" y="794"/>
                      <a:ext cx="0" cy="1662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7" name="Group 6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3228" y="832"/>
                      <a:ext cx="39" cy="1624"/>
                      <a:chOff x="3228" y="832"/>
                      <a:chExt cx="39" cy="1624"/>
                    </a:xfrm>
                  </p:grpSpPr>
                  <p:sp>
                    <p:nvSpPr>
                      <p:cNvPr id="26" name="Line 4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2456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" name="Line 4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2379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8" name="Line 4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229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9" name="Line 4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221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0" name="Line 4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2134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" name="Line 4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2050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2" name="Line 4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973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3" name="Line 5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889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4" name="Line 5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1805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5" name="Line 5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72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6" name="Line 5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644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7" name="Line 5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561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8" name="Line 5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1483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19" name="Line 5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399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0" name="Line 5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316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1" name="Line 5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23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2" name="Line 5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1155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4" name="Line 6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1077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5" name="Line 6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994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6" name="Line 6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54" y="910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27" name="Line 6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3228" y="832"/>
                        <a:ext cx="39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8" name="Group 71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2996" y="787"/>
                      <a:ext cx="271" cy="1772"/>
                      <a:chOff x="2996" y="787"/>
                      <a:chExt cx="271" cy="1772"/>
                    </a:xfrm>
                  </p:grpSpPr>
                  <p:sp>
                    <p:nvSpPr>
                      <p:cNvPr id="20" name="Rectangle 6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151" y="2411"/>
                        <a:ext cx="68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" name="Rectangle 6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48" y="2089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" name="Rectangle 6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48" y="1760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3" name="Rectangle 6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48" y="1438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4" name="Rectangle 6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48" y="1109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5" name="Rectangle 7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996" y="787"/>
                        <a:ext cx="271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2123" name="Picture 75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279" y="807"/>
                  <a:ext cx="1643" cy="16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2165" name="Group 151"/>
              <p:cNvGrpSpPr>
                <a:grpSpLocks/>
              </p:cNvGrpSpPr>
              <p:nvPr/>
            </p:nvGrpSpPr>
            <p:grpSpPr bwMode="auto">
              <a:xfrm>
                <a:off x="970603" y="1170039"/>
                <a:ext cx="2136496" cy="1955155"/>
                <a:chOff x="643" y="787"/>
                <a:chExt cx="2050" cy="1876"/>
              </a:xfrm>
            </p:grpSpPr>
            <p:grpSp>
              <p:nvGrpSpPr>
                <p:cNvPr id="2166" name="Group 149"/>
                <p:cNvGrpSpPr>
                  <a:grpSpLocks/>
                </p:cNvGrpSpPr>
                <p:nvPr/>
              </p:nvGrpSpPr>
              <p:grpSpPr bwMode="auto">
                <a:xfrm>
                  <a:off x="643" y="787"/>
                  <a:ext cx="2050" cy="1876"/>
                  <a:chOff x="643" y="787"/>
                  <a:chExt cx="2050" cy="1876"/>
                </a:xfrm>
              </p:grpSpPr>
              <p:sp>
                <p:nvSpPr>
                  <p:cNvPr id="2167" name="Rectangle 84"/>
                  <p:cNvSpPr>
                    <a:spLocks noChangeArrowheads="1"/>
                  </p:cNvSpPr>
                  <p:nvPr/>
                </p:nvSpPr>
                <p:spPr bwMode="auto">
                  <a:xfrm>
                    <a:off x="915" y="797"/>
                    <a:ext cx="1652" cy="1651"/>
                  </a:xfrm>
                  <a:prstGeom prst="rect">
                    <a:avLst/>
                  </a:prstGeom>
                  <a:solidFill>
                    <a:srgbClr val="FFFFFF"/>
                  </a:solidFill>
                  <a:ln w="9525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grpSp>
                <p:nvGrpSpPr>
                  <p:cNvPr id="2168" name="Group 116"/>
                  <p:cNvGrpSpPr>
                    <a:grpSpLocks/>
                  </p:cNvGrpSpPr>
                  <p:nvPr/>
                </p:nvGrpSpPr>
                <p:grpSpPr bwMode="auto">
                  <a:xfrm>
                    <a:off x="886" y="2445"/>
                    <a:ext cx="1807" cy="218"/>
                    <a:chOff x="886" y="2445"/>
                    <a:chExt cx="1807" cy="218"/>
                  </a:xfrm>
                </p:grpSpPr>
                <p:sp>
                  <p:nvSpPr>
                    <p:cNvPr id="2202" name="Line 8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912" y="2445"/>
                      <a:ext cx="1651" cy="0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203" name="Group 107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912" y="2451"/>
                      <a:ext cx="1613" cy="39"/>
                      <a:chOff x="912" y="2451"/>
                      <a:chExt cx="1613" cy="39"/>
                    </a:xfrm>
                  </p:grpSpPr>
                  <p:sp>
                    <p:nvSpPr>
                      <p:cNvPr id="2212" name="Line 8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912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3" name="Line 8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989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4" name="Line 8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07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5" name="Line 8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149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6" name="Line 9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232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7" name="Line 9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315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8" name="Line 9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39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19" name="Line 9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475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0" name="Line 9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558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1" name="Line 9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635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2" name="Line 9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718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3" name="Line 9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0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4" name="Line 9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78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5" name="Line 9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6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6" name="Line 10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045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7" name="Line 10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12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8" name="Line 10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05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29" name="Line 10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82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30" name="Line 10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65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31" name="Line 10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448" y="2451"/>
                        <a:ext cx="0" cy="13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32" name="Line 10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525" y="2451"/>
                        <a:ext cx="0" cy="39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204" name="Group 114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886" y="2515"/>
                      <a:ext cx="1807" cy="148"/>
                      <a:chOff x="886" y="2515"/>
                      <a:chExt cx="1807" cy="148"/>
                    </a:xfrm>
                  </p:grpSpPr>
                  <p:sp>
                    <p:nvSpPr>
                      <p:cNvPr id="2206" name="Rectangle 10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886" y="2515"/>
                        <a:ext cx="68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07" name="Rectangle 10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155" y="2515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08" name="Rectangle 11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482" y="2515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09" name="Rectangle 11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802" y="2515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10" name="Rectangle 11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128" y="2515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211" name="Rectangle 11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22" y="2515"/>
                        <a:ext cx="271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  <p:grpSp>
                <p:nvGrpSpPr>
                  <p:cNvPr id="2169" name="Group 148"/>
                  <p:cNvGrpSpPr>
                    <a:grpSpLocks/>
                  </p:cNvGrpSpPr>
                  <p:nvPr/>
                </p:nvGrpSpPr>
                <p:grpSpPr bwMode="auto">
                  <a:xfrm>
                    <a:off x="643" y="787"/>
                    <a:ext cx="271" cy="1761"/>
                    <a:chOff x="643" y="787"/>
                    <a:chExt cx="271" cy="1761"/>
                  </a:xfrm>
                </p:grpSpPr>
                <p:sp>
                  <p:nvSpPr>
                    <p:cNvPr id="2170" name="Line 117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912" y="794"/>
                      <a:ext cx="0" cy="1651"/>
                    </a:xfrm>
                    <a:prstGeom prst="line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2171" name="Group 139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874" y="832"/>
                      <a:ext cx="38" cy="1613"/>
                      <a:chOff x="874" y="832"/>
                      <a:chExt cx="38" cy="1613"/>
                    </a:xfrm>
                  </p:grpSpPr>
                  <p:sp>
                    <p:nvSpPr>
                      <p:cNvPr id="2180" name="Line 11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2445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1" name="Line 11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236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2" name="Line 12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228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3" name="Line 12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220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4" name="Line 12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2125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5" name="Line 12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2042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6" name="Line 12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96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7" name="Line 12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882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8" name="Line 12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1798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89" name="Line 12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722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0" name="Line 12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638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1" name="Line 129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55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2" name="Line 130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1478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3" name="Line 131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39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4" name="Line 132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312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5" name="Line 133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23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6" name="Line 134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1152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7" name="Line 135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1075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199" name="Line 136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992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00" name="Line 137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99" y="909"/>
                        <a:ext cx="13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201" name="Line 138"/>
                      <p:cNvSpPr>
                        <a:spLocks noChangeShapeType="1"/>
                      </p:cNvSpPr>
                      <p:nvPr/>
                    </p:nvSpPr>
                    <p:spPr bwMode="auto">
                      <a:xfrm flipH="1">
                        <a:off x="874" y="832"/>
                        <a:ext cx="38" cy="0"/>
                      </a:xfrm>
                      <a:prstGeom prst="line">
                        <a:avLst/>
                      </a:prstGeom>
                      <a:noFill/>
                      <a:ln w="9525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noFill/>
                          </a14:hiddenFill>
                        </a:ext>
                      </a:extLst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2172" name="Group 146"/>
                    <p:cNvGrpSpPr>
                      <a:grpSpLocks/>
                    </p:cNvGrpSpPr>
                    <p:nvPr/>
                  </p:nvGrpSpPr>
                  <p:grpSpPr bwMode="auto">
                    <a:xfrm>
                      <a:off x="643" y="787"/>
                      <a:ext cx="271" cy="1761"/>
                      <a:chOff x="643" y="787"/>
                      <a:chExt cx="271" cy="1761"/>
                    </a:xfrm>
                  </p:grpSpPr>
                  <p:sp>
                    <p:nvSpPr>
                      <p:cNvPr id="2174" name="Rectangle 14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797" y="2400"/>
                        <a:ext cx="68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75" name="Rectangle 14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94" y="2080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2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76" name="Rectangle 14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94" y="1754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4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77" name="Rectangle 14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94" y="1434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6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78" name="Rectangle 14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94" y="1107"/>
                        <a:ext cx="203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800</a:t>
                        </a:r>
                        <a:endParaRPr kumimoji="0" lang="en-US" altLang="en-US" sz="1000" b="1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179" name="Rectangle 14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643" y="787"/>
                        <a:ext cx="271" cy="14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  <p:txBody>
                      <a:bodyPr vert="horz" wrap="none" lIns="0" tIns="0" rIns="0" bIns="0" numCol="1" anchor="t" anchorCtr="0" compatLnSpc="1">
                        <a:prstTxWarp prst="textNoShape">
                          <a:avLst/>
                        </a:prstTxWarp>
                        <a:spAutoFit/>
                      </a:bodyPr>
                      <a:lstStyle>
                        <a:lvl1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1pPr>
                        <a:lvl2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2pPr>
                        <a:lvl3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3pPr>
                        <a:lvl4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4pPr>
                        <a:lvl5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5pPr>
                        <a:lvl6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6pPr>
                        <a:lvl7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7pPr>
                        <a:lvl8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8pPr>
                        <a:lvl9pPr fontAlgn="base">
                          <a:spcBef>
                            <a:spcPct val="0"/>
                          </a:spcBef>
                          <a:spcAft>
                            <a:spcPct val="0"/>
                          </a:spcAft>
                          <a:defRPr>
                            <a:solidFill>
                              <a:schemeClr val="tx1"/>
                            </a:solidFill>
                            <a:latin typeface="Arial" pitchFamily="34" charset="0"/>
                            <a:cs typeface="Arial" pitchFamily="34" charset="0"/>
                          </a:defRPr>
                        </a:lvl9pPr>
                      </a:lstStyle>
                      <a:p>
                        <a:pPr marL="0" marR="0" lvl="0" indent="0" algn="l" defTabSz="914400" rtl="0" eaLnBrk="1" fontAlgn="base" latinLnBrk="0" hangingPunct="1">
                          <a:lnSpc>
                            <a:spcPct val="100000"/>
                          </a:lnSpc>
                          <a:spcBef>
                            <a:spcPct val="0"/>
                          </a:spcBef>
                          <a:spcAft>
                            <a:spcPct val="0"/>
                          </a:spcAft>
                          <a:buClrTx/>
                          <a:buSzTx/>
                          <a:buFontTx/>
                          <a:buNone/>
                          <a:tabLst/>
                        </a:pPr>
                        <a:r>
                          <a:rPr kumimoji="0" lang="en-US" altLang="en-US" sz="1000" b="1" i="0" u="none" strike="noStrike" cap="none" normalizeH="0" baseline="0" dirty="0" smtClean="0">
                            <a:ln>
                              <a:noFill/>
                            </a:ln>
                            <a:solidFill>
                              <a:srgbClr val="000000"/>
                            </a:solidFill>
                            <a:effectLst/>
                            <a:latin typeface="Arial" pitchFamily="34" charset="0"/>
                            <a:cs typeface="Arial" pitchFamily="34" charset="0"/>
                          </a:rPr>
                          <a:t>1000</a:t>
                        </a:r>
                        <a:endParaRPr kumimoji="0" lang="en-US" altLang="en-US" sz="10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</p:grpSp>
            </p:grpSp>
            <p:pic>
              <p:nvPicPr>
                <p:cNvPr id="2198" name="Picture 150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25" y="806"/>
                  <a:ext cx="1632" cy="163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</p:grpSp>
        <p:sp>
          <p:nvSpPr>
            <p:cNvPr id="141" name="TextBox 140"/>
            <p:cNvSpPr txBox="1"/>
            <p:nvPr/>
          </p:nvSpPr>
          <p:spPr>
            <a:xfrm>
              <a:off x="1456267" y="1569497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00655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7</TotalTime>
  <Words>173</Words>
  <Application>Microsoft Office PowerPoint</Application>
  <PresentationFormat>On-screen Show (4:3)</PresentationFormat>
  <Paragraphs>15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Johnson &amp; John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tulli-Marotto, Sandra [JRDUS]</dc:creator>
  <cp:lastModifiedBy>Santulli-Marotto, Sandra [JRDUS]</cp:lastModifiedBy>
  <cp:revision>23</cp:revision>
  <dcterms:created xsi:type="dcterms:W3CDTF">2015-10-14T19:13:33Z</dcterms:created>
  <dcterms:modified xsi:type="dcterms:W3CDTF">2015-11-10T17:33:46Z</dcterms:modified>
</cp:coreProperties>
</file>